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5" r:id="rId2"/>
    <p:sldId id="263" r:id="rId3"/>
    <p:sldId id="262" r:id="rId4"/>
    <p:sldId id="260" r:id="rId5"/>
    <p:sldId id="259" r:id="rId6"/>
    <p:sldId id="266" r:id="rId7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8925" autoAdjust="0"/>
  </p:normalViewPr>
  <p:slideViewPr>
    <p:cSldViewPr snapToGrid="0">
      <p:cViewPr>
        <p:scale>
          <a:sx n="98" d="100"/>
          <a:sy n="98" d="100"/>
        </p:scale>
        <p:origin x="1224" y="-21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pr1\1-NEW%20PHY%20&amp;%20Mol%20Bio\arabidopsisNPR1%2015-10_data%20-%20Copy%20(1)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pr1\1-NEW%20PHY%20&amp;%20Mol%20Bio\arabidopsisNPR1%2015-10_data%20-%20Copy%20(1).xls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pr1\1-NEW%20PHY%20&amp;%20Mol%20Bio\arabidopsisNPR1%2015-10_data%20-%20Copy%20(1).xls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pr1\1-NEW%20PHY%20&amp;%20Mol%20Bio\arabidopsisNPR1%2015-10_data%20-%20Copy%20(1).xls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pr1\1-NEW%20PHY%20&amp;%20Mol%20Bio\arabidopsisNPR1%2015-10_data%20-%20Copy%20(1).xls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pr1\1-NEW%20PHY%20&amp;%20Mol%20Bio\arabidopsisNPR1%2015-10_data%20-%20Copy%20(1).xls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psingh!$J$1</c:f>
              <c:strCache>
                <c:ptCount val="1"/>
                <c:pt idx="0">
                  <c:v>0 hr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rpsingh!$L$2</c:f>
                <c:numCache>
                  <c:formatCode>General</c:formatCode>
                  <c:ptCount val="1"/>
                  <c:pt idx="0">
                    <c:v>0.25629945084267386</c:v>
                  </c:pt>
                </c:numCache>
              </c:numRef>
            </c:plus>
            <c:minus>
              <c:numRef>
                <c:f>rpsingh!$L$2</c:f>
                <c:numCache>
                  <c:formatCode>General</c:formatCode>
                  <c:ptCount val="1"/>
                  <c:pt idx="0">
                    <c:v>0.25629945084267386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2</c:f>
              <c:strCache>
                <c:ptCount val="1"/>
                <c:pt idx="0">
                  <c:v>AtNPR1</c:v>
                </c:pt>
              </c:strCache>
            </c:strRef>
          </c:cat>
          <c:val>
            <c:numRef>
              <c:f>rpsingh!$J$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82-47CA-9E62-BEAB6B62FAF1}"/>
            </c:ext>
          </c:extLst>
        </c:ser>
        <c:ser>
          <c:idx val="1"/>
          <c:order val="1"/>
          <c:tx>
            <c:strRef>
              <c:f>rpsingh!$K$1</c:f>
              <c:strCache>
                <c:ptCount val="1"/>
                <c:pt idx="0">
                  <c:v>12 hr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hade val="51000"/>
                    <a:satMod val="130000"/>
                  </a:schemeClr>
                </a:gs>
                <a:gs pos="80000">
                  <a:schemeClr val="accent2">
                    <a:shade val="93000"/>
                    <a:satMod val="130000"/>
                  </a:schemeClr>
                </a:gs>
                <a:gs pos="100000">
                  <a:schemeClr val="accent2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M$2</c:f>
                <c:numCache>
                  <c:formatCode>General</c:formatCode>
                  <c:ptCount val="1"/>
                  <c:pt idx="0">
                    <c:v>0.21429960982818699</c:v>
                  </c:pt>
                </c:numCache>
              </c:numRef>
            </c:plus>
            <c:minus>
              <c:numRef>
                <c:f>rpsingh!$M$2</c:f>
                <c:numCache>
                  <c:formatCode>General</c:formatCode>
                  <c:ptCount val="1"/>
                  <c:pt idx="0">
                    <c:v>0.21429960982818699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2</c:f>
              <c:strCache>
                <c:ptCount val="1"/>
                <c:pt idx="0">
                  <c:v>AtNPR1</c:v>
                </c:pt>
              </c:strCache>
            </c:strRef>
          </c:cat>
          <c:val>
            <c:numRef>
              <c:f>rpsingh!$K$2</c:f>
              <c:numCache>
                <c:formatCode>General</c:formatCode>
                <c:ptCount val="1"/>
                <c:pt idx="0">
                  <c:v>2.39851355351318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F82-47CA-9E62-BEAB6B62FA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51218440"/>
        <c:axId val="1"/>
      </c:barChart>
      <c:catAx>
        <c:axId val="45121844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51218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psingh!$J$3</c:f>
              <c:strCache>
                <c:ptCount val="1"/>
                <c:pt idx="0">
                  <c:v>0 hr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L$4</c:f>
                <c:numCache>
                  <c:formatCode>General</c:formatCode>
                  <c:ptCount val="1"/>
                  <c:pt idx="0">
                    <c:v>5.3823323037941052E-2</c:v>
                  </c:pt>
                </c:numCache>
              </c:numRef>
            </c:plus>
            <c:minus>
              <c:numRef>
                <c:f>rpsingh!$L$4</c:f>
                <c:numCache>
                  <c:formatCode>General</c:formatCode>
                  <c:ptCount val="1"/>
                  <c:pt idx="0">
                    <c:v>5.3823323037941052E-2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4</c:f>
              <c:strCache>
                <c:ptCount val="1"/>
                <c:pt idx="0">
                  <c:v>AtNPR2</c:v>
                </c:pt>
              </c:strCache>
            </c:strRef>
          </c:cat>
          <c:val>
            <c:numRef>
              <c:f>rpsingh!$J$4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27-4831-BC22-8334AA5BFF54}"/>
            </c:ext>
          </c:extLst>
        </c:ser>
        <c:ser>
          <c:idx val="1"/>
          <c:order val="1"/>
          <c:tx>
            <c:strRef>
              <c:f>rpsingh!$K$3</c:f>
              <c:strCache>
                <c:ptCount val="1"/>
                <c:pt idx="0">
                  <c:v>12 hr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hade val="51000"/>
                    <a:satMod val="130000"/>
                  </a:schemeClr>
                </a:gs>
                <a:gs pos="80000">
                  <a:schemeClr val="accent2">
                    <a:shade val="93000"/>
                    <a:satMod val="130000"/>
                  </a:schemeClr>
                </a:gs>
                <a:gs pos="100000">
                  <a:schemeClr val="accent2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M$4</c:f>
                <c:numCache>
                  <c:formatCode>General</c:formatCode>
                  <c:ptCount val="1"/>
                  <c:pt idx="0">
                    <c:v>4.4224148584658202E-2</c:v>
                  </c:pt>
                </c:numCache>
              </c:numRef>
            </c:plus>
            <c:minus>
              <c:numRef>
                <c:f>rpsingh!$M$4</c:f>
                <c:numCache>
                  <c:formatCode>General</c:formatCode>
                  <c:ptCount val="1"/>
                  <c:pt idx="0">
                    <c:v>4.4224148584658202E-2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4</c:f>
              <c:strCache>
                <c:ptCount val="1"/>
                <c:pt idx="0">
                  <c:v>AtNPR2</c:v>
                </c:pt>
              </c:strCache>
            </c:strRef>
          </c:cat>
          <c:val>
            <c:numRef>
              <c:f>rpsingh!$K$4</c:f>
              <c:numCache>
                <c:formatCode>General</c:formatCode>
                <c:ptCount val="1"/>
                <c:pt idx="0">
                  <c:v>9.714063361128047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127-4831-BC22-8334AA5BFF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334005984"/>
        <c:axId val="1"/>
      </c:barChart>
      <c:catAx>
        <c:axId val="33400598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400598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psingh!$J$5</c:f>
              <c:strCache>
                <c:ptCount val="1"/>
                <c:pt idx="0">
                  <c:v>0 hr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L$6</c:f>
                <c:numCache>
                  <c:formatCode>General</c:formatCode>
                  <c:ptCount val="1"/>
                  <c:pt idx="0">
                    <c:v>8.6355845698970285E-2</c:v>
                  </c:pt>
                </c:numCache>
              </c:numRef>
            </c:plus>
            <c:minus>
              <c:numRef>
                <c:f>rpsingh!$L$6</c:f>
                <c:numCache>
                  <c:formatCode>General</c:formatCode>
                  <c:ptCount val="1"/>
                  <c:pt idx="0">
                    <c:v>8.6355845698970285E-2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6</c:f>
              <c:strCache>
                <c:ptCount val="1"/>
                <c:pt idx="0">
                  <c:v>AtNPR3</c:v>
                </c:pt>
              </c:strCache>
            </c:strRef>
          </c:cat>
          <c:val>
            <c:numRef>
              <c:f>rpsingh!$J$6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9D-4BA4-8E2C-E0327453C8C9}"/>
            </c:ext>
          </c:extLst>
        </c:ser>
        <c:ser>
          <c:idx val="1"/>
          <c:order val="1"/>
          <c:tx>
            <c:strRef>
              <c:f>rpsingh!$K$5</c:f>
              <c:strCache>
                <c:ptCount val="1"/>
                <c:pt idx="0">
                  <c:v>12 hr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hade val="51000"/>
                    <a:satMod val="130000"/>
                  </a:schemeClr>
                </a:gs>
                <a:gs pos="80000">
                  <a:schemeClr val="accent2">
                    <a:shade val="93000"/>
                    <a:satMod val="130000"/>
                  </a:schemeClr>
                </a:gs>
                <a:gs pos="100000">
                  <a:schemeClr val="accent2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M$6</c:f>
                <c:numCache>
                  <c:formatCode>General</c:formatCode>
                  <c:ptCount val="1"/>
                  <c:pt idx="0">
                    <c:v>0.15135174834365861</c:v>
                  </c:pt>
                </c:numCache>
              </c:numRef>
            </c:plus>
            <c:minus>
              <c:numRef>
                <c:f>rpsingh!$M$6</c:f>
                <c:numCache>
                  <c:formatCode>General</c:formatCode>
                  <c:ptCount val="1"/>
                  <c:pt idx="0">
                    <c:v>0.15135174834365861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6</c:f>
              <c:strCache>
                <c:ptCount val="1"/>
                <c:pt idx="0">
                  <c:v>AtNPR3</c:v>
                </c:pt>
              </c:strCache>
            </c:strRef>
          </c:cat>
          <c:val>
            <c:numRef>
              <c:f>rpsingh!$K$6</c:f>
              <c:numCache>
                <c:formatCode>General</c:formatCode>
                <c:ptCount val="1"/>
                <c:pt idx="0">
                  <c:v>0.485435340757199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49D-4BA4-8E2C-E0327453C8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520062192"/>
        <c:axId val="1"/>
      </c:barChart>
      <c:catAx>
        <c:axId val="52006219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2006219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psingh!$J$7</c:f>
              <c:strCache>
                <c:ptCount val="1"/>
                <c:pt idx="0">
                  <c:v>0 hr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L$8</c:f>
                <c:numCache>
                  <c:formatCode>General</c:formatCode>
                  <c:ptCount val="1"/>
                  <c:pt idx="0">
                    <c:v>6.1493103763307098E-2</c:v>
                  </c:pt>
                </c:numCache>
              </c:numRef>
            </c:plus>
            <c:minus>
              <c:numRef>
                <c:f>rpsingh!$L$8</c:f>
                <c:numCache>
                  <c:formatCode>General</c:formatCode>
                  <c:ptCount val="1"/>
                  <c:pt idx="0">
                    <c:v>6.1493103763307098E-2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8</c:f>
              <c:strCache>
                <c:ptCount val="1"/>
                <c:pt idx="0">
                  <c:v>AtNPR4</c:v>
                </c:pt>
              </c:strCache>
            </c:strRef>
          </c:cat>
          <c:val>
            <c:numRef>
              <c:f>rpsingh!$J$8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82-4FBA-973B-C1695725A4B1}"/>
            </c:ext>
          </c:extLst>
        </c:ser>
        <c:ser>
          <c:idx val="1"/>
          <c:order val="1"/>
          <c:tx>
            <c:strRef>
              <c:f>rpsingh!$K$7</c:f>
              <c:strCache>
                <c:ptCount val="1"/>
                <c:pt idx="0">
                  <c:v>12 hr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hade val="51000"/>
                    <a:satMod val="130000"/>
                  </a:schemeClr>
                </a:gs>
                <a:gs pos="80000">
                  <a:schemeClr val="accent2">
                    <a:shade val="93000"/>
                    <a:satMod val="130000"/>
                  </a:schemeClr>
                </a:gs>
                <a:gs pos="100000">
                  <a:schemeClr val="accent2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M$8</c:f>
                <c:numCache>
                  <c:formatCode>General</c:formatCode>
                  <c:ptCount val="1"/>
                  <c:pt idx="0">
                    <c:v>0.15043076234561117</c:v>
                  </c:pt>
                </c:numCache>
              </c:numRef>
            </c:plus>
            <c:minus>
              <c:numRef>
                <c:f>rpsingh!$M$8</c:f>
                <c:numCache>
                  <c:formatCode>General</c:formatCode>
                  <c:ptCount val="1"/>
                  <c:pt idx="0">
                    <c:v>0.15043076234561117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8</c:f>
              <c:strCache>
                <c:ptCount val="1"/>
                <c:pt idx="0">
                  <c:v>AtNPR4</c:v>
                </c:pt>
              </c:strCache>
            </c:strRef>
          </c:cat>
          <c:val>
            <c:numRef>
              <c:f>rpsingh!$K$8</c:f>
              <c:numCache>
                <c:formatCode>General</c:formatCode>
                <c:ptCount val="1"/>
                <c:pt idx="0">
                  <c:v>0.330434287936662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782-4FBA-973B-C1695725A4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529542296"/>
        <c:axId val="1"/>
      </c:barChart>
      <c:catAx>
        <c:axId val="529542296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2954229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psingh!$J$9</c:f>
              <c:strCache>
                <c:ptCount val="1"/>
                <c:pt idx="0">
                  <c:v>0 hr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L$10</c:f>
                <c:numCache>
                  <c:formatCode>General</c:formatCode>
                  <c:ptCount val="1"/>
                  <c:pt idx="0">
                    <c:v>6.6224283955943694E-2</c:v>
                  </c:pt>
                </c:numCache>
              </c:numRef>
            </c:plus>
            <c:minus>
              <c:numRef>
                <c:f>rpsingh!$L$10</c:f>
                <c:numCache>
                  <c:formatCode>General</c:formatCode>
                  <c:ptCount val="1"/>
                  <c:pt idx="0">
                    <c:v>6.6224283955943694E-2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10</c:f>
              <c:strCache>
                <c:ptCount val="1"/>
                <c:pt idx="0">
                  <c:v>AtNPR5</c:v>
                </c:pt>
              </c:strCache>
            </c:strRef>
          </c:cat>
          <c:val>
            <c:numRef>
              <c:f>rpsingh!$J$10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78-4050-8A94-D74BFB782D39}"/>
            </c:ext>
          </c:extLst>
        </c:ser>
        <c:ser>
          <c:idx val="1"/>
          <c:order val="1"/>
          <c:tx>
            <c:strRef>
              <c:f>rpsingh!$K$9</c:f>
              <c:strCache>
                <c:ptCount val="1"/>
                <c:pt idx="0">
                  <c:v>12 hr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hade val="51000"/>
                    <a:satMod val="130000"/>
                  </a:schemeClr>
                </a:gs>
                <a:gs pos="80000">
                  <a:schemeClr val="accent2">
                    <a:shade val="93000"/>
                    <a:satMod val="130000"/>
                  </a:schemeClr>
                </a:gs>
                <a:gs pos="100000">
                  <a:schemeClr val="accent2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rpsingh!$M$10</c:f>
                <c:numCache>
                  <c:formatCode>General</c:formatCode>
                  <c:ptCount val="1"/>
                  <c:pt idx="0">
                    <c:v>0.14221479361626266</c:v>
                  </c:pt>
                </c:numCache>
              </c:numRef>
            </c:plus>
            <c:minus>
              <c:numRef>
                <c:f>rpsingh!$M$10</c:f>
                <c:numCache>
                  <c:formatCode>General</c:formatCode>
                  <c:ptCount val="1"/>
                  <c:pt idx="0">
                    <c:v>0.14221479361626266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10</c:f>
              <c:strCache>
                <c:ptCount val="1"/>
                <c:pt idx="0">
                  <c:v>AtNPR5</c:v>
                </c:pt>
              </c:strCache>
            </c:strRef>
          </c:cat>
          <c:val>
            <c:numRef>
              <c:f>rpsingh!$K$10</c:f>
              <c:numCache>
                <c:formatCode>General</c:formatCode>
                <c:ptCount val="1"/>
                <c:pt idx="0">
                  <c:v>5.605933040409876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778-4050-8A94-D74BFB782D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529544592"/>
        <c:axId val="1"/>
      </c:barChart>
      <c:catAx>
        <c:axId val="52954459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2954459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psingh!$J$11</c:f>
              <c:strCache>
                <c:ptCount val="1"/>
                <c:pt idx="0">
                  <c:v>0 hr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L$12</c:f>
                <c:numCache>
                  <c:formatCode>General</c:formatCode>
                  <c:ptCount val="1"/>
                  <c:pt idx="0">
                    <c:v>0.10197803864092897</c:v>
                  </c:pt>
                </c:numCache>
              </c:numRef>
            </c:plus>
            <c:minus>
              <c:numRef>
                <c:f>rpsingh!$L$12</c:f>
                <c:numCache>
                  <c:formatCode>General</c:formatCode>
                  <c:ptCount val="1"/>
                  <c:pt idx="0">
                    <c:v>0.10197803864092897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12</c:f>
              <c:strCache>
                <c:ptCount val="1"/>
                <c:pt idx="0">
                  <c:v>AtNPR6</c:v>
                </c:pt>
              </c:strCache>
            </c:strRef>
          </c:cat>
          <c:val>
            <c:numRef>
              <c:f>rpsingh!$J$1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0A-49B3-8FE4-99A6E87FAB7B}"/>
            </c:ext>
          </c:extLst>
        </c:ser>
        <c:ser>
          <c:idx val="1"/>
          <c:order val="1"/>
          <c:tx>
            <c:strRef>
              <c:f>rpsingh!$K$11</c:f>
              <c:strCache>
                <c:ptCount val="1"/>
                <c:pt idx="0">
                  <c:v>12 hr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hade val="51000"/>
                    <a:satMod val="130000"/>
                  </a:schemeClr>
                </a:gs>
                <a:gs pos="80000">
                  <a:schemeClr val="accent2">
                    <a:shade val="93000"/>
                    <a:satMod val="130000"/>
                  </a:schemeClr>
                </a:gs>
                <a:gs pos="100000">
                  <a:schemeClr val="accent2">
                    <a:shade val="94000"/>
                    <a:satMod val="135000"/>
                  </a:schemeClr>
                </a:gs>
              </a:gsLst>
              <a:lin ang="16200000" scaled="0"/>
            </a:gradFill>
            <a:ln w="3175"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rpsingh!$M$12</c:f>
                <c:numCache>
                  <c:formatCode>General</c:formatCode>
                  <c:ptCount val="1"/>
                  <c:pt idx="0">
                    <c:v>8.9346308274440095E-2</c:v>
                  </c:pt>
                </c:numCache>
              </c:numRef>
            </c:plus>
            <c:minus>
              <c:numRef>
                <c:f>rpsingh!$M$12</c:f>
                <c:numCache>
                  <c:formatCode>General</c:formatCode>
                  <c:ptCount val="1"/>
                  <c:pt idx="0">
                    <c:v>8.9346308274440095E-2</c:v>
                  </c:pt>
                </c:numCache>
              </c:numRef>
            </c:minus>
            <c:spPr>
              <a:noFill/>
              <a:ln w="9525">
                <a:solidFill>
                  <a:schemeClr val="tx2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cat>
            <c:strRef>
              <c:f>rpsingh!$I$12</c:f>
              <c:strCache>
                <c:ptCount val="1"/>
                <c:pt idx="0">
                  <c:v>AtNPR6</c:v>
                </c:pt>
              </c:strCache>
            </c:strRef>
          </c:cat>
          <c:val>
            <c:numRef>
              <c:f>rpsingh!$K$12</c:f>
              <c:numCache>
                <c:formatCode>General</c:formatCode>
                <c:ptCount val="1"/>
                <c:pt idx="0">
                  <c:v>9.35789744718635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0A-49B3-8FE4-99A6E87FAB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92217480"/>
        <c:axId val="337306256"/>
      </c:barChart>
      <c:catAx>
        <c:axId val="49221748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7306256"/>
        <c:crosses val="autoZero"/>
        <c:auto val="1"/>
        <c:lblAlgn val="ctr"/>
        <c:lblOffset val="100"/>
        <c:noMultiLvlLbl val="0"/>
      </c:catAx>
      <c:valAx>
        <c:axId val="337306256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221748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4175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05264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17725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97167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77772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84304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03017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19174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96527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42682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2630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695C24-8DEE-4297-BCD1-F58C2A0D8D27}" type="datetimeFigureOut">
              <a:rPr lang="en-IN" smtClean="0"/>
              <a:pPr/>
              <a:t>29-07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F29EA-F346-4C74-8F20-EC8097BA1277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195477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3" name="Picture 182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1607714" y="2546782"/>
            <a:ext cx="9418320" cy="5029200"/>
          </a:xfrm>
          <a:prstGeom prst="rect">
            <a:avLst/>
          </a:prstGeom>
        </p:spPr>
      </p:pic>
      <p:grpSp>
        <p:nvGrpSpPr>
          <p:cNvPr id="190" name="Group 189"/>
          <p:cNvGrpSpPr/>
          <p:nvPr/>
        </p:nvGrpSpPr>
        <p:grpSpPr>
          <a:xfrm rot="16200000">
            <a:off x="319380" y="402963"/>
            <a:ext cx="753745" cy="652264"/>
            <a:chOff x="5275579" y="9029498"/>
            <a:chExt cx="753745" cy="652264"/>
          </a:xfrm>
        </p:grpSpPr>
        <p:sp>
          <p:nvSpPr>
            <p:cNvPr id="185" name="object 19"/>
            <p:cNvSpPr txBox="1"/>
            <p:nvPr/>
          </p:nvSpPr>
          <p:spPr>
            <a:xfrm>
              <a:off x="5275579" y="9029498"/>
              <a:ext cx="753745" cy="433452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200" spc="-1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gend:</a:t>
              </a:r>
              <a:endParaRPr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330200">
                <a:lnSpc>
                  <a:spcPct val="100000"/>
                </a:lnSpc>
                <a:spcBef>
                  <a:spcPts val="530"/>
                </a:spcBef>
              </a:pPr>
              <a:r>
                <a:rPr lang="en-IN" sz="1200" spc="-5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</a:t>
              </a:r>
              <a:endParaRPr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88" name="Group 187"/>
            <p:cNvGrpSpPr/>
            <p:nvPr/>
          </p:nvGrpSpPr>
          <p:grpSpPr>
            <a:xfrm>
              <a:off x="5275580" y="9497096"/>
              <a:ext cx="702945" cy="184666"/>
              <a:chOff x="8209280" y="9318298"/>
              <a:chExt cx="702945" cy="184666"/>
            </a:xfrm>
          </p:grpSpPr>
          <p:sp>
            <p:nvSpPr>
              <p:cNvPr id="186" name="object 22"/>
              <p:cNvSpPr/>
              <p:nvPr/>
            </p:nvSpPr>
            <p:spPr>
              <a:xfrm>
                <a:off x="8209280" y="9432943"/>
                <a:ext cx="254000" cy="0"/>
              </a:xfrm>
              <a:custGeom>
                <a:avLst/>
                <a:gdLst/>
                <a:ahLst/>
                <a:cxnLst/>
                <a:rect l="l" t="t" r="r" b="b"/>
                <a:pathLst>
                  <a:path w="254000">
                    <a:moveTo>
                      <a:pt x="0" y="0"/>
                    </a:moveTo>
                    <a:lnTo>
                      <a:pt x="254000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object 23"/>
              <p:cNvSpPr txBox="1"/>
              <p:nvPr/>
            </p:nvSpPr>
            <p:spPr>
              <a:xfrm>
                <a:off x="8514080" y="9318298"/>
                <a:ext cx="398145" cy="18466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</a:pPr>
                <a:r>
                  <a:rPr sz="1200" spc="-5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ron</a:t>
                </a:r>
                <a:endParaRPr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89" name="object 18"/>
            <p:cNvSpPr/>
            <p:nvPr/>
          </p:nvSpPr>
          <p:spPr>
            <a:xfrm>
              <a:off x="5275580" y="9303077"/>
              <a:ext cx="254000" cy="127000"/>
            </a:xfrm>
            <a:prstGeom prst="rect">
              <a:avLst/>
            </a:prstGeom>
            <a:blipFill>
              <a:blip r:embed="rId3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" name="Rectangle 8"/>
          <p:cNvSpPr/>
          <p:nvPr/>
        </p:nvSpPr>
        <p:spPr>
          <a:xfrm rot="16200000">
            <a:off x="2473212" y="6177538"/>
            <a:ext cx="690900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ure </a:t>
            </a:r>
            <a:r>
              <a:rPr lang="en-IN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1 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he</a:t>
            </a:r>
            <a:r>
              <a:rPr lang="en-IN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exon-intron structure of 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PR1-like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enes 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n </a:t>
            </a:r>
            <a:r>
              <a:rPr lang="en-I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. </a:t>
            </a:r>
            <a:r>
              <a:rPr lang="en-IN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raimondii</a:t>
            </a:r>
            <a:r>
              <a:rPr lang="en-I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G. </a:t>
            </a:r>
            <a:r>
              <a:rPr lang="en-IN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rboreum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IN" sz="1200" i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</a:t>
            </a:r>
            <a:r>
              <a:rPr lang="en-I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IN" sz="1200" i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barbadense</a:t>
            </a:r>
            <a:r>
              <a:rPr lang="en-IN" sz="1200" i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endParaRPr lang="en-IN" sz="1200" i="1" dirty="0"/>
          </a:p>
        </p:txBody>
      </p:sp>
    </p:spTree>
    <p:extLst>
      <p:ext uri="{BB962C8B-B14F-4D97-AF65-F5344CB8AC3E}">
        <p14:creationId xmlns:p14="http://schemas.microsoft.com/office/powerpoint/2010/main" val="31817017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59799" y="7516584"/>
            <a:ext cx="561080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1200" b="1" dirty="0">
                <a:solidFill>
                  <a:srgbClr val="000000"/>
                </a:solidFill>
                <a:ea typeface="Calibri" panose="020F0502020204030204" pitchFamily="34" charset="0"/>
              </a:rPr>
              <a:t>Figure S2 </a:t>
            </a:r>
            <a:r>
              <a:rPr lang="en-IN" sz="1200" dirty="0">
                <a:solidFill>
                  <a:srgbClr val="000000"/>
                </a:solidFill>
                <a:ea typeface="Calibri" panose="020F0502020204030204" pitchFamily="34" charset="0"/>
              </a:rPr>
              <a:t>Genomic localization of </a:t>
            </a:r>
            <a:r>
              <a:rPr lang="en-IN" sz="1200" dirty="0" smtClean="0">
                <a:solidFill>
                  <a:srgbClr val="000000"/>
                </a:solidFill>
                <a:ea typeface="Calibri" panose="020F0502020204030204" pitchFamily="34" charset="0"/>
              </a:rPr>
              <a:t>NPR1-like </a:t>
            </a:r>
            <a:r>
              <a:rPr lang="en-IN" sz="1200" dirty="0">
                <a:solidFill>
                  <a:srgbClr val="000000"/>
                </a:solidFill>
                <a:ea typeface="Calibri" panose="020F0502020204030204" pitchFamily="34" charset="0"/>
              </a:rPr>
              <a:t>genes in the </a:t>
            </a:r>
            <a:r>
              <a:rPr lang="en-IN" sz="1200" dirty="0" err="1">
                <a:solidFill>
                  <a:srgbClr val="000000"/>
                </a:solidFill>
                <a:ea typeface="Calibri" panose="020F0502020204030204" pitchFamily="34" charset="0"/>
              </a:rPr>
              <a:t>allotetraploid</a:t>
            </a:r>
            <a:r>
              <a:rPr lang="en-IN" sz="1200" dirty="0">
                <a:solidFill>
                  <a:srgbClr val="000000"/>
                </a:solidFill>
                <a:ea typeface="Calibri" panose="020F0502020204030204" pitchFamily="34" charset="0"/>
              </a:rPr>
              <a:t> </a:t>
            </a:r>
            <a:r>
              <a:rPr lang="en-IN" sz="1200" i="1" dirty="0">
                <a:solidFill>
                  <a:srgbClr val="000000"/>
                </a:solidFill>
                <a:ea typeface="Calibri" panose="020F0502020204030204" pitchFamily="34" charset="0"/>
              </a:rPr>
              <a:t>G. </a:t>
            </a:r>
            <a:r>
              <a:rPr lang="en-IN" sz="1200" i="1" dirty="0" err="1" smtClean="0">
                <a:solidFill>
                  <a:srgbClr val="000000"/>
                </a:solidFill>
                <a:ea typeface="Calibri" panose="020F0502020204030204" pitchFamily="34" charset="0"/>
              </a:rPr>
              <a:t>hirsutum</a:t>
            </a:r>
            <a:r>
              <a:rPr lang="en-IN" sz="1200" i="1" dirty="0" smtClean="0">
                <a:solidFill>
                  <a:srgbClr val="000000"/>
                </a:solidFill>
                <a:ea typeface="Calibri" panose="020F0502020204030204" pitchFamily="34" charset="0"/>
              </a:rPr>
              <a:t>. </a:t>
            </a:r>
            <a:r>
              <a:rPr lang="en-IN" sz="1200" dirty="0"/>
              <a:t>The relative chromosomal sizes (unit, Mb) of </a:t>
            </a:r>
            <a:r>
              <a:rPr lang="en-IN" sz="1200" i="1" dirty="0"/>
              <a:t>G. </a:t>
            </a:r>
            <a:r>
              <a:rPr lang="en-IN" sz="1200" i="1" dirty="0" err="1" smtClean="0"/>
              <a:t>hirsutum</a:t>
            </a:r>
            <a:r>
              <a:rPr lang="en-IN" sz="1200" dirty="0"/>
              <a:t> </a:t>
            </a:r>
            <a:r>
              <a:rPr lang="en-IN" sz="1200" dirty="0" smtClean="0"/>
              <a:t>was calculated.</a:t>
            </a:r>
            <a:endParaRPr lang="en-IN" sz="1200" i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799" y="280584"/>
            <a:ext cx="6400800" cy="356071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799" y="4023534"/>
            <a:ext cx="6400800" cy="320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51371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54"/>
          <p:cNvSpPr txBox="1"/>
          <p:nvPr/>
        </p:nvSpPr>
        <p:spPr>
          <a:xfrm>
            <a:off x="163106" y="4726382"/>
            <a:ext cx="1125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solidFill>
                  <a:schemeClr val="accent6">
                    <a:lumMod val="75000"/>
                  </a:schemeClr>
                </a:solidFill>
              </a:rPr>
              <a:t>Binding site</a:t>
            </a:r>
            <a:endParaRPr lang="en-US" sz="800" dirty="0">
              <a:solidFill>
                <a:schemeClr val="accent6">
                  <a:lumMod val="75000"/>
                </a:schemeClr>
              </a:solidFill>
            </a:endParaRPr>
          </a:p>
        </p:txBody>
      </p:sp>
      <p:grpSp>
        <p:nvGrpSpPr>
          <p:cNvPr id="2" name="Group 29"/>
          <p:cNvGrpSpPr/>
          <p:nvPr/>
        </p:nvGrpSpPr>
        <p:grpSpPr>
          <a:xfrm>
            <a:off x="307068" y="1033462"/>
            <a:ext cx="6263960" cy="4625432"/>
            <a:chOff x="297020" y="1033462"/>
            <a:chExt cx="6263960" cy="462543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/>
            <a:srcRect r="3334" b="88243"/>
            <a:stretch>
              <a:fillRect/>
            </a:stretch>
          </p:blipFill>
          <p:spPr bwMode="auto">
            <a:xfrm>
              <a:off x="297020" y="1066208"/>
              <a:ext cx="6263960" cy="6433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/>
            <a:srcRect t="12205" r="3334" b="75742"/>
            <a:stretch>
              <a:fillRect/>
            </a:stretch>
          </p:blipFill>
          <p:spPr bwMode="auto">
            <a:xfrm>
              <a:off x="297020" y="2035546"/>
              <a:ext cx="6263960" cy="6595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/>
            <a:srcRect t="24692" r="3334" b="63005"/>
            <a:stretch>
              <a:fillRect/>
            </a:stretch>
          </p:blipFill>
          <p:spPr bwMode="auto">
            <a:xfrm>
              <a:off x="297020" y="3030830"/>
              <a:ext cx="6263960" cy="6732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2"/>
            <a:srcRect t="36628" r="3334" b="50885"/>
            <a:stretch>
              <a:fillRect/>
            </a:stretch>
          </p:blipFill>
          <p:spPr bwMode="auto">
            <a:xfrm>
              <a:off x="297020" y="3966629"/>
              <a:ext cx="6263960" cy="6832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2"/>
            <p:cNvPicPr>
              <a:picLocks noChangeAspect="1" noChangeArrowheads="1"/>
            </p:cNvPicPr>
            <p:nvPr/>
          </p:nvPicPr>
          <p:blipFill>
            <a:blip r:embed="rId2"/>
            <a:srcRect t="49483" r="3334" b="37296"/>
            <a:stretch>
              <a:fillRect/>
            </a:stretch>
          </p:blipFill>
          <p:spPr bwMode="auto">
            <a:xfrm>
              <a:off x="297020" y="4935412"/>
              <a:ext cx="6263960" cy="72348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" name="Rectangle 7"/>
            <p:cNvSpPr/>
            <p:nvPr/>
          </p:nvSpPr>
          <p:spPr>
            <a:xfrm>
              <a:off x="2781300" y="1033462"/>
              <a:ext cx="3564000" cy="360000"/>
            </a:xfrm>
            <a:prstGeom prst="rect">
              <a:avLst/>
            </a:prstGeom>
            <a:solidFill>
              <a:srgbClr val="FFFF00">
                <a:alpha val="1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solidFill>
                  <a:schemeClr val="lt1">
                    <a:alpha val="20000"/>
                  </a:schemeClr>
                </a:solidFill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2795573" y="1438301"/>
              <a:ext cx="3564000" cy="252000"/>
            </a:xfrm>
            <a:prstGeom prst="rect">
              <a:avLst/>
            </a:prstGeom>
            <a:solidFill>
              <a:srgbClr val="FFFF00">
                <a:alpha val="1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solidFill>
                  <a:schemeClr val="lt1">
                    <a:alpha val="20000"/>
                  </a:schemeClr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3070860" y="1394460"/>
              <a:ext cx="3426840" cy="49530"/>
            </a:xfrm>
            <a:prstGeom prst="rect">
              <a:avLst/>
            </a:prstGeom>
            <a:solidFill>
              <a:srgbClr val="FFFF00">
                <a:alpha val="1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solidFill>
                  <a:schemeClr val="lt1">
                    <a:alpha val="20000"/>
                  </a:schemeClr>
                </a:solidFill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537210" y="2045969"/>
              <a:ext cx="3326131" cy="619225"/>
            </a:xfrm>
            <a:prstGeom prst="rect">
              <a:avLst/>
            </a:prstGeom>
            <a:solidFill>
              <a:srgbClr val="FFFF00">
                <a:alpha val="1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solidFill>
                  <a:schemeClr val="lt1">
                    <a:alpha val="20000"/>
                  </a:schemeClr>
                </a:solidFill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358924" y="2050610"/>
              <a:ext cx="995896" cy="633742"/>
            </a:xfrm>
            <a:prstGeom prst="rect">
              <a:avLst/>
            </a:prstGeom>
            <a:solidFill>
              <a:schemeClr val="accent6">
                <a:lumMod val="60000"/>
                <a:lumOff val="40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518339" y="3031403"/>
              <a:ext cx="1812927" cy="633742"/>
            </a:xfrm>
            <a:prstGeom prst="rect">
              <a:avLst/>
            </a:prstGeom>
            <a:solidFill>
              <a:schemeClr val="accent6">
                <a:lumMod val="60000"/>
                <a:lumOff val="40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2289138" y="3040720"/>
              <a:ext cx="3491500" cy="64800"/>
            </a:xfrm>
            <a:prstGeom prst="rect">
              <a:avLst/>
            </a:prstGeom>
            <a:solidFill>
              <a:srgbClr val="FF0000">
                <a:alpha val="3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373633" y="3101345"/>
              <a:ext cx="3474906" cy="61200"/>
            </a:xfrm>
            <a:prstGeom prst="rect">
              <a:avLst/>
            </a:prstGeom>
            <a:solidFill>
              <a:srgbClr val="FF0000">
                <a:alpha val="3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2251404" y="3163854"/>
              <a:ext cx="3600000" cy="56064"/>
            </a:xfrm>
            <a:prstGeom prst="rect">
              <a:avLst/>
            </a:prstGeom>
            <a:solidFill>
              <a:srgbClr val="FF0000">
                <a:alpha val="3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2372115" y="3215249"/>
              <a:ext cx="3435683" cy="107373"/>
            </a:xfrm>
            <a:prstGeom prst="rect">
              <a:avLst/>
            </a:prstGeom>
            <a:solidFill>
              <a:srgbClr val="FF0000">
                <a:alpha val="3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2370598" y="3322621"/>
              <a:ext cx="3396460" cy="50400"/>
            </a:xfrm>
            <a:prstGeom prst="rect">
              <a:avLst/>
            </a:prstGeom>
            <a:solidFill>
              <a:srgbClr val="FF0000">
                <a:alpha val="3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2242324" y="3374169"/>
              <a:ext cx="3528000" cy="46800"/>
            </a:xfrm>
            <a:prstGeom prst="rect">
              <a:avLst/>
            </a:prstGeom>
            <a:solidFill>
              <a:srgbClr val="FF0000">
                <a:alpha val="3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2580237" y="3422713"/>
              <a:ext cx="3395050" cy="244800"/>
            </a:xfrm>
            <a:prstGeom prst="rect">
              <a:avLst/>
            </a:prstGeom>
            <a:solidFill>
              <a:srgbClr val="FF0000">
                <a:alpha val="3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1" name="Rectangle 19"/>
            <p:cNvSpPr/>
            <p:nvPr/>
          </p:nvSpPr>
          <p:spPr>
            <a:xfrm>
              <a:off x="616762" y="4010684"/>
              <a:ext cx="5760000" cy="367913"/>
            </a:xfrm>
            <a:custGeom>
              <a:avLst/>
              <a:gdLst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6378699"/>
                <a:gd name="connsiteY0" fmla="*/ 0 h 918779"/>
                <a:gd name="connsiteX1" fmla="*/ 5937234 w 6378699"/>
                <a:gd name="connsiteY1" fmla="*/ 0 h 918779"/>
                <a:gd name="connsiteX2" fmla="*/ 5934287 w 6378699"/>
                <a:gd name="connsiteY2" fmla="*/ 389655 h 918779"/>
                <a:gd name="connsiteX3" fmla="*/ 5941907 w 6378699"/>
                <a:gd name="connsiteY3" fmla="*/ 385845 h 918779"/>
                <a:gd name="connsiteX4" fmla="*/ 5937234 w 6378699"/>
                <a:gd name="connsiteY4" fmla="*/ 918779 h 918779"/>
                <a:gd name="connsiteX5" fmla="*/ 0 w 6378699"/>
                <a:gd name="connsiteY5" fmla="*/ 918779 h 918779"/>
                <a:gd name="connsiteX6" fmla="*/ 0 w 6378699"/>
                <a:gd name="connsiteY6" fmla="*/ 0 h 918779"/>
                <a:gd name="connsiteX0" fmla="*/ 0 w 6377708"/>
                <a:gd name="connsiteY0" fmla="*/ 0 h 918779"/>
                <a:gd name="connsiteX1" fmla="*/ 5937234 w 6377708"/>
                <a:gd name="connsiteY1" fmla="*/ 0 h 918779"/>
                <a:gd name="connsiteX2" fmla="*/ 5934287 w 6377708"/>
                <a:gd name="connsiteY2" fmla="*/ 389655 h 918779"/>
                <a:gd name="connsiteX3" fmla="*/ 5938097 w 6377708"/>
                <a:gd name="connsiteY3" fmla="*/ 267735 h 918779"/>
                <a:gd name="connsiteX4" fmla="*/ 5937234 w 6377708"/>
                <a:gd name="connsiteY4" fmla="*/ 918779 h 918779"/>
                <a:gd name="connsiteX5" fmla="*/ 0 w 6377708"/>
                <a:gd name="connsiteY5" fmla="*/ 918779 h 918779"/>
                <a:gd name="connsiteX6" fmla="*/ 0 w 6377708"/>
                <a:gd name="connsiteY6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374319"/>
                <a:gd name="connsiteY0" fmla="*/ 0 h 918779"/>
                <a:gd name="connsiteX1" fmla="*/ 5937234 w 6374319"/>
                <a:gd name="connsiteY1" fmla="*/ 0 h 918779"/>
                <a:gd name="connsiteX2" fmla="*/ 5934287 w 6374319"/>
                <a:gd name="connsiteY2" fmla="*/ 389655 h 918779"/>
                <a:gd name="connsiteX3" fmla="*/ 5938097 w 6374319"/>
                <a:gd name="connsiteY3" fmla="*/ 267735 h 918779"/>
                <a:gd name="connsiteX4" fmla="*/ 5835227 w 6374319"/>
                <a:gd name="connsiteY4" fmla="*/ 305835 h 918779"/>
                <a:gd name="connsiteX5" fmla="*/ 5937234 w 6374319"/>
                <a:gd name="connsiteY5" fmla="*/ 918779 h 918779"/>
                <a:gd name="connsiteX6" fmla="*/ 0 w 6374319"/>
                <a:gd name="connsiteY6" fmla="*/ 918779 h 918779"/>
                <a:gd name="connsiteX7" fmla="*/ 0 w 6374319"/>
                <a:gd name="connsiteY7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079068"/>
                <a:gd name="connsiteY0" fmla="*/ 0 h 918779"/>
                <a:gd name="connsiteX1" fmla="*/ 5937234 w 6079068"/>
                <a:gd name="connsiteY1" fmla="*/ 0 h 918779"/>
                <a:gd name="connsiteX2" fmla="*/ 5934287 w 6079068"/>
                <a:gd name="connsiteY2" fmla="*/ 389655 h 918779"/>
                <a:gd name="connsiteX3" fmla="*/ 5938097 w 6079068"/>
                <a:gd name="connsiteY3" fmla="*/ 267735 h 918779"/>
                <a:gd name="connsiteX4" fmla="*/ 5835227 w 6079068"/>
                <a:gd name="connsiteY4" fmla="*/ 305835 h 918779"/>
                <a:gd name="connsiteX5" fmla="*/ 6079068 w 6079068"/>
                <a:gd name="connsiteY5" fmla="*/ 484905 h 918779"/>
                <a:gd name="connsiteX6" fmla="*/ 5937234 w 6079068"/>
                <a:gd name="connsiteY6" fmla="*/ 918779 h 918779"/>
                <a:gd name="connsiteX7" fmla="*/ 0 w 6079068"/>
                <a:gd name="connsiteY7" fmla="*/ 918779 h 918779"/>
                <a:gd name="connsiteX8" fmla="*/ 0 w 6079068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17248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197"/>
                <a:gd name="connsiteY0" fmla="*/ 0 h 918779"/>
                <a:gd name="connsiteX1" fmla="*/ 5937234 w 5948197"/>
                <a:gd name="connsiteY1" fmla="*/ 0 h 918779"/>
                <a:gd name="connsiteX2" fmla="*/ 5934287 w 5948197"/>
                <a:gd name="connsiteY2" fmla="*/ 172485 h 918779"/>
                <a:gd name="connsiteX3" fmla="*/ 5938097 w 5948197"/>
                <a:gd name="connsiteY3" fmla="*/ 267735 h 918779"/>
                <a:gd name="connsiteX4" fmla="*/ 5831417 w 5948197"/>
                <a:gd name="connsiteY4" fmla="*/ 355365 h 918779"/>
                <a:gd name="connsiteX5" fmla="*/ 5934288 w 5948197"/>
                <a:gd name="connsiteY5" fmla="*/ 420135 h 918779"/>
                <a:gd name="connsiteX6" fmla="*/ 5937234 w 5948197"/>
                <a:gd name="connsiteY6" fmla="*/ 918779 h 918779"/>
                <a:gd name="connsiteX7" fmla="*/ 0 w 5948197"/>
                <a:gd name="connsiteY7" fmla="*/ 918779 h 918779"/>
                <a:gd name="connsiteX8" fmla="*/ 0 w 5948197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17248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07618 w 5937234"/>
                <a:gd name="connsiteY6" fmla="*/ 374415 h 918779"/>
                <a:gd name="connsiteX7" fmla="*/ 5911428 w 5937234"/>
                <a:gd name="connsiteY7" fmla="*/ 366795 h 918779"/>
                <a:gd name="connsiteX8" fmla="*/ 5934288 w 5937234"/>
                <a:gd name="connsiteY8" fmla="*/ 420135 h 918779"/>
                <a:gd name="connsiteX9" fmla="*/ 5937234 w 5937234"/>
                <a:gd name="connsiteY9" fmla="*/ 918779 h 918779"/>
                <a:gd name="connsiteX10" fmla="*/ 0 w 5937234"/>
                <a:gd name="connsiteY10" fmla="*/ 918779 h 918779"/>
                <a:gd name="connsiteX11" fmla="*/ 0 w 5937234"/>
                <a:gd name="connsiteY11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580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86368 w 5942716"/>
                <a:gd name="connsiteY3" fmla="*/ 282438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8951"/>
                <a:gd name="connsiteY0" fmla="*/ 0 h 918779"/>
                <a:gd name="connsiteX1" fmla="*/ 5937234 w 5938951"/>
                <a:gd name="connsiteY1" fmla="*/ 0 h 918779"/>
                <a:gd name="connsiteX2" fmla="*/ 5929135 w 5938951"/>
                <a:gd name="connsiteY2" fmla="*/ 269184 h 918779"/>
                <a:gd name="connsiteX3" fmla="*/ 5886368 w 5938951"/>
                <a:gd name="connsiteY3" fmla="*/ 282438 h 918779"/>
                <a:gd name="connsiteX4" fmla="*/ 5882932 w 5938951"/>
                <a:gd name="connsiteY4" fmla="*/ 365668 h 918779"/>
                <a:gd name="connsiteX5" fmla="*/ 5934288 w 5938951"/>
                <a:gd name="connsiteY5" fmla="*/ 420135 h 918779"/>
                <a:gd name="connsiteX6" fmla="*/ 5937234 w 5938951"/>
                <a:gd name="connsiteY6" fmla="*/ 918779 h 918779"/>
                <a:gd name="connsiteX7" fmla="*/ 0 w 5938951"/>
                <a:gd name="connsiteY7" fmla="*/ 918779 h 918779"/>
                <a:gd name="connsiteX8" fmla="*/ 0 w 5938951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924"/>
                <a:gd name="connsiteY0" fmla="*/ 0 h 918779"/>
                <a:gd name="connsiteX1" fmla="*/ 5937234 w 5952924"/>
                <a:gd name="connsiteY1" fmla="*/ 0 h 918779"/>
                <a:gd name="connsiteX2" fmla="*/ 5929135 w 5952924"/>
                <a:gd name="connsiteY2" fmla="*/ 269184 h 918779"/>
                <a:gd name="connsiteX3" fmla="*/ 5886368 w 5952924"/>
                <a:gd name="connsiteY3" fmla="*/ 282438 h 918779"/>
                <a:gd name="connsiteX4" fmla="*/ 5882932 w 5952924"/>
                <a:gd name="connsiteY4" fmla="*/ 365668 h 918779"/>
                <a:gd name="connsiteX5" fmla="*/ 5943035 w 5952924"/>
                <a:gd name="connsiteY5" fmla="*/ 362287 h 918779"/>
                <a:gd name="connsiteX6" fmla="*/ 5952318 w 5952924"/>
                <a:gd name="connsiteY6" fmla="*/ 402104 h 918779"/>
                <a:gd name="connsiteX7" fmla="*/ 5937234 w 5952924"/>
                <a:gd name="connsiteY7" fmla="*/ 918779 h 918779"/>
                <a:gd name="connsiteX8" fmla="*/ 0 w 5952924"/>
                <a:gd name="connsiteY8" fmla="*/ 918779 h 918779"/>
                <a:gd name="connsiteX9" fmla="*/ 0 w 5952924"/>
                <a:gd name="connsiteY9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762"/>
                <a:gd name="connsiteY0" fmla="*/ 0 h 918779"/>
                <a:gd name="connsiteX1" fmla="*/ 5937234 w 5952762"/>
                <a:gd name="connsiteY1" fmla="*/ 0 h 918779"/>
                <a:gd name="connsiteX2" fmla="*/ 5934287 w 5952762"/>
                <a:gd name="connsiteY2" fmla="*/ 269184 h 918779"/>
                <a:gd name="connsiteX3" fmla="*/ 5886368 w 5952762"/>
                <a:gd name="connsiteY3" fmla="*/ 282438 h 918779"/>
                <a:gd name="connsiteX4" fmla="*/ 5882932 w 5952762"/>
                <a:gd name="connsiteY4" fmla="*/ 365668 h 918779"/>
                <a:gd name="connsiteX5" fmla="*/ 5952318 w 5952762"/>
                <a:gd name="connsiteY5" fmla="*/ 402104 h 918779"/>
                <a:gd name="connsiteX6" fmla="*/ 5937234 w 5952762"/>
                <a:gd name="connsiteY6" fmla="*/ 918779 h 918779"/>
                <a:gd name="connsiteX7" fmla="*/ 0 w 5952762"/>
                <a:gd name="connsiteY7" fmla="*/ 918779 h 918779"/>
                <a:gd name="connsiteX8" fmla="*/ 0 w 5952762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30157 w 5952389"/>
                <a:gd name="connsiteY5" fmla="*/ 357136 h 918779"/>
                <a:gd name="connsiteX6" fmla="*/ 5952318 w 5952389"/>
                <a:gd name="connsiteY6" fmla="*/ 402104 h 918779"/>
                <a:gd name="connsiteX7" fmla="*/ 5937234 w 5952389"/>
                <a:gd name="connsiteY7" fmla="*/ 918779 h 918779"/>
                <a:gd name="connsiteX8" fmla="*/ 0 w 5952389"/>
                <a:gd name="connsiteY8" fmla="*/ 918779 h 918779"/>
                <a:gd name="connsiteX9" fmla="*/ 0 w 5952389"/>
                <a:gd name="connsiteY9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400"/>
                <a:gd name="connsiteY0" fmla="*/ 0 h 918779"/>
                <a:gd name="connsiteX1" fmla="*/ 5937234 w 5952400"/>
                <a:gd name="connsiteY1" fmla="*/ 0 h 918779"/>
                <a:gd name="connsiteX2" fmla="*/ 5934287 w 5952400"/>
                <a:gd name="connsiteY2" fmla="*/ 269184 h 918779"/>
                <a:gd name="connsiteX3" fmla="*/ 5878641 w 5952400"/>
                <a:gd name="connsiteY3" fmla="*/ 290165 h 918779"/>
                <a:gd name="connsiteX4" fmla="*/ 5882932 w 5952400"/>
                <a:gd name="connsiteY4" fmla="*/ 365668 h 918779"/>
                <a:gd name="connsiteX5" fmla="*/ 5952318 w 5952400"/>
                <a:gd name="connsiteY5" fmla="*/ 402104 h 918779"/>
                <a:gd name="connsiteX6" fmla="*/ 5937234 w 5952400"/>
                <a:gd name="connsiteY6" fmla="*/ 918779 h 918779"/>
                <a:gd name="connsiteX7" fmla="*/ 0 w 5952400"/>
                <a:gd name="connsiteY7" fmla="*/ 918779 h 918779"/>
                <a:gd name="connsiteX8" fmla="*/ 0 w 5952400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6359902"/>
                <a:gd name="connsiteY0" fmla="*/ 0 h 918779"/>
                <a:gd name="connsiteX1" fmla="*/ 5937234 w 6359902"/>
                <a:gd name="connsiteY1" fmla="*/ 0 h 918779"/>
                <a:gd name="connsiteX2" fmla="*/ 5878641 w 6359902"/>
                <a:gd name="connsiteY2" fmla="*/ 290165 h 918779"/>
                <a:gd name="connsiteX3" fmla="*/ 5882932 w 6359902"/>
                <a:gd name="connsiteY3" fmla="*/ 365668 h 918779"/>
                <a:gd name="connsiteX4" fmla="*/ 5952318 w 6359902"/>
                <a:gd name="connsiteY4" fmla="*/ 402104 h 918779"/>
                <a:gd name="connsiteX5" fmla="*/ 5937234 w 6359902"/>
                <a:gd name="connsiteY5" fmla="*/ 918779 h 918779"/>
                <a:gd name="connsiteX6" fmla="*/ 0 w 6359902"/>
                <a:gd name="connsiteY6" fmla="*/ 918779 h 918779"/>
                <a:gd name="connsiteX7" fmla="*/ 0 w 6359902"/>
                <a:gd name="connsiteY7" fmla="*/ 0 h 918779"/>
                <a:gd name="connsiteX0" fmla="*/ 0 w 6358832"/>
                <a:gd name="connsiteY0" fmla="*/ 0 h 918779"/>
                <a:gd name="connsiteX1" fmla="*/ 5937234 w 6358832"/>
                <a:gd name="connsiteY1" fmla="*/ 0 h 918779"/>
                <a:gd name="connsiteX2" fmla="*/ 5882932 w 6358832"/>
                <a:gd name="connsiteY2" fmla="*/ 365668 h 918779"/>
                <a:gd name="connsiteX3" fmla="*/ 5952318 w 6358832"/>
                <a:gd name="connsiteY3" fmla="*/ 402104 h 918779"/>
                <a:gd name="connsiteX4" fmla="*/ 5937234 w 6358832"/>
                <a:gd name="connsiteY4" fmla="*/ 918779 h 918779"/>
                <a:gd name="connsiteX5" fmla="*/ 0 w 6358832"/>
                <a:gd name="connsiteY5" fmla="*/ 918779 h 918779"/>
                <a:gd name="connsiteX6" fmla="*/ 0 w 6358832"/>
                <a:gd name="connsiteY6" fmla="*/ 0 h 918779"/>
                <a:gd name="connsiteX0" fmla="*/ 0 w 6359360"/>
                <a:gd name="connsiteY0" fmla="*/ 0 h 918779"/>
                <a:gd name="connsiteX1" fmla="*/ 5937234 w 6359360"/>
                <a:gd name="connsiteY1" fmla="*/ 0 h 918779"/>
                <a:gd name="connsiteX2" fmla="*/ 5882932 w 6359360"/>
                <a:gd name="connsiteY2" fmla="*/ 365668 h 918779"/>
                <a:gd name="connsiteX3" fmla="*/ 5937234 w 6359360"/>
                <a:gd name="connsiteY3" fmla="*/ 918779 h 918779"/>
                <a:gd name="connsiteX4" fmla="*/ 0 w 6359360"/>
                <a:gd name="connsiteY4" fmla="*/ 918779 h 918779"/>
                <a:gd name="connsiteX5" fmla="*/ 0 w 6359360"/>
                <a:gd name="connsiteY5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937234" h="918779">
                  <a:moveTo>
                    <a:pt x="0" y="0"/>
                  </a:moveTo>
                  <a:lnTo>
                    <a:pt x="5937234" y="0"/>
                  </a:lnTo>
                  <a:lnTo>
                    <a:pt x="5937234" y="918779"/>
                  </a:lnTo>
                  <a:lnTo>
                    <a:pt x="0" y="91877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2" name="Rectangle 19"/>
            <p:cNvSpPr/>
            <p:nvPr/>
          </p:nvSpPr>
          <p:spPr>
            <a:xfrm>
              <a:off x="529248" y="4968843"/>
              <a:ext cx="2675680" cy="46778"/>
            </a:xfrm>
            <a:custGeom>
              <a:avLst/>
              <a:gdLst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6378699"/>
                <a:gd name="connsiteY0" fmla="*/ 0 h 918779"/>
                <a:gd name="connsiteX1" fmla="*/ 5937234 w 6378699"/>
                <a:gd name="connsiteY1" fmla="*/ 0 h 918779"/>
                <a:gd name="connsiteX2" fmla="*/ 5934287 w 6378699"/>
                <a:gd name="connsiteY2" fmla="*/ 389655 h 918779"/>
                <a:gd name="connsiteX3" fmla="*/ 5941907 w 6378699"/>
                <a:gd name="connsiteY3" fmla="*/ 385845 h 918779"/>
                <a:gd name="connsiteX4" fmla="*/ 5937234 w 6378699"/>
                <a:gd name="connsiteY4" fmla="*/ 918779 h 918779"/>
                <a:gd name="connsiteX5" fmla="*/ 0 w 6378699"/>
                <a:gd name="connsiteY5" fmla="*/ 918779 h 918779"/>
                <a:gd name="connsiteX6" fmla="*/ 0 w 6378699"/>
                <a:gd name="connsiteY6" fmla="*/ 0 h 918779"/>
                <a:gd name="connsiteX0" fmla="*/ 0 w 6377708"/>
                <a:gd name="connsiteY0" fmla="*/ 0 h 918779"/>
                <a:gd name="connsiteX1" fmla="*/ 5937234 w 6377708"/>
                <a:gd name="connsiteY1" fmla="*/ 0 h 918779"/>
                <a:gd name="connsiteX2" fmla="*/ 5934287 w 6377708"/>
                <a:gd name="connsiteY2" fmla="*/ 389655 h 918779"/>
                <a:gd name="connsiteX3" fmla="*/ 5938097 w 6377708"/>
                <a:gd name="connsiteY3" fmla="*/ 267735 h 918779"/>
                <a:gd name="connsiteX4" fmla="*/ 5937234 w 6377708"/>
                <a:gd name="connsiteY4" fmla="*/ 918779 h 918779"/>
                <a:gd name="connsiteX5" fmla="*/ 0 w 6377708"/>
                <a:gd name="connsiteY5" fmla="*/ 918779 h 918779"/>
                <a:gd name="connsiteX6" fmla="*/ 0 w 6377708"/>
                <a:gd name="connsiteY6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374319"/>
                <a:gd name="connsiteY0" fmla="*/ 0 h 918779"/>
                <a:gd name="connsiteX1" fmla="*/ 5937234 w 6374319"/>
                <a:gd name="connsiteY1" fmla="*/ 0 h 918779"/>
                <a:gd name="connsiteX2" fmla="*/ 5934287 w 6374319"/>
                <a:gd name="connsiteY2" fmla="*/ 389655 h 918779"/>
                <a:gd name="connsiteX3" fmla="*/ 5938097 w 6374319"/>
                <a:gd name="connsiteY3" fmla="*/ 267735 h 918779"/>
                <a:gd name="connsiteX4" fmla="*/ 5835227 w 6374319"/>
                <a:gd name="connsiteY4" fmla="*/ 305835 h 918779"/>
                <a:gd name="connsiteX5" fmla="*/ 5937234 w 6374319"/>
                <a:gd name="connsiteY5" fmla="*/ 918779 h 918779"/>
                <a:gd name="connsiteX6" fmla="*/ 0 w 6374319"/>
                <a:gd name="connsiteY6" fmla="*/ 918779 h 918779"/>
                <a:gd name="connsiteX7" fmla="*/ 0 w 6374319"/>
                <a:gd name="connsiteY7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079068"/>
                <a:gd name="connsiteY0" fmla="*/ 0 h 918779"/>
                <a:gd name="connsiteX1" fmla="*/ 5937234 w 6079068"/>
                <a:gd name="connsiteY1" fmla="*/ 0 h 918779"/>
                <a:gd name="connsiteX2" fmla="*/ 5934287 w 6079068"/>
                <a:gd name="connsiteY2" fmla="*/ 389655 h 918779"/>
                <a:gd name="connsiteX3" fmla="*/ 5938097 w 6079068"/>
                <a:gd name="connsiteY3" fmla="*/ 267735 h 918779"/>
                <a:gd name="connsiteX4" fmla="*/ 5835227 w 6079068"/>
                <a:gd name="connsiteY4" fmla="*/ 305835 h 918779"/>
                <a:gd name="connsiteX5" fmla="*/ 6079068 w 6079068"/>
                <a:gd name="connsiteY5" fmla="*/ 484905 h 918779"/>
                <a:gd name="connsiteX6" fmla="*/ 5937234 w 6079068"/>
                <a:gd name="connsiteY6" fmla="*/ 918779 h 918779"/>
                <a:gd name="connsiteX7" fmla="*/ 0 w 6079068"/>
                <a:gd name="connsiteY7" fmla="*/ 918779 h 918779"/>
                <a:gd name="connsiteX8" fmla="*/ 0 w 6079068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17248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197"/>
                <a:gd name="connsiteY0" fmla="*/ 0 h 918779"/>
                <a:gd name="connsiteX1" fmla="*/ 5937234 w 5948197"/>
                <a:gd name="connsiteY1" fmla="*/ 0 h 918779"/>
                <a:gd name="connsiteX2" fmla="*/ 5934287 w 5948197"/>
                <a:gd name="connsiteY2" fmla="*/ 172485 h 918779"/>
                <a:gd name="connsiteX3" fmla="*/ 5938097 w 5948197"/>
                <a:gd name="connsiteY3" fmla="*/ 267735 h 918779"/>
                <a:gd name="connsiteX4" fmla="*/ 5831417 w 5948197"/>
                <a:gd name="connsiteY4" fmla="*/ 355365 h 918779"/>
                <a:gd name="connsiteX5" fmla="*/ 5934288 w 5948197"/>
                <a:gd name="connsiteY5" fmla="*/ 420135 h 918779"/>
                <a:gd name="connsiteX6" fmla="*/ 5937234 w 5948197"/>
                <a:gd name="connsiteY6" fmla="*/ 918779 h 918779"/>
                <a:gd name="connsiteX7" fmla="*/ 0 w 5948197"/>
                <a:gd name="connsiteY7" fmla="*/ 918779 h 918779"/>
                <a:gd name="connsiteX8" fmla="*/ 0 w 5948197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17248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07618 w 5937234"/>
                <a:gd name="connsiteY6" fmla="*/ 374415 h 918779"/>
                <a:gd name="connsiteX7" fmla="*/ 5911428 w 5937234"/>
                <a:gd name="connsiteY7" fmla="*/ 366795 h 918779"/>
                <a:gd name="connsiteX8" fmla="*/ 5934288 w 5937234"/>
                <a:gd name="connsiteY8" fmla="*/ 420135 h 918779"/>
                <a:gd name="connsiteX9" fmla="*/ 5937234 w 5937234"/>
                <a:gd name="connsiteY9" fmla="*/ 918779 h 918779"/>
                <a:gd name="connsiteX10" fmla="*/ 0 w 5937234"/>
                <a:gd name="connsiteY10" fmla="*/ 918779 h 918779"/>
                <a:gd name="connsiteX11" fmla="*/ 0 w 5937234"/>
                <a:gd name="connsiteY11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580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86368 w 5942716"/>
                <a:gd name="connsiteY3" fmla="*/ 282438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8951"/>
                <a:gd name="connsiteY0" fmla="*/ 0 h 918779"/>
                <a:gd name="connsiteX1" fmla="*/ 5937234 w 5938951"/>
                <a:gd name="connsiteY1" fmla="*/ 0 h 918779"/>
                <a:gd name="connsiteX2" fmla="*/ 5929135 w 5938951"/>
                <a:gd name="connsiteY2" fmla="*/ 269184 h 918779"/>
                <a:gd name="connsiteX3" fmla="*/ 5886368 w 5938951"/>
                <a:gd name="connsiteY3" fmla="*/ 282438 h 918779"/>
                <a:gd name="connsiteX4" fmla="*/ 5882932 w 5938951"/>
                <a:gd name="connsiteY4" fmla="*/ 365668 h 918779"/>
                <a:gd name="connsiteX5" fmla="*/ 5934288 w 5938951"/>
                <a:gd name="connsiteY5" fmla="*/ 420135 h 918779"/>
                <a:gd name="connsiteX6" fmla="*/ 5937234 w 5938951"/>
                <a:gd name="connsiteY6" fmla="*/ 918779 h 918779"/>
                <a:gd name="connsiteX7" fmla="*/ 0 w 5938951"/>
                <a:gd name="connsiteY7" fmla="*/ 918779 h 918779"/>
                <a:gd name="connsiteX8" fmla="*/ 0 w 5938951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924"/>
                <a:gd name="connsiteY0" fmla="*/ 0 h 918779"/>
                <a:gd name="connsiteX1" fmla="*/ 5937234 w 5952924"/>
                <a:gd name="connsiteY1" fmla="*/ 0 h 918779"/>
                <a:gd name="connsiteX2" fmla="*/ 5929135 w 5952924"/>
                <a:gd name="connsiteY2" fmla="*/ 269184 h 918779"/>
                <a:gd name="connsiteX3" fmla="*/ 5886368 w 5952924"/>
                <a:gd name="connsiteY3" fmla="*/ 282438 h 918779"/>
                <a:gd name="connsiteX4" fmla="*/ 5882932 w 5952924"/>
                <a:gd name="connsiteY4" fmla="*/ 365668 h 918779"/>
                <a:gd name="connsiteX5" fmla="*/ 5943035 w 5952924"/>
                <a:gd name="connsiteY5" fmla="*/ 362287 h 918779"/>
                <a:gd name="connsiteX6" fmla="*/ 5952318 w 5952924"/>
                <a:gd name="connsiteY6" fmla="*/ 402104 h 918779"/>
                <a:gd name="connsiteX7" fmla="*/ 5937234 w 5952924"/>
                <a:gd name="connsiteY7" fmla="*/ 918779 h 918779"/>
                <a:gd name="connsiteX8" fmla="*/ 0 w 5952924"/>
                <a:gd name="connsiteY8" fmla="*/ 918779 h 918779"/>
                <a:gd name="connsiteX9" fmla="*/ 0 w 5952924"/>
                <a:gd name="connsiteY9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762"/>
                <a:gd name="connsiteY0" fmla="*/ 0 h 918779"/>
                <a:gd name="connsiteX1" fmla="*/ 5937234 w 5952762"/>
                <a:gd name="connsiteY1" fmla="*/ 0 h 918779"/>
                <a:gd name="connsiteX2" fmla="*/ 5934287 w 5952762"/>
                <a:gd name="connsiteY2" fmla="*/ 269184 h 918779"/>
                <a:gd name="connsiteX3" fmla="*/ 5886368 w 5952762"/>
                <a:gd name="connsiteY3" fmla="*/ 282438 h 918779"/>
                <a:gd name="connsiteX4" fmla="*/ 5882932 w 5952762"/>
                <a:gd name="connsiteY4" fmla="*/ 365668 h 918779"/>
                <a:gd name="connsiteX5" fmla="*/ 5952318 w 5952762"/>
                <a:gd name="connsiteY5" fmla="*/ 402104 h 918779"/>
                <a:gd name="connsiteX6" fmla="*/ 5937234 w 5952762"/>
                <a:gd name="connsiteY6" fmla="*/ 918779 h 918779"/>
                <a:gd name="connsiteX7" fmla="*/ 0 w 5952762"/>
                <a:gd name="connsiteY7" fmla="*/ 918779 h 918779"/>
                <a:gd name="connsiteX8" fmla="*/ 0 w 5952762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30157 w 5952389"/>
                <a:gd name="connsiteY5" fmla="*/ 357136 h 918779"/>
                <a:gd name="connsiteX6" fmla="*/ 5952318 w 5952389"/>
                <a:gd name="connsiteY6" fmla="*/ 402104 h 918779"/>
                <a:gd name="connsiteX7" fmla="*/ 5937234 w 5952389"/>
                <a:gd name="connsiteY7" fmla="*/ 918779 h 918779"/>
                <a:gd name="connsiteX8" fmla="*/ 0 w 5952389"/>
                <a:gd name="connsiteY8" fmla="*/ 918779 h 918779"/>
                <a:gd name="connsiteX9" fmla="*/ 0 w 5952389"/>
                <a:gd name="connsiteY9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400"/>
                <a:gd name="connsiteY0" fmla="*/ 0 h 918779"/>
                <a:gd name="connsiteX1" fmla="*/ 5937234 w 5952400"/>
                <a:gd name="connsiteY1" fmla="*/ 0 h 918779"/>
                <a:gd name="connsiteX2" fmla="*/ 5934287 w 5952400"/>
                <a:gd name="connsiteY2" fmla="*/ 269184 h 918779"/>
                <a:gd name="connsiteX3" fmla="*/ 5878641 w 5952400"/>
                <a:gd name="connsiteY3" fmla="*/ 290165 h 918779"/>
                <a:gd name="connsiteX4" fmla="*/ 5882932 w 5952400"/>
                <a:gd name="connsiteY4" fmla="*/ 365668 h 918779"/>
                <a:gd name="connsiteX5" fmla="*/ 5952318 w 5952400"/>
                <a:gd name="connsiteY5" fmla="*/ 402104 h 918779"/>
                <a:gd name="connsiteX6" fmla="*/ 5937234 w 5952400"/>
                <a:gd name="connsiteY6" fmla="*/ 918779 h 918779"/>
                <a:gd name="connsiteX7" fmla="*/ 0 w 5952400"/>
                <a:gd name="connsiteY7" fmla="*/ 918779 h 918779"/>
                <a:gd name="connsiteX8" fmla="*/ 0 w 5952400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6359902"/>
                <a:gd name="connsiteY0" fmla="*/ 0 h 918779"/>
                <a:gd name="connsiteX1" fmla="*/ 5937234 w 6359902"/>
                <a:gd name="connsiteY1" fmla="*/ 0 h 918779"/>
                <a:gd name="connsiteX2" fmla="*/ 5878641 w 6359902"/>
                <a:gd name="connsiteY2" fmla="*/ 290165 h 918779"/>
                <a:gd name="connsiteX3" fmla="*/ 5882932 w 6359902"/>
                <a:gd name="connsiteY3" fmla="*/ 365668 h 918779"/>
                <a:gd name="connsiteX4" fmla="*/ 5952318 w 6359902"/>
                <a:gd name="connsiteY4" fmla="*/ 402104 h 918779"/>
                <a:gd name="connsiteX5" fmla="*/ 5937234 w 6359902"/>
                <a:gd name="connsiteY5" fmla="*/ 918779 h 918779"/>
                <a:gd name="connsiteX6" fmla="*/ 0 w 6359902"/>
                <a:gd name="connsiteY6" fmla="*/ 918779 h 918779"/>
                <a:gd name="connsiteX7" fmla="*/ 0 w 6359902"/>
                <a:gd name="connsiteY7" fmla="*/ 0 h 918779"/>
                <a:gd name="connsiteX0" fmla="*/ 0 w 6358832"/>
                <a:gd name="connsiteY0" fmla="*/ 0 h 918779"/>
                <a:gd name="connsiteX1" fmla="*/ 5937234 w 6358832"/>
                <a:gd name="connsiteY1" fmla="*/ 0 h 918779"/>
                <a:gd name="connsiteX2" fmla="*/ 5882932 w 6358832"/>
                <a:gd name="connsiteY2" fmla="*/ 365668 h 918779"/>
                <a:gd name="connsiteX3" fmla="*/ 5952318 w 6358832"/>
                <a:gd name="connsiteY3" fmla="*/ 402104 h 918779"/>
                <a:gd name="connsiteX4" fmla="*/ 5937234 w 6358832"/>
                <a:gd name="connsiteY4" fmla="*/ 918779 h 918779"/>
                <a:gd name="connsiteX5" fmla="*/ 0 w 6358832"/>
                <a:gd name="connsiteY5" fmla="*/ 918779 h 918779"/>
                <a:gd name="connsiteX6" fmla="*/ 0 w 6358832"/>
                <a:gd name="connsiteY6" fmla="*/ 0 h 918779"/>
                <a:gd name="connsiteX0" fmla="*/ 0 w 6359360"/>
                <a:gd name="connsiteY0" fmla="*/ 0 h 918779"/>
                <a:gd name="connsiteX1" fmla="*/ 5937234 w 6359360"/>
                <a:gd name="connsiteY1" fmla="*/ 0 h 918779"/>
                <a:gd name="connsiteX2" fmla="*/ 5882932 w 6359360"/>
                <a:gd name="connsiteY2" fmla="*/ 365668 h 918779"/>
                <a:gd name="connsiteX3" fmla="*/ 5937234 w 6359360"/>
                <a:gd name="connsiteY3" fmla="*/ 918779 h 918779"/>
                <a:gd name="connsiteX4" fmla="*/ 0 w 6359360"/>
                <a:gd name="connsiteY4" fmla="*/ 918779 h 918779"/>
                <a:gd name="connsiteX5" fmla="*/ 0 w 6359360"/>
                <a:gd name="connsiteY5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937234" h="918779">
                  <a:moveTo>
                    <a:pt x="0" y="0"/>
                  </a:moveTo>
                  <a:lnTo>
                    <a:pt x="5937234" y="0"/>
                  </a:lnTo>
                  <a:lnTo>
                    <a:pt x="5937234" y="918779"/>
                  </a:lnTo>
                  <a:lnTo>
                    <a:pt x="0" y="91877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3" name="Rectangle 19"/>
            <p:cNvSpPr/>
            <p:nvPr/>
          </p:nvSpPr>
          <p:spPr>
            <a:xfrm>
              <a:off x="527730" y="5017122"/>
              <a:ext cx="3330000" cy="50400"/>
            </a:xfrm>
            <a:custGeom>
              <a:avLst/>
              <a:gdLst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6378699"/>
                <a:gd name="connsiteY0" fmla="*/ 0 h 918779"/>
                <a:gd name="connsiteX1" fmla="*/ 5937234 w 6378699"/>
                <a:gd name="connsiteY1" fmla="*/ 0 h 918779"/>
                <a:gd name="connsiteX2" fmla="*/ 5934287 w 6378699"/>
                <a:gd name="connsiteY2" fmla="*/ 389655 h 918779"/>
                <a:gd name="connsiteX3" fmla="*/ 5941907 w 6378699"/>
                <a:gd name="connsiteY3" fmla="*/ 385845 h 918779"/>
                <a:gd name="connsiteX4" fmla="*/ 5937234 w 6378699"/>
                <a:gd name="connsiteY4" fmla="*/ 918779 h 918779"/>
                <a:gd name="connsiteX5" fmla="*/ 0 w 6378699"/>
                <a:gd name="connsiteY5" fmla="*/ 918779 h 918779"/>
                <a:gd name="connsiteX6" fmla="*/ 0 w 6378699"/>
                <a:gd name="connsiteY6" fmla="*/ 0 h 918779"/>
                <a:gd name="connsiteX0" fmla="*/ 0 w 6377708"/>
                <a:gd name="connsiteY0" fmla="*/ 0 h 918779"/>
                <a:gd name="connsiteX1" fmla="*/ 5937234 w 6377708"/>
                <a:gd name="connsiteY1" fmla="*/ 0 h 918779"/>
                <a:gd name="connsiteX2" fmla="*/ 5934287 w 6377708"/>
                <a:gd name="connsiteY2" fmla="*/ 389655 h 918779"/>
                <a:gd name="connsiteX3" fmla="*/ 5938097 w 6377708"/>
                <a:gd name="connsiteY3" fmla="*/ 267735 h 918779"/>
                <a:gd name="connsiteX4" fmla="*/ 5937234 w 6377708"/>
                <a:gd name="connsiteY4" fmla="*/ 918779 h 918779"/>
                <a:gd name="connsiteX5" fmla="*/ 0 w 6377708"/>
                <a:gd name="connsiteY5" fmla="*/ 918779 h 918779"/>
                <a:gd name="connsiteX6" fmla="*/ 0 w 6377708"/>
                <a:gd name="connsiteY6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374319"/>
                <a:gd name="connsiteY0" fmla="*/ 0 h 918779"/>
                <a:gd name="connsiteX1" fmla="*/ 5937234 w 6374319"/>
                <a:gd name="connsiteY1" fmla="*/ 0 h 918779"/>
                <a:gd name="connsiteX2" fmla="*/ 5934287 w 6374319"/>
                <a:gd name="connsiteY2" fmla="*/ 389655 h 918779"/>
                <a:gd name="connsiteX3" fmla="*/ 5938097 w 6374319"/>
                <a:gd name="connsiteY3" fmla="*/ 267735 h 918779"/>
                <a:gd name="connsiteX4" fmla="*/ 5835227 w 6374319"/>
                <a:gd name="connsiteY4" fmla="*/ 305835 h 918779"/>
                <a:gd name="connsiteX5" fmla="*/ 5937234 w 6374319"/>
                <a:gd name="connsiteY5" fmla="*/ 918779 h 918779"/>
                <a:gd name="connsiteX6" fmla="*/ 0 w 6374319"/>
                <a:gd name="connsiteY6" fmla="*/ 918779 h 918779"/>
                <a:gd name="connsiteX7" fmla="*/ 0 w 6374319"/>
                <a:gd name="connsiteY7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079068"/>
                <a:gd name="connsiteY0" fmla="*/ 0 h 918779"/>
                <a:gd name="connsiteX1" fmla="*/ 5937234 w 6079068"/>
                <a:gd name="connsiteY1" fmla="*/ 0 h 918779"/>
                <a:gd name="connsiteX2" fmla="*/ 5934287 w 6079068"/>
                <a:gd name="connsiteY2" fmla="*/ 389655 h 918779"/>
                <a:gd name="connsiteX3" fmla="*/ 5938097 w 6079068"/>
                <a:gd name="connsiteY3" fmla="*/ 267735 h 918779"/>
                <a:gd name="connsiteX4" fmla="*/ 5835227 w 6079068"/>
                <a:gd name="connsiteY4" fmla="*/ 305835 h 918779"/>
                <a:gd name="connsiteX5" fmla="*/ 6079068 w 6079068"/>
                <a:gd name="connsiteY5" fmla="*/ 484905 h 918779"/>
                <a:gd name="connsiteX6" fmla="*/ 5937234 w 6079068"/>
                <a:gd name="connsiteY6" fmla="*/ 918779 h 918779"/>
                <a:gd name="connsiteX7" fmla="*/ 0 w 6079068"/>
                <a:gd name="connsiteY7" fmla="*/ 918779 h 918779"/>
                <a:gd name="connsiteX8" fmla="*/ 0 w 6079068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17248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197"/>
                <a:gd name="connsiteY0" fmla="*/ 0 h 918779"/>
                <a:gd name="connsiteX1" fmla="*/ 5937234 w 5948197"/>
                <a:gd name="connsiteY1" fmla="*/ 0 h 918779"/>
                <a:gd name="connsiteX2" fmla="*/ 5934287 w 5948197"/>
                <a:gd name="connsiteY2" fmla="*/ 172485 h 918779"/>
                <a:gd name="connsiteX3" fmla="*/ 5938097 w 5948197"/>
                <a:gd name="connsiteY3" fmla="*/ 267735 h 918779"/>
                <a:gd name="connsiteX4" fmla="*/ 5831417 w 5948197"/>
                <a:gd name="connsiteY4" fmla="*/ 355365 h 918779"/>
                <a:gd name="connsiteX5" fmla="*/ 5934288 w 5948197"/>
                <a:gd name="connsiteY5" fmla="*/ 420135 h 918779"/>
                <a:gd name="connsiteX6" fmla="*/ 5937234 w 5948197"/>
                <a:gd name="connsiteY6" fmla="*/ 918779 h 918779"/>
                <a:gd name="connsiteX7" fmla="*/ 0 w 5948197"/>
                <a:gd name="connsiteY7" fmla="*/ 918779 h 918779"/>
                <a:gd name="connsiteX8" fmla="*/ 0 w 5948197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17248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07618 w 5937234"/>
                <a:gd name="connsiteY6" fmla="*/ 374415 h 918779"/>
                <a:gd name="connsiteX7" fmla="*/ 5911428 w 5937234"/>
                <a:gd name="connsiteY7" fmla="*/ 366795 h 918779"/>
                <a:gd name="connsiteX8" fmla="*/ 5934288 w 5937234"/>
                <a:gd name="connsiteY8" fmla="*/ 420135 h 918779"/>
                <a:gd name="connsiteX9" fmla="*/ 5937234 w 5937234"/>
                <a:gd name="connsiteY9" fmla="*/ 918779 h 918779"/>
                <a:gd name="connsiteX10" fmla="*/ 0 w 5937234"/>
                <a:gd name="connsiteY10" fmla="*/ 918779 h 918779"/>
                <a:gd name="connsiteX11" fmla="*/ 0 w 5937234"/>
                <a:gd name="connsiteY11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580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86368 w 5942716"/>
                <a:gd name="connsiteY3" fmla="*/ 282438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8951"/>
                <a:gd name="connsiteY0" fmla="*/ 0 h 918779"/>
                <a:gd name="connsiteX1" fmla="*/ 5937234 w 5938951"/>
                <a:gd name="connsiteY1" fmla="*/ 0 h 918779"/>
                <a:gd name="connsiteX2" fmla="*/ 5929135 w 5938951"/>
                <a:gd name="connsiteY2" fmla="*/ 269184 h 918779"/>
                <a:gd name="connsiteX3" fmla="*/ 5886368 w 5938951"/>
                <a:gd name="connsiteY3" fmla="*/ 282438 h 918779"/>
                <a:gd name="connsiteX4" fmla="*/ 5882932 w 5938951"/>
                <a:gd name="connsiteY4" fmla="*/ 365668 h 918779"/>
                <a:gd name="connsiteX5" fmla="*/ 5934288 w 5938951"/>
                <a:gd name="connsiteY5" fmla="*/ 420135 h 918779"/>
                <a:gd name="connsiteX6" fmla="*/ 5937234 w 5938951"/>
                <a:gd name="connsiteY6" fmla="*/ 918779 h 918779"/>
                <a:gd name="connsiteX7" fmla="*/ 0 w 5938951"/>
                <a:gd name="connsiteY7" fmla="*/ 918779 h 918779"/>
                <a:gd name="connsiteX8" fmla="*/ 0 w 5938951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924"/>
                <a:gd name="connsiteY0" fmla="*/ 0 h 918779"/>
                <a:gd name="connsiteX1" fmla="*/ 5937234 w 5952924"/>
                <a:gd name="connsiteY1" fmla="*/ 0 h 918779"/>
                <a:gd name="connsiteX2" fmla="*/ 5929135 w 5952924"/>
                <a:gd name="connsiteY2" fmla="*/ 269184 h 918779"/>
                <a:gd name="connsiteX3" fmla="*/ 5886368 w 5952924"/>
                <a:gd name="connsiteY3" fmla="*/ 282438 h 918779"/>
                <a:gd name="connsiteX4" fmla="*/ 5882932 w 5952924"/>
                <a:gd name="connsiteY4" fmla="*/ 365668 h 918779"/>
                <a:gd name="connsiteX5" fmla="*/ 5943035 w 5952924"/>
                <a:gd name="connsiteY5" fmla="*/ 362287 h 918779"/>
                <a:gd name="connsiteX6" fmla="*/ 5952318 w 5952924"/>
                <a:gd name="connsiteY6" fmla="*/ 402104 h 918779"/>
                <a:gd name="connsiteX7" fmla="*/ 5937234 w 5952924"/>
                <a:gd name="connsiteY7" fmla="*/ 918779 h 918779"/>
                <a:gd name="connsiteX8" fmla="*/ 0 w 5952924"/>
                <a:gd name="connsiteY8" fmla="*/ 918779 h 918779"/>
                <a:gd name="connsiteX9" fmla="*/ 0 w 5952924"/>
                <a:gd name="connsiteY9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762"/>
                <a:gd name="connsiteY0" fmla="*/ 0 h 918779"/>
                <a:gd name="connsiteX1" fmla="*/ 5937234 w 5952762"/>
                <a:gd name="connsiteY1" fmla="*/ 0 h 918779"/>
                <a:gd name="connsiteX2" fmla="*/ 5934287 w 5952762"/>
                <a:gd name="connsiteY2" fmla="*/ 269184 h 918779"/>
                <a:gd name="connsiteX3" fmla="*/ 5886368 w 5952762"/>
                <a:gd name="connsiteY3" fmla="*/ 282438 h 918779"/>
                <a:gd name="connsiteX4" fmla="*/ 5882932 w 5952762"/>
                <a:gd name="connsiteY4" fmla="*/ 365668 h 918779"/>
                <a:gd name="connsiteX5" fmla="*/ 5952318 w 5952762"/>
                <a:gd name="connsiteY5" fmla="*/ 402104 h 918779"/>
                <a:gd name="connsiteX6" fmla="*/ 5937234 w 5952762"/>
                <a:gd name="connsiteY6" fmla="*/ 918779 h 918779"/>
                <a:gd name="connsiteX7" fmla="*/ 0 w 5952762"/>
                <a:gd name="connsiteY7" fmla="*/ 918779 h 918779"/>
                <a:gd name="connsiteX8" fmla="*/ 0 w 5952762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30157 w 5952389"/>
                <a:gd name="connsiteY5" fmla="*/ 357136 h 918779"/>
                <a:gd name="connsiteX6" fmla="*/ 5952318 w 5952389"/>
                <a:gd name="connsiteY6" fmla="*/ 402104 h 918779"/>
                <a:gd name="connsiteX7" fmla="*/ 5937234 w 5952389"/>
                <a:gd name="connsiteY7" fmla="*/ 918779 h 918779"/>
                <a:gd name="connsiteX8" fmla="*/ 0 w 5952389"/>
                <a:gd name="connsiteY8" fmla="*/ 918779 h 918779"/>
                <a:gd name="connsiteX9" fmla="*/ 0 w 5952389"/>
                <a:gd name="connsiteY9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400"/>
                <a:gd name="connsiteY0" fmla="*/ 0 h 918779"/>
                <a:gd name="connsiteX1" fmla="*/ 5937234 w 5952400"/>
                <a:gd name="connsiteY1" fmla="*/ 0 h 918779"/>
                <a:gd name="connsiteX2" fmla="*/ 5934287 w 5952400"/>
                <a:gd name="connsiteY2" fmla="*/ 269184 h 918779"/>
                <a:gd name="connsiteX3" fmla="*/ 5878641 w 5952400"/>
                <a:gd name="connsiteY3" fmla="*/ 290165 h 918779"/>
                <a:gd name="connsiteX4" fmla="*/ 5882932 w 5952400"/>
                <a:gd name="connsiteY4" fmla="*/ 365668 h 918779"/>
                <a:gd name="connsiteX5" fmla="*/ 5952318 w 5952400"/>
                <a:gd name="connsiteY5" fmla="*/ 402104 h 918779"/>
                <a:gd name="connsiteX6" fmla="*/ 5937234 w 5952400"/>
                <a:gd name="connsiteY6" fmla="*/ 918779 h 918779"/>
                <a:gd name="connsiteX7" fmla="*/ 0 w 5952400"/>
                <a:gd name="connsiteY7" fmla="*/ 918779 h 918779"/>
                <a:gd name="connsiteX8" fmla="*/ 0 w 5952400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6359902"/>
                <a:gd name="connsiteY0" fmla="*/ 0 h 918779"/>
                <a:gd name="connsiteX1" fmla="*/ 5937234 w 6359902"/>
                <a:gd name="connsiteY1" fmla="*/ 0 h 918779"/>
                <a:gd name="connsiteX2" fmla="*/ 5878641 w 6359902"/>
                <a:gd name="connsiteY2" fmla="*/ 290165 h 918779"/>
                <a:gd name="connsiteX3" fmla="*/ 5882932 w 6359902"/>
                <a:gd name="connsiteY3" fmla="*/ 365668 h 918779"/>
                <a:gd name="connsiteX4" fmla="*/ 5952318 w 6359902"/>
                <a:gd name="connsiteY4" fmla="*/ 402104 h 918779"/>
                <a:gd name="connsiteX5" fmla="*/ 5937234 w 6359902"/>
                <a:gd name="connsiteY5" fmla="*/ 918779 h 918779"/>
                <a:gd name="connsiteX6" fmla="*/ 0 w 6359902"/>
                <a:gd name="connsiteY6" fmla="*/ 918779 h 918779"/>
                <a:gd name="connsiteX7" fmla="*/ 0 w 6359902"/>
                <a:gd name="connsiteY7" fmla="*/ 0 h 918779"/>
                <a:gd name="connsiteX0" fmla="*/ 0 w 6358832"/>
                <a:gd name="connsiteY0" fmla="*/ 0 h 918779"/>
                <a:gd name="connsiteX1" fmla="*/ 5937234 w 6358832"/>
                <a:gd name="connsiteY1" fmla="*/ 0 h 918779"/>
                <a:gd name="connsiteX2" fmla="*/ 5882932 w 6358832"/>
                <a:gd name="connsiteY2" fmla="*/ 365668 h 918779"/>
                <a:gd name="connsiteX3" fmla="*/ 5952318 w 6358832"/>
                <a:gd name="connsiteY3" fmla="*/ 402104 h 918779"/>
                <a:gd name="connsiteX4" fmla="*/ 5937234 w 6358832"/>
                <a:gd name="connsiteY4" fmla="*/ 918779 h 918779"/>
                <a:gd name="connsiteX5" fmla="*/ 0 w 6358832"/>
                <a:gd name="connsiteY5" fmla="*/ 918779 h 918779"/>
                <a:gd name="connsiteX6" fmla="*/ 0 w 6358832"/>
                <a:gd name="connsiteY6" fmla="*/ 0 h 918779"/>
                <a:gd name="connsiteX0" fmla="*/ 0 w 6359360"/>
                <a:gd name="connsiteY0" fmla="*/ 0 h 918779"/>
                <a:gd name="connsiteX1" fmla="*/ 5937234 w 6359360"/>
                <a:gd name="connsiteY1" fmla="*/ 0 h 918779"/>
                <a:gd name="connsiteX2" fmla="*/ 5882932 w 6359360"/>
                <a:gd name="connsiteY2" fmla="*/ 365668 h 918779"/>
                <a:gd name="connsiteX3" fmla="*/ 5937234 w 6359360"/>
                <a:gd name="connsiteY3" fmla="*/ 918779 h 918779"/>
                <a:gd name="connsiteX4" fmla="*/ 0 w 6359360"/>
                <a:gd name="connsiteY4" fmla="*/ 918779 h 918779"/>
                <a:gd name="connsiteX5" fmla="*/ 0 w 6359360"/>
                <a:gd name="connsiteY5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937234" h="918779">
                  <a:moveTo>
                    <a:pt x="0" y="0"/>
                  </a:moveTo>
                  <a:lnTo>
                    <a:pt x="5937234" y="0"/>
                  </a:lnTo>
                  <a:lnTo>
                    <a:pt x="5937234" y="918779"/>
                  </a:lnTo>
                  <a:lnTo>
                    <a:pt x="0" y="91877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4" name="Rectangle 19"/>
            <p:cNvSpPr/>
            <p:nvPr/>
          </p:nvSpPr>
          <p:spPr>
            <a:xfrm>
              <a:off x="541311" y="5066919"/>
              <a:ext cx="2700000" cy="50400"/>
            </a:xfrm>
            <a:custGeom>
              <a:avLst/>
              <a:gdLst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6378699"/>
                <a:gd name="connsiteY0" fmla="*/ 0 h 918779"/>
                <a:gd name="connsiteX1" fmla="*/ 5937234 w 6378699"/>
                <a:gd name="connsiteY1" fmla="*/ 0 h 918779"/>
                <a:gd name="connsiteX2" fmla="*/ 5934287 w 6378699"/>
                <a:gd name="connsiteY2" fmla="*/ 389655 h 918779"/>
                <a:gd name="connsiteX3" fmla="*/ 5941907 w 6378699"/>
                <a:gd name="connsiteY3" fmla="*/ 385845 h 918779"/>
                <a:gd name="connsiteX4" fmla="*/ 5937234 w 6378699"/>
                <a:gd name="connsiteY4" fmla="*/ 918779 h 918779"/>
                <a:gd name="connsiteX5" fmla="*/ 0 w 6378699"/>
                <a:gd name="connsiteY5" fmla="*/ 918779 h 918779"/>
                <a:gd name="connsiteX6" fmla="*/ 0 w 6378699"/>
                <a:gd name="connsiteY6" fmla="*/ 0 h 918779"/>
                <a:gd name="connsiteX0" fmla="*/ 0 w 6377708"/>
                <a:gd name="connsiteY0" fmla="*/ 0 h 918779"/>
                <a:gd name="connsiteX1" fmla="*/ 5937234 w 6377708"/>
                <a:gd name="connsiteY1" fmla="*/ 0 h 918779"/>
                <a:gd name="connsiteX2" fmla="*/ 5934287 w 6377708"/>
                <a:gd name="connsiteY2" fmla="*/ 389655 h 918779"/>
                <a:gd name="connsiteX3" fmla="*/ 5938097 w 6377708"/>
                <a:gd name="connsiteY3" fmla="*/ 267735 h 918779"/>
                <a:gd name="connsiteX4" fmla="*/ 5937234 w 6377708"/>
                <a:gd name="connsiteY4" fmla="*/ 918779 h 918779"/>
                <a:gd name="connsiteX5" fmla="*/ 0 w 6377708"/>
                <a:gd name="connsiteY5" fmla="*/ 918779 h 918779"/>
                <a:gd name="connsiteX6" fmla="*/ 0 w 6377708"/>
                <a:gd name="connsiteY6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374319"/>
                <a:gd name="connsiteY0" fmla="*/ 0 h 918779"/>
                <a:gd name="connsiteX1" fmla="*/ 5937234 w 6374319"/>
                <a:gd name="connsiteY1" fmla="*/ 0 h 918779"/>
                <a:gd name="connsiteX2" fmla="*/ 5934287 w 6374319"/>
                <a:gd name="connsiteY2" fmla="*/ 389655 h 918779"/>
                <a:gd name="connsiteX3" fmla="*/ 5938097 w 6374319"/>
                <a:gd name="connsiteY3" fmla="*/ 267735 h 918779"/>
                <a:gd name="connsiteX4" fmla="*/ 5835227 w 6374319"/>
                <a:gd name="connsiteY4" fmla="*/ 305835 h 918779"/>
                <a:gd name="connsiteX5" fmla="*/ 5937234 w 6374319"/>
                <a:gd name="connsiteY5" fmla="*/ 918779 h 918779"/>
                <a:gd name="connsiteX6" fmla="*/ 0 w 6374319"/>
                <a:gd name="connsiteY6" fmla="*/ 918779 h 918779"/>
                <a:gd name="connsiteX7" fmla="*/ 0 w 6374319"/>
                <a:gd name="connsiteY7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079068"/>
                <a:gd name="connsiteY0" fmla="*/ 0 h 918779"/>
                <a:gd name="connsiteX1" fmla="*/ 5937234 w 6079068"/>
                <a:gd name="connsiteY1" fmla="*/ 0 h 918779"/>
                <a:gd name="connsiteX2" fmla="*/ 5934287 w 6079068"/>
                <a:gd name="connsiteY2" fmla="*/ 389655 h 918779"/>
                <a:gd name="connsiteX3" fmla="*/ 5938097 w 6079068"/>
                <a:gd name="connsiteY3" fmla="*/ 267735 h 918779"/>
                <a:gd name="connsiteX4" fmla="*/ 5835227 w 6079068"/>
                <a:gd name="connsiteY4" fmla="*/ 305835 h 918779"/>
                <a:gd name="connsiteX5" fmla="*/ 6079068 w 6079068"/>
                <a:gd name="connsiteY5" fmla="*/ 484905 h 918779"/>
                <a:gd name="connsiteX6" fmla="*/ 5937234 w 6079068"/>
                <a:gd name="connsiteY6" fmla="*/ 918779 h 918779"/>
                <a:gd name="connsiteX7" fmla="*/ 0 w 6079068"/>
                <a:gd name="connsiteY7" fmla="*/ 918779 h 918779"/>
                <a:gd name="connsiteX8" fmla="*/ 0 w 6079068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17248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197"/>
                <a:gd name="connsiteY0" fmla="*/ 0 h 918779"/>
                <a:gd name="connsiteX1" fmla="*/ 5937234 w 5948197"/>
                <a:gd name="connsiteY1" fmla="*/ 0 h 918779"/>
                <a:gd name="connsiteX2" fmla="*/ 5934287 w 5948197"/>
                <a:gd name="connsiteY2" fmla="*/ 172485 h 918779"/>
                <a:gd name="connsiteX3" fmla="*/ 5938097 w 5948197"/>
                <a:gd name="connsiteY3" fmla="*/ 267735 h 918779"/>
                <a:gd name="connsiteX4" fmla="*/ 5831417 w 5948197"/>
                <a:gd name="connsiteY4" fmla="*/ 355365 h 918779"/>
                <a:gd name="connsiteX5" fmla="*/ 5934288 w 5948197"/>
                <a:gd name="connsiteY5" fmla="*/ 420135 h 918779"/>
                <a:gd name="connsiteX6" fmla="*/ 5937234 w 5948197"/>
                <a:gd name="connsiteY6" fmla="*/ 918779 h 918779"/>
                <a:gd name="connsiteX7" fmla="*/ 0 w 5948197"/>
                <a:gd name="connsiteY7" fmla="*/ 918779 h 918779"/>
                <a:gd name="connsiteX8" fmla="*/ 0 w 5948197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17248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07618 w 5937234"/>
                <a:gd name="connsiteY6" fmla="*/ 374415 h 918779"/>
                <a:gd name="connsiteX7" fmla="*/ 5911428 w 5937234"/>
                <a:gd name="connsiteY7" fmla="*/ 366795 h 918779"/>
                <a:gd name="connsiteX8" fmla="*/ 5934288 w 5937234"/>
                <a:gd name="connsiteY8" fmla="*/ 420135 h 918779"/>
                <a:gd name="connsiteX9" fmla="*/ 5937234 w 5937234"/>
                <a:gd name="connsiteY9" fmla="*/ 918779 h 918779"/>
                <a:gd name="connsiteX10" fmla="*/ 0 w 5937234"/>
                <a:gd name="connsiteY10" fmla="*/ 918779 h 918779"/>
                <a:gd name="connsiteX11" fmla="*/ 0 w 5937234"/>
                <a:gd name="connsiteY11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580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86368 w 5942716"/>
                <a:gd name="connsiteY3" fmla="*/ 282438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8951"/>
                <a:gd name="connsiteY0" fmla="*/ 0 h 918779"/>
                <a:gd name="connsiteX1" fmla="*/ 5937234 w 5938951"/>
                <a:gd name="connsiteY1" fmla="*/ 0 h 918779"/>
                <a:gd name="connsiteX2" fmla="*/ 5929135 w 5938951"/>
                <a:gd name="connsiteY2" fmla="*/ 269184 h 918779"/>
                <a:gd name="connsiteX3" fmla="*/ 5886368 w 5938951"/>
                <a:gd name="connsiteY3" fmla="*/ 282438 h 918779"/>
                <a:gd name="connsiteX4" fmla="*/ 5882932 w 5938951"/>
                <a:gd name="connsiteY4" fmla="*/ 365668 h 918779"/>
                <a:gd name="connsiteX5" fmla="*/ 5934288 w 5938951"/>
                <a:gd name="connsiteY5" fmla="*/ 420135 h 918779"/>
                <a:gd name="connsiteX6" fmla="*/ 5937234 w 5938951"/>
                <a:gd name="connsiteY6" fmla="*/ 918779 h 918779"/>
                <a:gd name="connsiteX7" fmla="*/ 0 w 5938951"/>
                <a:gd name="connsiteY7" fmla="*/ 918779 h 918779"/>
                <a:gd name="connsiteX8" fmla="*/ 0 w 5938951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924"/>
                <a:gd name="connsiteY0" fmla="*/ 0 h 918779"/>
                <a:gd name="connsiteX1" fmla="*/ 5937234 w 5952924"/>
                <a:gd name="connsiteY1" fmla="*/ 0 h 918779"/>
                <a:gd name="connsiteX2" fmla="*/ 5929135 w 5952924"/>
                <a:gd name="connsiteY2" fmla="*/ 269184 h 918779"/>
                <a:gd name="connsiteX3" fmla="*/ 5886368 w 5952924"/>
                <a:gd name="connsiteY3" fmla="*/ 282438 h 918779"/>
                <a:gd name="connsiteX4" fmla="*/ 5882932 w 5952924"/>
                <a:gd name="connsiteY4" fmla="*/ 365668 h 918779"/>
                <a:gd name="connsiteX5" fmla="*/ 5943035 w 5952924"/>
                <a:gd name="connsiteY5" fmla="*/ 362287 h 918779"/>
                <a:gd name="connsiteX6" fmla="*/ 5952318 w 5952924"/>
                <a:gd name="connsiteY6" fmla="*/ 402104 h 918779"/>
                <a:gd name="connsiteX7" fmla="*/ 5937234 w 5952924"/>
                <a:gd name="connsiteY7" fmla="*/ 918779 h 918779"/>
                <a:gd name="connsiteX8" fmla="*/ 0 w 5952924"/>
                <a:gd name="connsiteY8" fmla="*/ 918779 h 918779"/>
                <a:gd name="connsiteX9" fmla="*/ 0 w 5952924"/>
                <a:gd name="connsiteY9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762"/>
                <a:gd name="connsiteY0" fmla="*/ 0 h 918779"/>
                <a:gd name="connsiteX1" fmla="*/ 5937234 w 5952762"/>
                <a:gd name="connsiteY1" fmla="*/ 0 h 918779"/>
                <a:gd name="connsiteX2" fmla="*/ 5934287 w 5952762"/>
                <a:gd name="connsiteY2" fmla="*/ 269184 h 918779"/>
                <a:gd name="connsiteX3" fmla="*/ 5886368 w 5952762"/>
                <a:gd name="connsiteY3" fmla="*/ 282438 h 918779"/>
                <a:gd name="connsiteX4" fmla="*/ 5882932 w 5952762"/>
                <a:gd name="connsiteY4" fmla="*/ 365668 h 918779"/>
                <a:gd name="connsiteX5" fmla="*/ 5952318 w 5952762"/>
                <a:gd name="connsiteY5" fmla="*/ 402104 h 918779"/>
                <a:gd name="connsiteX6" fmla="*/ 5937234 w 5952762"/>
                <a:gd name="connsiteY6" fmla="*/ 918779 h 918779"/>
                <a:gd name="connsiteX7" fmla="*/ 0 w 5952762"/>
                <a:gd name="connsiteY7" fmla="*/ 918779 h 918779"/>
                <a:gd name="connsiteX8" fmla="*/ 0 w 5952762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30157 w 5952389"/>
                <a:gd name="connsiteY5" fmla="*/ 357136 h 918779"/>
                <a:gd name="connsiteX6" fmla="*/ 5952318 w 5952389"/>
                <a:gd name="connsiteY6" fmla="*/ 402104 h 918779"/>
                <a:gd name="connsiteX7" fmla="*/ 5937234 w 5952389"/>
                <a:gd name="connsiteY7" fmla="*/ 918779 h 918779"/>
                <a:gd name="connsiteX8" fmla="*/ 0 w 5952389"/>
                <a:gd name="connsiteY8" fmla="*/ 918779 h 918779"/>
                <a:gd name="connsiteX9" fmla="*/ 0 w 5952389"/>
                <a:gd name="connsiteY9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400"/>
                <a:gd name="connsiteY0" fmla="*/ 0 h 918779"/>
                <a:gd name="connsiteX1" fmla="*/ 5937234 w 5952400"/>
                <a:gd name="connsiteY1" fmla="*/ 0 h 918779"/>
                <a:gd name="connsiteX2" fmla="*/ 5934287 w 5952400"/>
                <a:gd name="connsiteY2" fmla="*/ 269184 h 918779"/>
                <a:gd name="connsiteX3" fmla="*/ 5878641 w 5952400"/>
                <a:gd name="connsiteY3" fmla="*/ 290165 h 918779"/>
                <a:gd name="connsiteX4" fmla="*/ 5882932 w 5952400"/>
                <a:gd name="connsiteY4" fmla="*/ 365668 h 918779"/>
                <a:gd name="connsiteX5" fmla="*/ 5952318 w 5952400"/>
                <a:gd name="connsiteY5" fmla="*/ 402104 h 918779"/>
                <a:gd name="connsiteX6" fmla="*/ 5937234 w 5952400"/>
                <a:gd name="connsiteY6" fmla="*/ 918779 h 918779"/>
                <a:gd name="connsiteX7" fmla="*/ 0 w 5952400"/>
                <a:gd name="connsiteY7" fmla="*/ 918779 h 918779"/>
                <a:gd name="connsiteX8" fmla="*/ 0 w 5952400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6359902"/>
                <a:gd name="connsiteY0" fmla="*/ 0 h 918779"/>
                <a:gd name="connsiteX1" fmla="*/ 5937234 w 6359902"/>
                <a:gd name="connsiteY1" fmla="*/ 0 h 918779"/>
                <a:gd name="connsiteX2" fmla="*/ 5878641 w 6359902"/>
                <a:gd name="connsiteY2" fmla="*/ 290165 h 918779"/>
                <a:gd name="connsiteX3" fmla="*/ 5882932 w 6359902"/>
                <a:gd name="connsiteY3" fmla="*/ 365668 h 918779"/>
                <a:gd name="connsiteX4" fmla="*/ 5952318 w 6359902"/>
                <a:gd name="connsiteY4" fmla="*/ 402104 h 918779"/>
                <a:gd name="connsiteX5" fmla="*/ 5937234 w 6359902"/>
                <a:gd name="connsiteY5" fmla="*/ 918779 h 918779"/>
                <a:gd name="connsiteX6" fmla="*/ 0 w 6359902"/>
                <a:gd name="connsiteY6" fmla="*/ 918779 h 918779"/>
                <a:gd name="connsiteX7" fmla="*/ 0 w 6359902"/>
                <a:gd name="connsiteY7" fmla="*/ 0 h 918779"/>
                <a:gd name="connsiteX0" fmla="*/ 0 w 6358832"/>
                <a:gd name="connsiteY0" fmla="*/ 0 h 918779"/>
                <a:gd name="connsiteX1" fmla="*/ 5937234 w 6358832"/>
                <a:gd name="connsiteY1" fmla="*/ 0 h 918779"/>
                <a:gd name="connsiteX2" fmla="*/ 5882932 w 6358832"/>
                <a:gd name="connsiteY2" fmla="*/ 365668 h 918779"/>
                <a:gd name="connsiteX3" fmla="*/ 5952318 w 6358832"/>
                <a:gd name="connsiteY3" fmla="*/ 402104 h 918779"/>
                <a:gd name="connsiteX4" fmla="*/ 5937234 w 6358832"/>
                <a:gd name="connsiteY4" fmla="*/ 918779 h 918779"/>
                <a:gd name="connsiteX5" fmla="*/ 0 w 6358832"/>
                <a:gd name="connsiteY5" fmla="*/ 918779 h 918779"/>
                <a:gd name="connsiteX6" fmla="*/ 0 w 6358832"/>
                <a:gd name="connsiteY6" fmla="*/ 0 h 918779"/>
                <a:gd name="connsiteX0" fmla="*/ 0 w 6359360"/>
                <a:gd name="connsiteY0" fmla="*/ 0 h 918779"/>
                <a:gd name="connsiteX1" fmla="*/ 5937234 w 6359360"/>
                <a:gd name="connsiteY1" fmla="*/ 0 h 918779"/>
                <a:gd name="connsiteX2" fmla="*/ 5882932 w 6359360"/>
                <a:gd name="connsiteY2" fmla="*/ 365668 h 918779"/>
                <a:gd name="connsiteX3" fmla="*/ 5937234 w 6359360"/>
                <a:gd name="connsiteY3" fmla="*/ 918779 h 918779"/>
                <a:gd name="connsiteX4" fmla="*/ 0 w 6359360"/>
                <a:gd name="connsiteY4" fmla="*/ 918779 h 918779"/>
                <a:gd name="connsiteX5" fmla="*/ 0 w 6359360"/>
                <a:gd name="connsiteY5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937234" h="918779">
                  <a:moveTo>
                    <a:pt x="0" y="0"/>
                  </a:moveTo>
                  <a:lnTo>
                    <a:pt x="5937234" y="0"/>
                  </a:lnTo>
                  <a:lnTo>
                    <a:pt x="5937234" y="918779"/>
                  </a:lnTo>
                  <a:lnTo>
                    <a:pt x="0" y="91877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5" name="Rectangle 19"/>
            <p:cNvSpPr/>
            <p:nvPr/>
          </p:nvSpPr>
          <p:spPr>
            <a:xfrm>
              <a:off x="532257" y="5116716"/>
              <a:ext cx="2592000" cy="46778"/>
            </a:xfrm>
            <a:custGeom>
              <a:avLst/>
              <a:gdLst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6378699"/>
                <a:gd name="connsiteY0" fmla="*/ 0 h 918779"/>
                <a:gd name="connsiteX1" fmla="*/ 5937234 w 6378699"/>
                <a:gd name="connsiteY1" fmla="*/ 0 h 918779"/>
                <a:gd name="connsiteX2" fmla="*/ 5934287 w 6378699"/>
                <a:gd name="connsiteY2" fmla="*/ 389655 h 918779"/>
                <a:gd name="connsiteX3" fmla="*/ 5941907 w 6378699"/>
                <a:gd name="connsiteY3" fmla="*/ 385845 h 918779"/>
                <a:gd name="connsiteX4" fmla="*/ 5937234 w 6378699"/>
                <a:gd name="connsiteY4" fmla="*/ 918779 h 918779"/>
                <a:gd name="connsiteX5" fmla="*/ 0 w 6378699"/>
                <a:gd name="connsiteY5" fmla="*/ 918779 h 918779"/>
                <a:gd name="connsiteX6" fmla="*/ 0 w 6378699"/>
                <a:gd name="connsiteY6" fmla="*/ 0 h 918779"/>
                <a:gd name="connsiteX0" fmla="*/ 0 w 6377708"/>
                <a:gd name="connsiteY0" fmla="*/ 0 h 918779"/>
                <a:gd name="connsiteX1" fmla="*/ 5937234 w 6377708"/>
                <a:gd name="connsiteY1" fmla="*/ 0 h 918779"/>
                <a:gd name="connsiteX2" fmla="*/ 5934287 w 6377708"/>
                <a:gd name="connsiteY2" fmla="*/ 389655 h 918779"/>
                <a:gd name="connsiteX3" fmla="*/ 5938097 w 6377708"/>
                <a:gd name="connsiteY3" fmla="*/ 267735 h 918779"/>
                <a:gd name="connsiteX4" fmla="*/ 5937234 w 6377708"/>
                <a:gd name="connsiteY4" fmla="*/ 918779 h 918779"/>
                <a:gd name="connsiteX5" fmla="*/ 0 w 6377708"/>
                <a:gd name="connsiteY5" fmla="*/ 918779 h 918779"/>
                <a:gd name="connsiteX6" fmla="*/ 0 w 6377708"/>
                <a:gd name="connsiteY6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374319"/>
                <a:gd name="connsiteY0" fmla="*/ 0 h 918779"/>
                <a:gd name="connsiteX1" fmla="*/ 5937234 w 6374319"/>
                <a:gd name="connsiteY1" fmla="*/ 0 h 918779"/>
                <a:gd name="connsiteX2" fmla="*/ 5934287 w 6374319"/>
                <a:gd name="connsiteY2" fmla="*/ 389655 h 918779"/>
                <a:gd name="connsiteX3" fmla="*/ 5938097 w 6374319"/>
                <a:gd name="connsiteY3" fmla="*/ 267735 h 918779"/>
                <a:gd name="connsiteX4" fmla="*/ 5835227 w 6374319"/>
                <a:gd name="connsiteY4" fmla="*/ 305835 h 918779"/>
                <a:gd name="connsiteX5" fmla="*/ 5937234 w 6374319"/>
                <a:gd name="connsiteY5" fmla="*/ 918779 h 918779"/>
                <a:gd name="connsiteX6" fmla="*/ 0 w 6374319"/>
                <a:gd name="connsiteY6" fmla="*/ 918779 h 918779"/>
                <a:gd name="connsiteX7" fmla="*/ 0 w 6374319"/>
                <a:gd name="connsiteY7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079068"/>
                <a:gd name="connsiteY0" fmla="*/ 0 h 918779"/>
                <a:gd name="connsiteX1" fmla="*/ 5937234 w 6079068"/>
                <a:gd name="connsiteY1" fmla="*/ 0 h 918779"/>
                <a:gd name="connsiteX2" fmla="*/ 5934287 w 6079068"/>
                <a:gd name="connsiteY2" fmla="*/ 389655 h 918779"/>
                <a:gd name="connsiteX3" fmla="*/ 5938097 w 6079068"/>
                <a:gd name="connsiteY3" fmla="*/ 267735 h 918779"/>
                <a:gd name="connsiteX4" fmla="*/ 5835227 w 6079068"/>
                <a:gd name="connsiteY4" fmla="*/ 305835 h 918779"/>
                <a:gd name="connsiteX5" fmla="*/ 6079068 w 6079068"/>
                <a:gd name="connsiteY5" fmla="*/ 484905 h 918779"/>
                <a:gd name="connsiteX6" fmla="*/ 5937234 w 6079068"/>
                <a:gd name="connsiteY6" fmla="*/ 918779 h 918779"/>
                <a:gd name="connsiteX7" fmla="*/ 0 w 6079068"/>
                <a:gd name="connsiteY7" fmla="*/ 918779 h 918779"/>
                <a:gd name="connsiteX8" fmla="*/ 0 w 6079068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17248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197"/>
                <a:gd name="connsiteY0" fmla="*/ 0 h 918779"/>
                <a:gd name="connsiteX1" fmla="*/ 5937234 w 5948197"/>
                <a:gd name="connsiteY1" fmla="*/ 0 h 918779"/>
                <a:gd name="connsiteX2" fmla="*/ 5934287 w 5948197"/>
                <a:gd name="connsiteY2" fmla="*/ 172485 h 918779"/>
                <a:gd name="connsiteX3" fmla="*/ 5938097 w 5948197"/>
                <a:gd name="connsiteY3" fmla="*/ 267735 h 918779"/>
                <a:gd name="connsiteX4" fmla="*/ 5831417 w 5948197"/>
                <a:gd name="connsiteY4" fmla="*/ 355365 h 918779"/>
                <a:gd name="connsiteX5" fmla="*/ 5934288 w 5948197"/>
                <a:gd name="connsiteY5" fmla="*/ 420135 h 918779"/>
                <a:gd name="connsiteX6" fmla="*/ 5937234 w 5948197"/>
                <a:gd name="connsiteY6" fmla="*/ 918779 h 918779"/>
                <a:gd name="connsiteX7" fmla="*/ 0 w 5948197"/>
                <a:gd name="connsiteY7" fmla="*/ 918779 h 918779"/>
                <a:gd name="connsiteX8" fmla="*/ 0 w 5948197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17248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07618 w 5937234"/>
                <a:gd name="connsiteY6" fmla="*/ 374415 h 918779"/>
                <a:gd name="connsiteX7" fmla="*/ 5911428 w 5937234"/>
                <a:gd name="connsiteY7" fmla="*/ 366795 h 918779"/>
                <a:gd name="connsiteX8" fmla="*/ 5934288 w 5937234"/>
                <a:gd name="connsiteY8" fmla="*/ 420135 h 918779"/>
                <a:gd name="connsiteX9" fmla="*/ 5937234 w 5937234"/>
                <a:gd name="connsiteY9" fmla="*/ 918779 h 918779"/>
                <a:gd name="connsiteX10" fmla="*/ 0 w 5937234"/>
                <a:gd name="connsiteY10" fmla="*/ 918779 h 918779"/>
                <a:gd name="connsiteX11" fmla="*/ 0 w 5937234"/>
                <a:gd name="connsiteY11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580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86368 w 5942716"/>
                <a:gd name="connsiteY3" fmla="*/ 282438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8951"/>
                <a:gd name="connsiteY0" fmla="*/ 0 h 918779"/>
                <a:gd name="connsiteX1" fmla="*/ 5937234 w 5938951"/>
                <a:gd name="connsiteY1" fmla="*/ 0 h 918779"/>
                <a:gd name="connsiteX2" fmla="*/ 5929135 w 5938951"/>
                <a:gd name="connsiteY2" fmla="*/ 269184 h 918779"/>
                <a:gd name="connsiteX3" fmla="*/ 5886368 w 5938951"/>
                <a:gd name="connsiteY3" fmla="*/ 282438 h 918779"/>
                <a:gd name="connsiteX4" fmla="*/ 5882932 w 5938951"/>
                <a:gd name="connsiteY4" fmla="*/ 365668 h 918779"/>
                <a:gd name="connsiteX5" fmla="*/ 5934288 w 5938951"/>
                <a:gd name="connsiteY5" fmla="*/ 420135 h 918779"/>
                <a:gd name="connsiteX6" fmla="*/ 5937234 w 5938951"/>
                <a:gd name="connsiteY6" fmla="*/ 918779 h 918779"/>
                <a:gd name="connsiteX7" fmla="*/ 0 w 5938951"/>
                <a:gd name="connsiteY7" fmla="*/ 918779 h 918779"/>
                <a:gd name="connsiteX8" fmla="*/ 0 w 5938951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924"/>
                <a:gd name="connsiteY0" fmla="*/ 0 h 918779"/>
                <a:gd name="connsiteX1" fmla="*/ 5937234 w 5952924"/>
                <a:gd name="connsiteY1" fmla="*/ 0 h 918779"/>
                <a:gd name="connsiteX2" fmla="*/ 5929135 w 5952924"/>
                <a:gd name="connsiteY2" fmla="*/ 269184 h 918779"/>
                <a:gd name="connsiteX3" fmla="*/ 5886368 w 5952924"/>
                <a:gd name="connsiteY3" fmla="*/ 282438 h 918779"/>
                <a:gd name="connsiteX4" fmla="*/ 5882932 w 5952924"/>
                <a:gd name="connsiteY4" fmla="*/ 365668 h 918779"/>
                <a:gd name="connsiteX5" fmla="*/ 5943035 w 5952924"/>
                <a:gd name="connsiteY5" fmla="*/ 362287 h 918779"/>
                <a:gd name="connsiteX6" fmla="*/ 5952318 w 5952924"/>
                <a:gd name="connsiteY6" fmla="*/ 402104 h 918779"/>
                <a:gd name="connsiteX7" fmla="*/ 5937234 w 5952924"/>
                <a:gd name="connsiteY7" fmla="*/ 918779 h 918779"/>
                <a:gd name="connsiteX8" fmla="*/ 0 w 5952924"/>
                <a:gd name="connsiteY8" fmla="*/ 918779 h 918779"/>
                <a:gd name="connsiteX9" fmla="*/ 0 w 5952924"/>
                <a:gd name="connsiteY9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762"/>
                <a:gd name="connsiteY0" fmla="*/ 0 h 918779"/>
                <a:gd name="connsiteX1" fmla="*/ 5937234 w 5952762"/>
                <a:gd name="connsiteY1" fmla="*/ 0 h 918779"/>
                <a:gd name="connsiteX2" fmla="*/ 5934287 w 5952762"/>
                <a:gd name="connsiteY2" fmla="*/ 269184 h 918779"/>
                <a:gd name="connsiteX3" fmla="*/ 5886368 w 5952762"/>
                <a:gd name="connsiteY3" fmla="*/ 282438 h 918779"/>
                <a:gd name="connsiteX4" fmla="*/ 5882932 w 5952762"/>
                <a:gd name="connsiteY4" fmla="*/ 365668 h 918779"/>
                <a:gd name="connsiteX5" fmla="*/ 5952318 w 5952762"/>
                <a:gd name="connsiteY5" fmla="*/ 402104 h 918779"/>
                <a:gd name="connsiteX6" fmla="*/ 5937234 w 5952762"/>
                <a:gd name="connsiteY6" fmla="*/ 918779 h 918779"/>
                <a:gd name="connsiteX7" fmla="*/ 0 w 5952762"/>
                <a:gd name="connsiteY7" fmla="*/ 918779 h 918779"/>
                <a:gd name="connsiteX8" fmla="*/ 0 w 5952762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30157 w 5952389"/>
                <a:gd name="connsiteY5" fmla="*/ 357136 h 918779"/>
                <a:gd name="connsiteX6" fmla="*/ 5952318 w 5952389"/>
                <a:gd name="connsiteY6" fmla="*/ 402104 h 918779"/>
                <a:gd name="connsiteX7" fmla="*/ 5937234 w 5952389"/>
                <a:gd name="connsiteY7" fmla="*/ 918779 h 918779"/>
                <a:gd name="connsiteX8" fmla="*/ 0 w 5952389"/>
                <a:gd name="connsiteY8" fmla="*/ 918779 h 918779"/>
                <a:gd name="connsiteX9" fmla="*/ 0 w 5952389"/>
                <a:gd name="connsiteY9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400"/>
                <a:gd name="connsiteY0" fmla="*/ 0 h 918779"/>
                <a:gd name="connsiteX1" fmla="*/ 5937234 w 5952400"/>
                <a:gd name="connsiteY1" fmla="*/ 0 h 918779"/>
                <a:gd name="connsiteX2" fmla="*/ 5934287 w 5952400"/>
                <a:gd name="connsiteY2" fmla="*/ 269184 h 918779"/>
                <a:gd name="connsiteX3" fmla="*/ 5878641 w 5952400"/>
                <a:gd name="connsiteY3" fmla="*/ 290165 h 918779"/>
                <a:gd name="connsiteX4" fmla="*/ 5882932 w 5952400"/>
                <a:gd name="connsiteY4" fmla="*/ 365668 h 918779"/>
                <a:gd name="connsiteX5" fmla="*/ 5952318 w 5952400"/>
                <a:gd name="connsiteY5" fmla="*/ 402104 h 918779"/>
                <a:gd name="connsiteX6" fmla="*/ 5937234 w 5952400"/>
                <a:gd name="connsiteY6" fmla="*/ 918779 h 918779"/>
                <a:gd name="connsiteX7" fmla="*/ 0 w 5952400"/>
                <a:gd name="connsiteY7" fmla="*/ 918779 h 918779"/>
                <a:gd name="connsiteX8" fmla="*/ 0 w 5952400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6359902"/>
                <a:gd name="connsiteY0" fmla="*/ 0 h 918779"/>
                <a:gd name="connsiteX1" fmla="*/ 5937234 w 6359902"/>
                <a:gd name="connsiteY1" fmla="*/ 0 h 918779"/>
                <a:gd name="connsiteX2" fmla="*/ 5878641 w 6359902"/>
                <a:gd name="connsiteY2" fmla="*/ 290165 h 918779"/>
                <a:gd name="connsiteX3" fmla="*/ 5882932 w 6359902"/>
                <a:gd name="connsiteY3" fmla="*/ 365668 h 918779"/>
                <a:gd name="connsiteX4" fmla="*/ 5952318 w 6359902"/>
                <a:gd name="connsiteY4" fmla="*/ 402104 h 918779"/>
                <a:gd name="connsiteX5" fmla="*/ 5937234 w 6359902"/>
                <a:gd name="connsiteY5" fmla="*/ 918779 h 918779"/>
                <a:gd name="connsiteX6" fmla="*/ 0 w 6359902"/>
                <a:gd name="connsiteY6" fmla="*/ 918779 h 918779"/>
                <a:gd name="connsiteX7" fmla="*/ 0 w 6359902"/>
                <a:gd name="connsiteY7" fmla="*/ 0 h 918779"/>
                <a:gd name="connsiteX0" fmla="*/ 0 w 6358832"/>
                <a:gd name="connsiteY0" fmla="*/ 0 h 918779"/>
                <a:gd name="connsiteX1" fmla="*/ 5937234 w 6358832"/>
                <a:gd name="connsiteY1" fmla="*/ 0 h 918779"/>
                <a:gd name="connsiteX2" fmla="*/ 5882932 w 6358832"/>
                <a:gd name="connsiteY2" fmla="*/ 365668 h 918779"/>
                <a:gd name="connsiteX3" fmla="*/ 5952318 w 6358832"/>
                <a:gd name="connsiteY3" fmla="*/ 402104 h 918779"/>
                <a:gd name="connsiteX4" fmla="*/ 5937234 w 6358832"/>
                <a:gd name="connsiteY4" fmla="*/ 918779 h 918779"/>
                <a:gd name="connsiteX5" fmla="*/ 0 w 6358832"/>
                <a:gd name="connsiteY5" fmla="*/ 918779 h 918779"/>
                <a:gd name="connsiteX6" fmla="*/ 0 w 6358832"/>
                <a:gd name="connsiteY6" fmla="*/ 0 h 918779"/>
                <a:gd name="connsiteX0" fmla="*/ 0 w 6359360"/>
                <a:gd name="connsiteY0" fmla="*/ 0 h 918779"/>
                <a:gd name="connsiteX1" fmla="*/ 5937234 w 6359360"/>
                <a:gd name="connsiteY1" fmla="*/ 0 h 918779"/>
                <a:gd name="connsiteX2" fmla="*/ 5882932 w 6359360"/>
                <a:gd name="connsiteY2" fmla="*/ 365668 h 918779"/>
                <a:gd name="connsiteX3" fmla="*/ 5937234 w 6359360"/>
                <a:gd name="connsiteY3" fmla="*/ 918779 h 918779"/>
                <a:gd name="connsiteX4" fmla="*/ 0 w 6359360"/>
                <a:gd name="connsiteY4" fmla="*/ 918779 h 918779"/>
                <a:gd name="connsiteX5" fmla="*/ 0 w 6359360"/>
                <a:gd name="connsiteY5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937234" h="918779">
                  <a:moveTo>
                    <a:pt x="0" y="0"/>
                  </a:moveTo>
                  <a:lnTo>
                    <a:pt x="5937234" y="0"/>
                  </a:lnTo>
                  <a:lnTo>
                    <a:pt x="5937234" y="918779"/>
                  </a:lnTo>
                  <a:lnTo>
                    <a:pt x="0" y="91877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6" name="Rectangle 19"/>
            <p:cNvSpPr/>
            <p:nvPr/>
          </p:nvSpPr>
          <p:spPr>
            <a:xfrm>
              <a:off x="535266" y="5164995"/>
              <a:ext cx="2466000" cy="72000"/>
            </a:xfrm>
            <a:custGeom>
              <a:avLst/>
              <a:gdLst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6378699"/>
                <a:gd name="connsiteY0" fmla="*/ 0 h 918779"/>
                <a:gd name="connsiteX1" fmla="*/ 5937234 w 6378699"/>
                <a:gd name="connsiteY1" fmla="*/ 0 h 918779"/>
                <a:gd name="connsiteX2" fmla="*/ 5934287 w 6378699"/>
                <a:gd name="connsiteY2" fmla="*/ 389655 h 918779"/>
                <a:gd name="connsiteX3" fmla="*/ 5941907 w 6378699"/>
                <a:gd name="connsiteY3" fmla="*/ 385845 h 918779"/>
                <a:gd name="connsiteX4" fmla="*/ 5937234 w 6378699"/>
                <a:gd name="connsiteY4" fmla="*/ 918779 h 918779"/>
                <a:gd name="connsiteX5" fmla="*/ 0 w 6378699"/>
                <a:gd name="connsiteY5" fmla="*/ 918779 h 918779"/>
                <a:gd name="connsiteX6" fmla="*/ 0 w 6378699"/>
                <a:gd name="connsiteY6" fmla="*/ 0 h 918779"/>
                <a:gd name="connsiteX0" fmla="*/ 0 w 6377708"/>
                <a:gd name="connsiteY0" fmla="*/ 0 h 918779"/>
                <a:gd name="connsiteX1" fmla="*/ 5937234 w 6377708"/>
                <a:gd name="connsiteY1" fmla="*/ 0 h 918779"/>
                <a:gd name="connsiteX2" fmla="*/ 5934287 w 6377708"/>
                <a:gd name="connsiteY2" fmla="*/ 389655 h 918779"/>
                <a:gd name="connsiteX3" fmla="*/ 5938097 w 6377708"/>
                <a:gd name="connsiteY3" fmla="*/ 267735 h 918779"/>
                <a:gd name="connsiteX4" fmla="*/ 5937234 w 6377708"/>
                <a:gd name="connsiteY4" fmla="*/ 918779 h 918779"/>
                <a:gd name="connsiteX5" fmla="*/ 0 w 6377708"/>
                <a:gd name="connsiteY5" fmla="*/ 918779 h 918779"/>
                <a:gd name="connsiteX6" fmla="*/ 0 w 6377708"/>
                <a:gd name="connsiteY6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374319"/>
                <a:gd name="connsiteY0" fmla="*/ 0 h 918779"/>
                <a:gd name="connsiteX1" fmla="*/ 5937234 w 6374319"/>
                <a:gd name="connsiteY1" fmla="*/ 0 h 918779"/>
                <a:gd name="connsiteX2" fmla="*/ 5934287 w 6374319"/>
                <a:gd name="connsiteY2" fmla="*/ 389655 h 918779"/>
                <a:gd name="connsiteX3" fmla="*/ 5938097 w 6374319"/>
                <a:gd name="connsiteY3" fmla="*/ 267735 h 918779"/>
                <a:gd name="connsiteX4" fmla="*/ 5835227 w 6374319"/>
                <a:gd name="connsiteY4" fmla="*/ 305835 h 918779"/>
                <a:gd name="connsiteX5" fmla="*/ 5937234 w 6374319"/>
                <a:gd name="connsiteY5" fmla="*/ 918779 h 918779"/>
                <a:gd name="connsiteX6" fmla="*/ 0 w 6374319"/>
                <a:gd name="connsiteY6" fmla="*/ 918779 h 918779"/>
                <a:gd name="connsiteX7" fmla="*/ 0 w 6374319"/>
                <a:gd name="connsiteY7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079068"/>
                <a:gd name="connsiteY0" fmla="*/ 0 h 918779"/>
                <a:gd name="connsiteX1" fmla="*/ 5937234 w 6079068"/>
                <a:gd name="connsiteY1" fmla="*/ 0 h 918779"/>
                <a:gd name="connsiteX2" fmla="*/ 5934287 w 6079068"/>
                <a:gd name="connsiteY2" fmla="*/ 389655 h 918779"/>
                <a:gd name="connsiteX3" fmla="*/ 5938097 w 6079068"/>
                <a:gd name="connsiteY3" fmla="*/ 267735 h 918779"/>
                <a:gd name="connsiteX4" fmla="*/ 5835227 w 6079068"/>
                <a:gd name="connsiteY4" fmla="*/ 305835 h 918779"/>
                <a:gd name="connsiteX5" fmla="*/ 6079068 w 6079068"/>
                <a:gd name="connsiteY5" fmla="*/ 484905 h 918779"/>
                <a:gd name="connsiteX6" fmla="*/ 5937234 w 6079068"/>
                <a:gd name="connsiteY6" fmla="*/ 918779 h 918779"/>
                <a:gd name="connsiteX7" fmla="*/ 0 w 6079068"/>
                <a:gd name="connsiteY7" fmla="*/ 918779 h 918779"/>
                <a:gd name="connsiteX8" fmla="*/ 0 w 6079068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17248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197"/>
                <a:gd name="connsiteY0" fmla="*/ 0 h 918779"/>
                <a:gd name="connsiteX1" fmla="*/ 5937234 w 5948197"/>
                <a:gd name="connsiteY1" fmla="*/ 0 h 918779"/>
                <a:gd name="connsiteX2" fmla="*/ 5934287 w 5948197"/>
                <a:gd name="connsiteY2" fmla="*/ 172485 h 918779"/>
                <a:gd name="connsiteX3" fmla="*/ 5938097 w 5948197"/>
                <a:gd name="connsiteY3" fmla="*/ 267735 h 918779"/>
                <a:gd name="connsiteX4" fmla="*/ 5831417 w 5948197"/>
                <a:gd name="connsiteY4" fmla="*/ 355365 h 918779"/>
                <a:gd name="connsiteX5" fmla="*/ 5934288 w 5948197"/>
                <a:gd name="connsiteY5" fmla="*/ 420135 h 918779"/>
                <a:gd name="connsiteX6" fmla="*/ 5937234 w 5948197"/>
                <a:gd name="connsiteY6" fmla="*/ 918779 h 918779"/>
                <a:gd name="connsiteX7" fmla="*/ 0 w 5948197"/>
                <a:gd name="connsiteY7" fmla="*/ 918779 h 918779"/>
                <a:gd name="connsiteX8" fmla="*/ 0 w 5948197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17248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07618 w 5937234"/>
                <a:gd name="connsiteY6" fmla="*/ 374415 h 918779"/>
                <a:gd name="connsiteX7" fmla="*/ 5911428 w 5937234"/>
                <a:gd name="connsiteY7" fmla="*/ 366795 h 918779"/>
                <a:gd name="connsiteX8" fmla="*/ 5934288 w 5937234"/>
                <a:gd name="connsiteY8" fmla="*/ 420135 h 918779"/>
                <a:gd name="connsiteX9" fmla="*/ 5937234 w 5937234"/>
                <a:gd name="connsiteY9" fmla="*/ 918779 h 918779"/>
                <a:gd name="connsiteX10" fmla="*/ 0 w 5937234"/>
                <a:gd name="connsiteY10" fmla="*/ 918779 h 918779"/>
                <a:gd name="connsiteX11" fmla="*/ 0 w 5937234"/>
                <a:gd name="connsiteY11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580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86368 w 5942716"/>
                <a:gd name="connsiteY3" fmla="*/ 282438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8951"/>
                <a:gd name="connsiteY0" fmla="*/ 0 h 918779"/>
                <a:gd name="connsiteX1" fmla="*/ 5937234 w 5938951"/>
                <a:gd name="connsiteY1" fmla="*/ 0 h 918779"/>
                <a:gd name="connsiteX2" fmla="*/ 5929135 w 5938951"/>
                <a:gd name="connsiteY2" fmla="*/ 269184 h 918779"/>
                <a:gd name="connsiteX3" fmla="*/ 5886368 w 5938951"/>
                <a:gd name="connsiteY3" fmla="*/ 282438 h 918779"/>
                <a:gd name="connsiteX4" fmla="*/ 5882932 w 5938951"/>
                <a:gd name="connsiteY4" fmla="*/ 365668 h 918779"/>
                <a:gd name="connsiteX5" fmla="*/ 5934288 w 5938951"/>
                <a:gd name="connsiteY5" fmla="*/ 420135 h 918779"/>
                <a:gd name="connsiteX6" fmla="*/ 5937234 w 5938951"/>
                <a:gd name="connsiteY6" fmla="*/ 918779 h 918779"/>
                <a:gd name="connsiteX7" fmla="*/ 0 w 5938951"/>
                <a:gd name="connsiteY7" fmla="*/ 918779 h 918779"/>
                <a:gd name="connsiteX8" fmla="*/ 0 w 5938951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924"/>
                <a:gd name="connsiteY0" fmla="*/ 0 h 918779"/>
                <a:gd name="connsiteX1" fmla="*/ 5937234 w 5952924"/>
                <a:gd name="connsiteY1" fmla="*/ 0 h 918779"/>
                <a:gd name="connsiteX2" fmla="*/ 5929135 w 5952924"/>
                <a:gd name="connsiteY2" fmla="*/ 269184 h 918779"/>
                <a:gd name="connsiteX3" fmla="*/ 5886368 w 5952924"/>
                <a:gd name="connsiteY3" fmla="*/ 282438 h 918779"/>
                <a:gd name="connsiteX4" fmla="*/ 5882932 w 5952924"/>
                <a:gd name="connsiteY4" fmla="*/ 365668 h 918779"/>
                <a:gd name="connsiteX5" fmla="*/ 5943035 w 5952924"/>
                <a:gd name="connsiteY5" fmla="*/ 362287 h 918779"/>
                <a:gd name="connsiteX6" fmla="*/ 5952318 w 5952924"/>
                <a:gd name="connsiteY6" fmla="*/ 402104 h 918779"/>
                <a:gd name="connsiteX7" fmla="*/ 5937234 w 5952924"/>
                <a:gd name="connsiteY7" fmla="*/ 918779 h 918779"/>
                <a:gd name="connsiteX8" fmla="*/ 0 w 5952924"/>
                <a:gd name="connsiteY8" fmla="*/ 918779 h 918779"/>
                <a:gd name="connsiteX9" fmla="*/ 0 w 5952924"/>
                <a:gd name="connsiteY9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762"/>
                <a:gd name="connsiteY0" fmla="*/ 0 h 918779"/>
                <a:gd name="connsiteX1" fmla="*/ 5937234 w 5952762"/>
                <a:gd name="connsiteY1" fmla="*/ 0 h 918779"/>
                <a:gd name="connsiteX2" fmla="*/ 5934287 w 5952762"/>
                <a:gd name="connsiteY2" fmla="*/ 269184 h 918779"/>
                <a:gd name="connsiteX3" fmla="*/ 5886368 w 5952762"/>
                <a:gd name="connsiteY3" fmla="*/ 282438 h 918779"/>
                <a:gd name="connsiteX4" fmla="*/ 5882932 w 5952762"/>
                <a:gd name="connsiteY4" fmla="*/ 365668 h 918779"/>
                <a:gd name="connsiteX5" fmla="*/ 5952318 w 5952762"/>
                <a:gd name="connsiteY5" fmla="*/ 402104 h 918779"/>
                <a:gd name="connsiteX6" fmla="*/ 5937234 w 5952762"/>
                <a:gd name="connsiteY6" fmla="*/ 918779 h 918779"/>
                <a:gd name="connsiteX7" fmla="*/ 0 w 5952762"/>
                <a:gd name="connsiteY7" fmla="*/ 918779 h 918779"/>
                <a:gd name="connsiteX8" fmla="*/ 0 w 5952762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30157 w 5952389"/>
                <a:gd name="connsiteY5" fmla="*/ 357136 h 918779"/>
                <a:gd name="connsiteX6" fmla="*/ 5952318 w 5952389"/>
                <a:gd name="connsiteY6" fmla="*/ 402104 h 918779"/>
                <a:gd name="connsiteX7" fmla="*/ 5937234 w 5952389"/>
                <a:gd name="connsiteY7" fmla="*/ 918779 h 918779"/>
                <a:gd name="connsiteX8" fmla="*/ 0 w 5952389"/>
                <a:gd name="connsiteY8" fmla="*/ 918779 h 918779"/>
                <a:gd name="connsiteX9" fmla="*/ 0 w 5952389"/>
                <a:gd name="connsiteY9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400"/>
                <a:gd name="connsiteY0" fmla="*/ 0 h 918779"/>
                <a:gd name="connsiteX1" fmla="*/ 5937234 w 5952400"/>
                <a:gd name="connsiteY1" fmla="*/ 0 h 918779"/>
                <a:gd name="connsiteX2" fmla="*/ 5934287 w 5952400"/>
                <a:gd name="connsiteY2" fmla="*/ 269184 h 918779"/>
                <a:gd name="connsiteX3" fmla="*/ 5878641 w 5952400"/>
                <a:gd name="connsiteY3" fmla="*/ 290165 h 918779"/>
                <a:gd name="connsiteX4" fmla="*/ 5882932 w 5952400"/>
                <a:gd name="connsiteY4" fmla="*/ 365668 h 918779"/>
                <a:gd name="connsiteX5" fmla="*/ 5952318 w 5952400"/>
                <a:gd name="connsiteY5" fmla="*/ 402104 h 918779"/>
                <a:gd name="connsiteX6" fmla="*/ 5937234 w 5952400"/>
                <a:gd name="connsiteY6" fmla="*/ 918779 h 918779"/>
                <a:gd name="connsiteX7" fmla="*/ 0 w 5952400"/>
                <a:gd name="connsiteY7" fmla="*/ 918779 h 918779"/>
                <a:gd name="connsiteX8" fmla="*/ 0 w 5952400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6359902"/>
                <a:gd name="connsiteY0" fmla="*/ 0 h 918779"/>
                <a:gd name="connsiteX1" fmla="*/ 5937234 w 6359902"/>
                <a:gd name="connsiteY1" fmla="*/ 0 h 918779"/>
                <a:gd name="connsiteX2" fmla="*/ 5878641 w 6359902"/>
                <a:gd name="connsiteY2" fmla="*/ 290165 h 918779"/>
                <a:gd name="connsiteX3" fmla="*/ 5882932 w 6359902"/>
                <a:gd name="connsiteY3" fmla="*/ 365668 h 918779"/>
                <a:gd name="connsiteX4" fmla="*/ 5952318 w 6359902"/>
                <a:gd name="connsiteY4" fmla="*/ 402104 h 918779"/>
                <a:gd name="connsiteX5" fmla="*/ 5937234 w 6359902"/>
                <a:gd name="connsiteY5" fmla="*/ 918779 h 918779"/>
                <a:gd name="connsiteX6" fmla="*/ 0 w 6359902"/>
                <a:gd name="connsiteY6" fmla="*/ 918779 h 918779"/>
                <a:gd name="connsiteX7" fmla="*/ 0 w 6359902"/>
                <a:gd name="connsiteY7" fmla="*/ 0 h 918779"/>
                <a:gd name="connsiteX0" fmla="*/ 0 w 6358832"/>
                <a:gd name="connsiteY0" fmla="*/ 0 h 918779"/>
                <a:gd name="connsiteX1" fmla="*/ 5937234 w 6358832"/>
                <a:gd name="connsiteY1" fmla="*/ 0 h 918779"/>
                <a:gd name="connsiteX2" fmla="*/ 5882932 w 6358832"/>
                <a:gd name="connsiteY2" fmla="*/ 365668 h 918779"/>
                <a:gd name="connsiteX3" fmla="*/ 5952318 w 6358832"/>
                <a:gd name="connsiteY3" fmla="*/ 402104 h 918779"/>
                <a:gd name="connsiteX4" fmla="*/ 5937234 w 6358832"/>
                <a:gd name="connsiteY4" fmla="*/ 918779 h 918779"/>
                <a:gd name="connsiteX5" fmla="*/ 0 w 6358832"/>
                <a:gd name="connsiteY5" fmla="*/ 918779 h 918779"/>
                <a:gd name="connsiteX6" fmla="*/ 0 w 6358832"/>
                <a:gd name="connsiteY6" fmla="*/ 0 h 918779"/>
                <a:gd name="connsiteX0" fmla="*/ 0 w 6359360"/>
                <a:gd name="connsiteY0" fmla="*/ 0 h 918779"/>
                <a:gd name="connsiteX1" fmla="*/ 5937234 w 6359360"/>
                <a:gd name="connsiteY1" fmla="*/ 0 h 918779"/>
                <a:gd name="connsiteX2" fmla="*/ 5882932 w 6359360"/>
                <a:gd name="connsiteY2" fmla="*/ 365668 h 918779"/>
                <a:gd name="connsiteX3" fmla="*/ 5937234 w 6359360"/>
                <a:gd name="connsiteY3" fmla="*/ 918779 h 918779"/>
                <a:gd name="connsiteX4" fmla="*/ 0 w 6359360"/>
                <a:gd name="connsiteY4" fmla="*/ 918779 h 918779"/>
                <a:gd name="connsiteX5" fmla="*/ 0 w 6359360"/>
                <a:gd name="connsiteY5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937234" h="918779">
                  <a:moveTo>
                    <a:pt x="0" y="0"/>
                  </a:moveTo>
                  <a:lnTo>
                    <a:pt x="5937234" y="0"/>
                  </a:lnTo>
                  <a:lnTo>
                    <a:pt x="5937234" y="918779"/>
                  </a:lnTo>
                  <a:lnTo>
                    <a:pt x="0" y="91877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7" name="Rectangle 19"/>
            <p:cNvSpPr/>
            <p:nvPr/>
          </p:nvSpPr>
          <p:spPr>
            <a:xfrm>
              <a:off x="535266" y="5237427"/>
              <a:ext cx="2880000" cy="46778"/>
            </a:xfrm>
            <a:custGeom>
              <a:avLst/>
              <a:gdLst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6378699"/>
                <a:gd name="connsiteY0" fmla="*/ 0 h 918779"/>
                <a:gd name="connsiteX1" fmla="*/ 5937234 w 6378699"/>
                <a:gd name="connsiteY1" fmla="*/ 0 h 918779"/>
                <a:gd name="connsiteX2" fmla="*/ 5934287 w 6378699"/>
                <a:gd name="connsiteY2" fmla="*/ 389655 h 918779"/>
                <a:gd name="connsiteX3" fmla="*/ 5941907 w 6378699"/>
                <a:gd name="connsiteY3" fmla="*/ 385845 h 918779"/>
                <a:gd name="connsiteX4" fmla="*/ 5937234 w 6378699"/>
                <a:gd name="connsiteY4" fmla="*/ 918779 h 918779"/>
                <a:gd name="connsiteX5" fmla="*/ 0 w 6378699"/>
                <a:gd name="connsiteY5" fmla="*/ 918779 h 918779"/>
                <a:gd name="connsiteX6" fmla="*/ 0 w 6378699"/>
                <a:gd name="connsiteY6" fmla="*/ 0 h 918779"/>
                <a:gd name="connsiteX0" fmla="*/ 0 w 6377708"/>
                <a:gd name="connsiteY0" fmla="*/ 0 h 918779"/>
                <a:gd name="connsiteX1" fmla="*/ 5937234 w 6377708"/>
                <a:gd name="connsiteY1" fmla="*/ 0 h 918779"/>
                <a:gd name="connsiteX2" fmla="*/ 5934287 w 6377708"/>
                <a:gd name="connsiteY2" fmla="*/ 389655 h 918779"/>
                <a:gd name="connsiteX3" fmla="*/ 5938097 w 6377708"/>
                <a:gd name="connsiteY3" fmla="*/ 267735 h 918779"/>
                <a:gd name="connsiteX4" fmla="*/ 5937234 w 6377708"/>
                <a:gd name="connsiteY4" fmla="*/ 918779 h 918779"/>
                <a:gd name="connsiteX5" fmla="*/ 0 w 6377708"/>
                <a:gd name="connsiteY5" fmla="*/ 918779 h 918779"/>
                <a:gd name="connsiteX6" fmla="*/ 0 w 6377708"/>
                <a:gd name="connsiteY6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374319"/>
                <a:gd name="connsiteY0" fmla="*/ 0 h 918779"/>
                <a:gd name="connsiteX1" fmla="*/ 5937234 w 6374319"/>
                <a:gd name="connsiteY1" fmla="*/ 0 h 918779"/>
                <a:gd name="connsiteX2" fmla="*/ 5934287 w 6374319"/>
                <a:gd name="connsiteY2" fmla="*/ 389655 h 918779"/>
                <a:gd name="connsiteX3" fmla="*/ 5938097 w 6374319"/>
                <a:gd name="connsiteY3" fmla="*/ 267735 h 918779"/>
                <a:gd name="connsiteX4" fmla="*/ 5835227 w 6374319"/>
                <a:gd name="connsiteY4" fmla="*/ 305835 h 918779"/>
                <a:gd name="connsiteX5" fmla="*/ 5937234 w 6374319"/>
                <a:gd name="connsiteY5" fmla="*/ 918779 h 918779"/>
                <a:gd name="connsiteX6" fmla="*/ 0 w 6374319"/>
                <a:gd name="connsiteY6" fmla="*/ 918779 h 918779"/>
                <a:gd name="connsiteX7" fmla="*/ 0 w 6374319"/>
                <a:gd name="connsiteY7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079068"/>
                <a:gd name="connsiteY0" fmla="*/ 0 h 918779"/>
                <a:gd name="connsiteX1" fmla="*/ 5937234 w 6079068"/>
                <a:gd name="connsiteY1" fmla="*/ 0 h 918779"/>
                <a:gd name="connsiteX2" fmla="*/ 5934287 w 6079068"/>
                <a:gd name="connsiteY2" fmla="*/ 389655 h 918779"/>
                <a:gd name="connsiteX3" fmla="*/ 5938097 w 6079068"/>
                <a:gd name="connsiteY3" fmla="*/ 267735 h 918779"/>
                <a:gd name="connsiteX4" fmla="*/ 5835227 w 6079068"/>
                <a:gd name="connsiteY4" fmla="*/ 305835 h 918779"/>
                <a:gd name="connsiteX5" fmla="*/ 6079068 w 6079068"/>
                <a:gd name="connsiteY5" fmla="*/ 484905 h 918779"/>
                <a:gd name="connsiteX6" fmla="*/ 5937234 w 6079068"/>
                <a:gd name="connsiteY6" fmla="*/ 918779 h 918779"/>
                <a:gd name="connsiteX7" fmla="*/ 0 w 6079068"/>
                <a:gd name="connsiteY7" fmla="*/ 918779 h 918779"/>
                <a:gd name="connsiteX8" fmla="*/ 0 w 6079068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17248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197"/>
                <a:gd name="connsiteY0" fmla="*/ 0 h 918779"/>
                <a:gd name="connsiteX1" fmla="*/ 5937234 w 5948197"/>
                <a:gd name="connsiteY1" fmla="*/ 0 h 918779"/>
                <a:gd name="connsiteX2" fmla="*/ 5934287 w 5948197"/>
                <a:gd name="connsiteY2" fmla="*/ 172485 h 918779"/>
                <a:gd name="connsiteX3" fmla="*/ 5938097 w 5948197"/>
                <a:gd name="connsiteY3" fmla="*/ 267735 h 918779"/>
                <a:gd name="connsiteX4" fmla="*/ 5831417 w 5948197"/>
                <a:gd name="connsiteY4" fmla="*/ 355365 h 918779"/>
                <a:gd name="connsiteX5" fmla="*/ 5934288 w 5948197"/>
                <a:gd name="connsiteY5" fmla="*/ 420135 h 918779"/>
                <a:gd name="connsiteX6" fmla="*/ 5937234 w 5948197"/>
                <a:gd name="connsiteY6" fmla="*/ 918779 h 918779"/>
                <a:gd name="connsiteX7" fmla="*/ 0 w 5948197"/>
                <a:gd name="connsiteY7" fmla="*/ 918779 h 918779"/>
                <a:gd name="connsiteX8" fmla="*/ 0 w 5948197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17248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07618 w 5937234"/>
                <a:gd name="connsiteY6" fmla="*/ 374415 h 918779"/>
                <a:gd name="connsiteX7" fmla="*/ 5911428 w 5937234"/>
                <a:gd name="connsiteY7" fmla="*/ 366795 h 918779"/>
                <a:gd name="connsiteX8" fmla="*/ 5934288 w 5937234"/>
                <a:gd name="connsiteY8" fmla="*/ 420135 h 918779"/>
                <a:gd name="connsiteX9" fmla="*/ 5937234 w 5937234"/>
                <a:gd name="connsiteY9" fmla="*/ 918779 h 918779"/>
                <a:gd name="connsiteX10" fmla="*/ 0 w 5937234"/>
                <a:gd name="connsiteY10" fmla="*/ 918779 h 918779"/>
                <a:gd name="connsiteX11" fmla="*/ 0 w 5937234"/>
                <a:gd name="connsiteY11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580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86368 w 5942716"/>
                <a:gd name="connsiteY3" fmla="*/ 282438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8951"/>
                <a:gd name="connsiteY0" fmla="*/ 0 h 918779"/>
                <a:gd name="connsiteX1" fmla="*/ 5937234 w 5938951"/>
                <a:gd name="connsiteY1" fmla="*/ 0 h 918779"/>
                <a:gd name="connsiteX2" fmla="*/ 5929135 w 5938951"/>
                <a:gd name="connsiteY2" fmla="*/ 269184 h 918779"/>
                <a:gd name="connsiteX3" fmla="*/ 5886368 w 5938951"/>
                <a:gd name="connsiteY3" fmla="*/ 282438 h 918779"/>
                <a:gd name="connsiteX4" fmla="*/ 5882932 w 5938951"/>
                <a:gd name="connsiteY4" fmla="*/ 365668 h 918779"/>
                <a:gd name="connsiteX5" fmla="*/ 5934288 w 5938951"/>
                <a:gd name="connsiteY5" fmla="*/ 420135 h 918779"/>
                <a:gd name="connsiteX6" fmla="*/ 5937234 w 5938951"/>
                <a:gd name="connsiteY6" fmla="*/ 918779 h 918779"/>
                <a:gd name="connsiteX7" fmla="*/ 0 w 5938951"/>
                <a:gd name="connsiteY7" fmla="*/ 918779 h 918779"/>
                <a:gd name="connsiteX8" fmla="*/ 0 w 5938951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924"/>
                <a:gd name="connsiteY0" fmla="*/ 0 h 918779"/>
                <a:gd name="connsiteX1" fmla="*/ 5937234 w 5952924"/>
                <a:gd name="connsiteY1" fmla="*/ 0 h 918779"/>
                <a:gd name="connsiteX2" fmla="*/ 5929135 w 5952924"/>
                <a:gd name="connsiteY2" fmla="*/ 269184 h 918779"/>
                <a:gd name="connsiteX3" fmla="*/ 5886368 w 5952924"/>
                <a:gd name="connsiteY3" fmla="*/ 282438 h 918779"/>
                <a:gd name="connsiteX4" fmla="*/ 5882932 w 5952924"/>
                <a:gd name="connsiteY4" fmla="*/ 365668 h 918779"/>
                <a:gd name="connsiteX5" fmla="*/ 5943035 w 5952924"/>
                <a:gd name="connsiteY5" fmla="*/ 362287 h 918779"/>
                <a:gd name="connsiteX6" fmla="*/ 5952318 w 5952924"/>
                <a:gd name="connsiteY6" fmla="*/ 402104 h 918779"/>
                <a:gd name="connsiteX7" fmla="*/ 5937234 w 5952924"/>
                <a:gd name="connsiteY7" fmla="*/ 918779 h 918779"/>
                <a:gd name="connsiteX8" fmla="*/ 0 w 5952924"/>
                <a:gd name="connsiteY8" fmla="*/ 918779 h 918779"/>
                <a:gd name="connsiteX9" fmla="*/ 0 w 5952924"/>
                <a:gd name="connsiteY9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762"/>
                <a:gd name="connsiteY0" fmla="*/ 0 h 918779"/>
                <a:gd name="connsiteX1" fmla="*/ 5937234 w 5952762"/>
                <a:gd name="connsiteY1" fmla="*/ 0 h 918779"/>
                <a:gd name="connsiteX2" fmla="*/ 5934287 w 5952762"/>
                <a:gd name="connsiteY2" fmla="*/ 269184 h 918779"/>
                <a:gd name="connsiteX3" fmla="*/ 5886368 w 5952762"/>
                <a:gd name="connsiteY3" fmla="*/ 282438 h 918779"/>
                <a:gd name="connsiteX4" fmla="*/ 5882932 w 5952762"/>
                <a:gd name="connsiteY4" fmla="*/ 365668 h 918779"/>
                <a:gd name="connsiteX5" fmla="*/ 5952318 w 5952762"/>
                <a:gd name="connsiteY5" fmla="*/ 402104 h 918779"/>
                <a:gd name="connsiteX6" fmla="*/ 5937234 w 5952762"/>
                <a:gd name="connsiteY6" fmla="*/ 918779 h 918779"/>
                <a:gd name="connsiteX7" fmla="*/ 0 w 5952762"/>
                <a:gd name="connsiteY7" fmla="*/ 918779 h 918779"/>
                <a:gd name="connsiteX8" fmla="*/ 0 w 5952762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30157 w 5952389"/>
                <a:gd name="connsiteY5" fmla="*/ 357136 h 918779"/>
                <a:gd name="connsiteX6" fmla="*/ 5952318 w 5952389"/>
                <a:gd name="connsiteY6" fmla="*/ 402104 h 918779"/>
                <a:gd name="connsiteX7" fmla="*/ 5937234 w 5952389"/>
                <a:gd name="connsiteY7" fmla="*/ 918779 h 918779"/>
                <a:gd name="connsiteX8" fmla="*/ 0 w 5952389"/>
                <a:gd name="connsiteY8" fmla="*/ 918779 h 918779"/>
                <a:gd name="connsiteX9" fmla="*/ 0 w 5952389"/>
                <a:gd name="connsiteY9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400"/>
                <a:gd name="connsiteY0" fmla="*/ 0 h 918779"/>
                <a:gd name="connsiteX1" fmla="*/ 5937234 w 5952400"/>
                <a:gd name="connsiteY1" fmla="*/ 0 h 918779"/>
                <a:gd name="connsiteX2" fmla="*/ 5934287 w 5952400"/>
                <a:gd name="connsiteY2" fmla="*/ 269184 h 918779"/>
                <a:gd name="connsiteX3" fmla="*/ 5878641 w 5952400"/>
                <a:gd name="connsiteY3" fmla="*/ 290165 h 918779"/>
                <a:gd name="connsiteX4" fmla="*/ 5882932 w 5952400"/>
                <a:gd name="connsiteY4" fmla="*/ 365668 h 918779"/>
                <a:gd name="connsiteX5" fmla="*/ 5952318 w 5952400"/>
                <a:gd name="connsiteY5" fmla="*/ 402104 h 918779"/>
                <a:gd name="connsiteX6" fmla="*/ 5937234 w 5952400"/>
                <a:gd name="connsiteY6" fmla="*/ 918779 h 918779"/>
                <a:gd name="connsiteX7" fmla="*/ 0 w 5952400"/>
                <a:gd name="connsiteY7" fmla="*/ 918779 h 918779"/>
                <a:gd name="connsiteX8" fmla="*/ 0 w 5952400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6359902"/>
                <a:gd name="connsiteY0" fmla="*/ 0 h 918779"/>
                <a:gd name="connsiteX1" fmla="*/ 5937234 w 6359902"/>
                <a:gd name="connsiteY1" fmla="*/ 0 h 918779"/>
                <a:gd name="connsiteX2" fmla="*/ 5878641 w 6359902"/>
                <a:gd name="connsiteY2" fmla="*/ 290165 h 918779"/>
                <a:gd name="connsiteX3" fmla="*/ 5882932 w 6359902"/>
                <a:gd name="connsiteY3" fmla="*/ 365668 h 918779"/>
                <a:gd name="connsiteX4" fmla="*/ 5952318 w 6359902"/>
                <a:gd name="connsiteY4" fmla="*/ 402104 h 918779"/>
                <a:gd name="connsiteX5" fmla="*/ 5937234 w 6359902"/>
                <a:gd name="connsiteY5" fmla="*/ 918779 h 918779"/>
                <a:gd name="connsiteX6" fmla="*/ 0 w 6359902"/>
                <a:gd name="connsiteY6" fmla="*/ 918779 h 918779"/>
                <a:gd name="connsiteX7" fmla="*/ 0 w 6359902"/>
                <a:gd name="connsiteY7" fmla="*/ 0 h 918779"/>
                <a:gd name="connsiteX0" fmla="*/ 0 w 6358832"/>
                <a:gd name="connsiteY0" fmla="*/ 0 h 918779"/>
                <a:gd name="connsiteX1" fmla="*/ 5937234 w 6358832"/>
                <a:gd name="connsiteY1" fmla="*/ 0 h 918779"/>
                <a:gd name="connsiteX2" fmla="*/ 5882932 w 6358832"/>
                <a:gd name="connsiteY2" fmla="*/ 365668 h 918779"/>
                <a:gd name="connsiteX3" fmla="*/ 5952318 w 6358832"/>
                <a:gd name="connsiteY3" fmla="*/ 402104 h 918779"/>
                <a:gd name="connsiteX4" fmla="*/ 5937234 w 6358832"/>
                <a:gd name="connsiteY4" fmla="*/ 918779 h 918779"/>
                <a:gd name="connsiteX5" fmla="*/ 0 w 6358832"/>
                <a:gd name="connsiteY5" fmla="*/ 918779 h 918779"/>
                <a:gd name="connsiteX6" fmla="*/ 0 w 6358832"/>
                <a:gd name="connsiteY6" fmla="*/ 0 h 918779"/>
                <a:gd name="connsiteX0" fmla="*/ 0 w 6359360"/>
                <a:gd name="connsiteY0" fmla="*/ 0 h 918779"/>
                <a:gd name="connsiteX1" fmla="*/ 5937234 w 6359360"/>
                <a:gd name="connsiteY1" fmla="*/ 0 h 918779"/>
                <a:gd name="connsiteX2" fmla="*/ 5882932 w 6359360"/>
                <a:gd name="connsiteY2" fmla="*/ 365668 h 918779"/>
                <a:gd name="connsiteX3" fmla="*/ 5937234 w 6359360"/>
                <a:gd name="connsiteY3" fmla="*/ 918779 h 918779"/>
                <a:gd name="connsiteX4" fmla="*/ 0 w 6359360"/>
                <a:gd name="connsiteY4" fmla="*/ 918779 h 918779"/>
                <a:gd name="connsiteX5" fmla="*/ 0 w 6359360"/>
                <a:gd name="connsiteY5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937234" h="918779">
                  <a:moveTo>
                    <a:pt x="0" y="0"/>
                  </a:moveTo>
                  <a:lnTo>
                    <a:pt x="5937234" y="0"/>
                  </a:lnTo>
                  <a:lnTo>
                    <a:pt x="5937234" y="918779"/>
                  </a:lnTo>
                  <a:lnTo>
                    <a:pt x="0" y="91877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8" name="Rectangle 19"/>
            <p:cNvSpPr/>
            <p:nvPr/>
          </p:nvSpPr>
          <p:spPr>
            <a:xfrm>
              <a:off x="533748" y="5287117"/>
              <a:ext cx="2844000" cy="46800"/>
            </a:xfrm>
            <a:custGeom>
              <a:avLst/>
              <a:gdLst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389655 h 918779"/>
                <a:gd name="connsiteX3" fmla="*/ 5937234 w 5937234"/>
                <a:gd name="connsiteY3" fmla="*/ 918779 h 918779"/>
                <a:gd name="connsiteX4" fmla="*/ 0 w 5937234"/>
                <a:gd name="connsiteY4" fmla="*/ 918779 h 918779"/>
                <a:gd name="connsiteX5" fmla="*/ 0 w 5937234"/>
                <a:gd name="connsiteY5" fmla="*/ 0 h 918779"/>
                <a:gd name="connsiteX0" fmla="*/ 0 w 6378699"/>
                <a:gd name="connsiteY0" fmla="*/ 0 h 918779"/>
                <a:gd name="connsiteX1" fmla="*/ 5937234 w 6378699"/>
                <a:gd name="connsiteY1" fmla="*/ 0 h 918779"/>
                <a:gd name="connsiteX2" fmla="*/ 5934287 w 6378699"/>
                <a:gd name="connsiteY2" fmla="*/ 389655 h 918779"/>
                <a:gd name="connsiteX3" fmla="*/ 5941907 w 6378699"/>
                <a:gd name="connsiteY3" fmla="*/ 385845 h 918779"/>
                <a:gd name="connsiteX4" fmla="*/ 5937234 w 6378699"/>
                <a:gd name="connsiteY4" fmla="*/ 918779 h 918779"/>
                <a:gd name="connsiteX5" fmla="*/ 0 w 6378699"/>
                <a:gd name="connsiteY5" fmla="*/ 918779 h 918779"/>
                <a:gd name="connsiteX6" fmla="*/ 0 w 6378699"/>
                <a:gd name="connsiteY6" fmla="*/ 0 h 918779"/>
                <a:gd name="connsiteX0" fmla="*/ 0 w 6377708"/>
                <a:gd name="connsiteY0" fmla="*/ 0 h 918779"/>
                <a:gd name="connsiteX1" fmla="*/ 5937234 w 6377708"/>
                <a:gd name="connsiteY1" fmla="*/ 0 h 918779"/>
                <a:gd name="connsiteX2" fmla="*/ 5934287 w 6377708"/>
                <a:gd name="connsiteY2" fmla="*/ 389655 h 918779"/>
                <a:gd name="connsiteX3" fmla="*/ 5938097 w 6377708"/>
                <a:gd name="connsiteY3" fmla="*/ 267735 h 918779"/>
                <a:gd name="connsiteX4" fmla="*/ 5937234 w 6377708"/>
                <a:gd name="connsiteY4" fmla="*/ 918779 h 918779"/>
                <a:gd name="connsiteX5" fmla="*/ 0 w 6377708"/>
                <a:gd name="connsiteY5" fmla="*/ 918779 h 918779"/>
                <a:gd name="connsiteX6" fmla="*/ 0 w 6377708"/>
                <a:gd name="connsiteY6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493056"/>
                <a:gd name="connsiteY0" fmla="*/ 0 h 918779"/>
                <a:gd name="connsiteX1" fmla="*/ 5937234 w 6493056"/>
                <a:gd name="connsiteY1" fmla="*/ 0 h 918779"/>
                <a:gd name="connsiteX2" fmla="*/ 5934287 w 6493056"/>
                <a:gd name="connsiteY2" fmla="*/ 389655 h 918779"/>
                <a:gd name="connsiteX3" fmla="*/ 5938097 w 6493056"/>
                <a:gd name="connsiteY3" fmla="*/ 267735 h 918779"/>
                <a:gd name="connsiteX4" fmla="*/ 6239087 w 6493056"/>
                <a:gd name="connsiteY4" fmla="*/ 515385 h 918779"/>
                <a:gd name="connsiteX5" fmla="*/ 5937234 w 6493056"/>
                <a:gd name="connsiteY5" fmla="*/ 918779 h 918779"/>
                <a:gd name="connsiteX6" fmla="*/ 0 w 6493056"/>
                <a:gd name="connsiteY6" fmla="*/ 918779 h 918779"/>
                <a:gd name="connsiteX7" fmla="*/ 0 w 6493056"/>
                <a:gd name="connsiteY7" fmla="*/ 0 h 918779"/>
                <a:gd name="connsiteX0" fmla="*/ 0 w 6374319"/>
                <a:gd name="connsiteY0" fmla="*/ 0 h 918779"/>
                <a:gd name="connsiteX1" fmla="*/ 5937234 w 6374319"/>
                <a:gd name="connsiteY1" fmla="*/ 0 h 918779"/>
                <a:gd name="connsiteX2" fmla="*/ 5934287 w 6374319"/>
                <a:gd name="connsiteY2" fmla="*/ 389655 h 918779"/>
                <a:gd name="connsiteX3" fmla="*/ 5938097 w 6374319"/>
                <a:gd name="connsiteY3" fmla="*/ 267735 h 918779"/>
                <a:gd name="connsiteX4" fmla="*/ 5835227 w 6374319"/>
                <a:gd name="connsiteY4" fmla="*/ 305835 h 918779"/>
                <a:gd name="connsiteX5" fmla="*/ 5937234 w 6374319"/>
                <a:gd name="connsiteY5" fmla="*/ 918779 h 918779"/>
                <a:gd name="connsiteX6" fmla="*/ 0 w 6374319"/>
                <a:gd name="connsiteY6" fmla="*/ 918779 h 918779"/>
                <a:gd name="connsiteX7" fmla="*/ 0 w 6374319"/>
                <a:gd name="connsiteY7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431882"/>
                <a:gd name="connsiteY0" fmla="*/ 0 h 918779"/>
                <a:gd name="connsiteX1" fmla="*/ 5937234 w 6431882"/>
                <a:gd name="connsiteY1" fmla="*/ 0 h 918779"/>
                <a:gd name="connsiteX2" fmla="*/ 5934287 w 6431882"/>
                <a:gd name="connsiteY2" fmla="*/ 389655 h 918779"/>
                <a:gd name="connsiteX3" fmla="*/ 5938097 w 6431882"/>
                <a:gd name="connsiteY3" fmla="*/ 267735 h 918779"/>
                <a:gd name="connsiteX4" fmla="*/ 5835227 w 6431882"/>
                <a:gd name="connsiteY4" fmla="*/ 305835 h 918779"/>
                <a:gd name="connsiteX5" fmla="*/ 6079068 w 6431882"/>
                <a:gd name="connsiteY5" fmla="*/ 484905 h 918779"/>
                <a:gd name="connsiteX6" fmla="*/ 5937234 w 6431882"/>
                <a:gd name="connsiteY6" fmla="*/ 918779 h 918779"/>
                <a:gd name="connsiteX7" fmla="*/ 0 w 6431882"/>
                <a:gd name="connsiteY7" fmla="*/ 918779 h 918779"/>
                <a:gd name="connsiteX8" fmla="*/ 0 w 6431882"/>
                <a:gd name="connsiteY8" fmla="*/ 0 h 918779"/>
                <a:gd name="connsiteX0" fmla="*/ 0 w 6079068"/>
                <a:gd name="connsiteY0" fmla="*/ 0 h 918779"/>
                <a:gd name="connsiteX1" fmla="*/ 5937234 w 6079068"/>
                <a:gd name="connsiteY1" fmla="*/ 0 h 918779"/>
                <a:gd name="connsiteX2" fmla="*/ 5934287 w 6079068"/>
                <a:gd name="connsiteY2" fmla="*/ 389655 h 918779"/>
                <a:gd name="connsiteX3" fmla="*/ 5938097 w 6079068"/>
                <a:gd name="connsiteY3" fmla="*/ 267735 h 918779"/>
                <a:gd name="connsiteX4" fmla="*/ 5835227 w 6079068"/>
                <a:gd name="connsiteY4" fmla="*/ 305835 h 918779"/>
                <a:gd name="connsiteX5" fmla="*/ 6079068 w 6079068"/>
                <a:gd name="connsiteY5" fmla="*/ 484905 h 918779"/>
                <a:gd name="connsiteX6" fmla="*/ 5937234 w 6079068"/>
                <a:gd name="connsiteY6" fmla="*/ 918779 h 918779"/>
                <a:gd name="connsiteX7" fmla="*/ 0 w 6079068"/>
                <a:gd name="connsiteY7" fmla="*/ 918779 h 918779"/>
                <a:gd name="connsiteX8" fmla="*/ 0 w 6079068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0108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38965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401"/>
                <a:gd name="connsiteY0" fmla="*/ 0 h 918779"/>
                <a:gd name="connsiteX1" fmla="*/ 5937234 w 5948401"/>
                <a:gd name="connsiteY1" fmla="*/ 0 h 918779"/>
                <a:gd name="connsiteX2" fmla="*/ 5934287 w 5948401"/>
                <a:gd name="connsiteY2" fmla="*/ 172485 h 918779"/>
                <a:gd name="connsiteX3" fmla="*/ 5938097 w 5948401"/>
                <a:gd name="connsiteY3" fmla="*/ 267735 h 918779"/>
                <a:gd name="connsiteX4" fmla="*/ 5835227 w 5948401"/>
                <a:gd name="connsiteY4" fmla="*/ 305835 h 918779"/>
                <a:gd name="connsiteX5" fmla="*/ 5934288 w 5948401"/>
                <a:gd name="connsiteY5" fmla="*/ 420135 h 918779"/>
                <a:gd name="connsiteX6" fmla="*/ 5937234 w 5948401"/>
                <a:gd name="connsiteY6" fmla="*/ 918779 h 918779"/>
                <a:gd name="connsiteX7" fmla="*/ 0 w 5948401"/>
                <a:gd name="connsiteY7" fmla="*/ 918779 h 918779"/>
                <a:gd name="connsiteX8" fmla="*/ 0 w 5948401"/>
                <a:gd name="connsiteY8" fmla="*/ 0 h 918779"/>
                <a:gd name="connsiteX0" fmla="*/ 0 w 5948197"/>
                <a:gd name="connsiteY0" fmla="*/ 0 h 918779"/>
                <a:gd name="connsiteX1" fmla="*/ 5937234 w 5948197"/>
                <a:gd name="connsiteY1" fmla="*/ 0 h 918779"/>
                <a:gd name="connsiteX2" fmla="*/ 5934287 w 5948197"/>
                <a:gd name="connsiteY2" fmla="*/ 172485 h 918779"/>
                <a:gd name="connsiteX3" fmla="*/ 5938097 w 5948197"/>
                <a:gd name="connsiteY3" fmla="*/ 267735 h 918779"/>
                <a:gd name="connsiteX4" fmla="*/ 5831417 w 5948197"/>
                <a:gd name="connsiteY4" fmla="*/ 355365 h 918779"/>
                <a:gd name="connsiteX5" fmla="*/ 5934288 w 5948197"/>
                <a:gd name="connsiteY5" fmla="*/ 420135 h 918779"/>
                <a:gd name="connsiteX6" fmla="*/ 5937234 w 5948197"/>
                <a:gd name="connsiteY6" fmla="*/ 918779 h 918779"/>
                <a:gd name="connsiteX7" fmla="*/ 0 w 5948197"/>
                <a:gd name="connsiteY7" fmla="*/ 918779 h 918779"/>
                <a:gd name="connsiteX8" fmla="*/ 0 w 5948197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17248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07618 w 5937234"/>
                <a:gd name="connsiteY6" fmla="*/ 374415 h 918779"/>
                <a:gd name="connsiteX7" fmla="*/ 5911428 w 5937234"/>
                <a:gd name="connsiteY7" fmla="*/ 366795 h 918779"/>
                <a:gd name="connsiteX8" fmla="*/ 5934288 w 5937234"/>
                <a:gd name="connsiteY8" fmla="*/ 420135 h 918779"/>
                <a:gd name="connsiteX9" fmla="*/ 5937234 w 5937234"/>
                <a:gd name="connsiteY9" fmla="*/ 918779 h 918779"/>
                <a:gd name="connsiteX10" fmla="*/ 0 w 5937234"/>
                <a:gd name="connsiteY10" fmla="*/ 918779 h 918779"/>
                <a:gd name="connsiteX11" fmla="*/ 0 w 5937234"/>
                <a:gd name="connsiteY11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43"/>
                <a:gd name="connsiteY0" fmla="*/ 0 h 918779"/>
                <a:gd name="connsiteX1" fmla="*/ 5937234 w 5937243"/>
                <a:gd name="connsiteY1" fmla="*/ 0 h 918779"/>
                <a:gd name="connsiteX2" fmla="*/ 5934287 w 5937243"/>
                <a:gd name="connsiteY2" fmla="*/ 256305 h 918779"/>
                <a:gd name="connsiteX3" fmla="*/ 5842847 w 5937243"/>
                <a:gd name="connsiteY3" fmla="*/ 275355 h 918779"/>
                <a:gd name="connsiteX4" fmla="*/ 5831417 w 5937243"/>
                <a:gd name="connsiteY4" fmla="*/ 355365 h 918779"/>
                <a:gd name="connsiteX5" fmla="*/ 5915238 w 5937243"/>
                <a:gd name="connsiteY5" fmla="*/ 374415 h 918779"/>
                <a:gd name="connsiteX6" fmla="*/ 5907618 w 5937243"/>
                <a:gd name="connsiteY6" fmla="*/ 374415 h 918779"/>
                <a:gd name="connsiteX7" fmla="*/ 5934288 w 5937243"/>
                <a:gd name="connsiteY7" fmla="*/ 420135 h 918779"/>
                <a:gd name="connsiteX8" fmla="*/ 5937234 w 5937243"/>
                <a:gd name="connsiteY8" fmla="*/ 918779 h 918779"/>
                <a:gd name="connsiteX9" fmla="*/ 0 w 5937243"/>
                <a:gd name="connsiteY9" fmla="*/ 918779 h 918779"/>
                <a:gd name="connsiteX10" fmla="*/ 0 w 5937243"/>
                <a:gd name="connsiteY10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9048 w 5937234"/>
                <a:gd name="connsiteY5" fmla="*/ 37441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4287 w 5937234"/>
                <a:gd name="connsiteY2" fmla="*/ 256305 h 918779"/>
                <a:gd name="connsiteX3" fmla="*/ 5842847 w 5937234"/>
                <a:gd name="connsiteY3" fmla="*/ 275355 h 918779"/>
                <a:gd name="connsiteX4" fmla="*/ 5831417 w 5937234"/>
                <a:gd name="connsiteY4" fmla="*/ 355365 h 918779"/>
                <a:gd name="connsiteX5" fmla="*/ 5915238 w 5937234"/>
                <a:gd name="connsiteY5" fmla="*/ 362985 h 918779"/>
                <a:gd name="connsiteX6" fmla="*/ 5934288 w 5937234"/>
                <a:gd name="connsiteY6" fmla="*/ 420135 h 918779"/>
                <a:gd name="connsiteX7" fmla="*/ 5937234 w 5937234"/>
                <a:gd name="connsiteY7" fmla="*/ 918779 h 918779"/>
                <a:gd name="connsiteX8" fmla="*/ 0 w 5937234"/>
                <a:gd name="connsiteY8" fmla="*/ 918779 h 918779"/>
                <a:gd name="connsiteX9" fmla="*/ 0 w 5937234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37939"/>
                <a:gd name="connsiteY0" fmla="*/ 0 h 918779"/>
                <a:gd name="connsiteX1" fmla="*/ 5937234 w 5937939"/>
                <a:gd name="connsiteY1" fmla="*/ 0 h 918779"/>
                <a:gd name="connsiteX2" fmla="*/ 5934287 w 5937939"/>
                <a:gd name="connsiteY2" fmla="*/ 256305 h 918779"/>
                <a:gd name="connsiteX3" fmla="*/ 5842847 w 5937939"/>
                <a:gd name="connsiteY3" fmla="*/ 275355 h 918779"/>
                <a:gd name="connsiteX4" fmla="*/ 5831417 w 5937939"/>
                <a:gd name="connsiteY4" fmla="*/ 355365 h 918779"/>
                <a:gd name="connsiteX5" fmla="*/ 5897207 w 5937939"/>
                <a:gd name="connsiteY5" fmla="*/ 366342 h 918779"/>
                <a:gd name="connsiteX6" fmla="*/ 5934288 w 5937939"/>
                <a:gd name="connsiteY6" fmla="*/ 420135 h 918779"/>
                <a:gd name="connsiteX7" fmla="*/ 5937234 w 5937939"/>
                <a:gd name="connsiteY7" fmla="*/ 918779 h 918779"/>
                <a:gd name="connsiteX8" fmla="*/ 0 w 5937939"/>
                <a:gd name="connsiteY8" fmla="*/ 918779 h 918779"/>
                <a:gd name="connsiteX9" fmla="*/ 0 w 5937939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847 w 5942716"/>
                <a:gd name="connsiteY3" fmla="*/ 275355 h 918779"/>
                <a:gd name="connsiteX4" fmla="*/ 5837428 w 5942716"/>
                <a:gd name="connsiteY4" fmla="*/ 305620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7428 w 5942716"/>
                <a:gd name="connsiteY5" fmla="*/ 305620 h 918779"/>
                <a:gd name="connsiteX6" fmla="*/ 5831417 w 5942716"/>
                <a:gd name="connsiteY6" fmla="*/ 355365 h 918779"/>
                <a:gd name="connsiteX7" fmla="*/ 5934288 w 5942716"/>
                <a:gd name="connsiteY7" fmla="*/ 420135 h 918779"/>
                <a:gd name="connsiteX8" fmla="*/ 5937234 w 5942716"/>
                <a:gd name="connsiteY8" fmla="*/ 918779 h 918779"/>
                <a:gd name="connsiteX9" fmla="*/ 0 w 5942716"/>
                <a:gd name="connsiteY9" fmla="*/ 918779 h 918779"/>
                <a:gd name="connsiteX10" fmla="*/ 0 w 5942716"/>
                <a:gd name="connsiteY10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42847 w 5942716"/>
                <a:gd name="connsiteY4" fmla="*/ 275355 h 918779"/>
                <a:gd name="connsiteX5" fmla="*/ 5831417 w 5942716"/>
                <a:gd name="connsiteY5" fmla="*/ 355365 h 918779"/>
                <a:gd name="connsiteX6" fmla="*/ 5934288 w 5942716"/>
                <a:gd name="connsiteY6" fmla="*/ 420135 h 918779"/>
                <a:gd name="connsiteX7" fmla="*/ 5937234 w 5942716"/>
                <a:gd name="connsiteY7" fmla="*/ 918779 h 918779"/>
                <a:gd name="connsiteX8" fmla="*/ 0 w 5942716"/>
                <a:gd name="connsiteY8" fmla="*/ 918779 h 918779"/>
                <a:gd name="connsiteX9" fmla="*/ 0 w 5942716"/>
                <a:gd name="connsiteY9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73489 w 5942716"/>
                <a:gd name="connsiteY3" fmla="*/ 251529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42580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34287 w 5942716"/>
                <a:gd name="connsiteY2" fmla="*/ 256305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32277 w 5942716"/>
                <a:gd name="connsiteY3" fmla="*/ 272135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42716"/>
                <a:gd name="connsiteY0" fmla="*/ 0 h 918779"/>
                <a:gd name="connsiteX1" fmla="*/ 5937234 w 5942716"/>
                <a:gd name="connsiteY1" fmla="*/ 0 h 918779"/>
                <a:gd name="connsiteX2" fmla="*/ 5929135 w 5942716"/>
                <a:gd name="connsiteY2" fmla="*/ 269184 h 918779"/>
                <a:gd name="connsiteX3" fmla="*/ 5886368 w 5942716"/>
                <a:gd name="connsiteY3" fmla="*/ 282438 h 918779"/>
                <a:gd name="connsiteX4" fmla="*/ 5831417 w 5942716"/>
                <a:gd name="connsiteY4" fmla="*/ 355365 h 918779"/>
                <a:gd name="connsiteX5" fmla="*/ 5934288 w 5942716"/>
                <a:gd name="connsiteY5" fmla="*/ 420135 h 918779"/>
                <a:gd name="connsiteX6" fmla="*/ 5937234 w 5942716"/>
                <a:gd name="connsiteY6" fmla="*/ 918779 h 918779"/>
                <a:gd name="connsiteX7" fmla="*/ 0 w 5942716"/>
                <a:gd name="connsiteY7" fmla="*/ 918779 h 918779"/>
                <a:gd name="connsiteX8" fmla="*/ 0 w 5942716"/>
                <a:gd name="connsiteY8" fmla="*/ 0 h 918779"/>
                <a:gd name="connsiteX0" fmla="*/ 0 w 5938951"/>
                <a:gd name="connsiteY0" fmla="*/ 0 h 918779"/>
                <a:gd name="connsiteX1" fmla="*/ 5937234 w 5938951"/>
                <a:gd name="connsiteY1" fmla="*/ 0 h 918779"/>
                <a:gd name="connsiteX2" fmla="*/ 5929135 w 5938951"/>
                <a:gd name="connsiteY2" fmla="*/ 269184 h 918779"/>
                <a:gd name="connsiteX3" fmla="*/ 5886368 w 5938951"/>
                <a:gd name="connsiteY3" fmla="*/ 282438 h 918779"/>
                <a:gd name="connsiteX4" fmla="*/ 5882932 w 5938951"/>
                <a:gd name="connsiteY4" fmla="*/ 365668 h 918779"/>
                <a:gd name="connsiteX5" fmla="*/ 5934288 w 5938951"/>
                <a:gd name="connsiteY5" fmla="*/ 420135 h 918779"/>
                <a:gd name="connsiteX6" fmla="*/ 5937234 w 5938951"/>
                <a:gd name="connsiteY6" fmla="*/ 918779 h 918779"/>
                <a:gd name="connsiteX7" fmla="*/ 0 w 5938951"/>
                <a:gd name="connsiteY7" fmla="*/ 918779 h 918779"/>
                <a:gd name="connsiteX8" fmla="*/ 0 w 5938951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924"/>
                <a:gd name="connsiteY0" fmla="*/ 0 h 918779"/>
                <a:gd name="connsiteX1" fmla="*/ 5937234 w 5952924"/>
                <a:gd name="connsiteY1" fmla="*/ 0 h 918779"/>
                <a:gd name="connsiteX2" fmla="*/ 5929135 w 5952924"/>
                <a:gd name="connsiteY2" fmla="*/ 269184 h 918779"/>
                <a:gd name="connsiteX3" fmla="*/ 5886368 w 5952924"/>
                <a:gd name="connsiteY3" fmla="*/ 282438 h 918779"/>
                <a:gd name="connsiteX4" fmla="*/ 5882932 w 5952924"/>
                <a:gd name="connsiteY4" fmla="*/ 365668 h 918779"/>
                <a:gd name="connsiteX5" fmla="*/ 5943035 w 5952924"/>
                <a:gd name="connsiteY5" fmla="*/ 362287 h 918779"/>
                <a:gd name="connsiteX6" fmla="*/ 5952318 w 5952924"/>
                <a:gd name="connsiteY6" fmla="*/ 402104 h 918779"/>
                <a:gd name="connsiteX7" fmla="*/ 5937234 w 5952924"/>
                <a:gd name="connsiteY7" fmla="*/ 918779 h 918779"/>
                <a:gd name="connsiteX8" fmla="*/ 0 w 5952924"/>
                <a:gd name="connsiteY8" fmla="*/ 918779 h 918779"/>
                <a:gd name="connsiteX9" fmla="*/ 0 w 5952924"/>
                <a:gd name="connsiteY9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29135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4288"/>
                <a:gd name="connsiteY0" fmla="*/ 0 h 918779"/>
                <a:gd name="connsiteX1" fmla="*/ 5937234 w 5954288"/>
                <a:gd name="connsiteY1" fmla="*/ 0 h 918779"/>
                <a:gd name="connsiteX2" fmla="*/ 5934287 w 5954288"/>
                <a:gd name="connsiteY2" fmla="*/ 269184 h 918779"/>
                <a:gd name="connsiteX3" fmla="*/ 5886368 w 5954288"/>
                <a:gd name="connsiteY3" fmla="*/ 282438 h 918779"/>
                <a:gd name="connsiteX4" fmla="*/ 5882932 w 5954288"/>
                <a:gd name="connsiteY4" fmla="*/ 365668 h 918779"/>
                <a:gd name="connsiteX5" fmla="*/ 5952318 w 5954288"/>
                <a:gd name="connsiteY5" fmla="*/ 402104 h 918779"/>
                <a:gd name="connsiteX6" fmla="*/ 5937234 w 5954288"/>
                <a:gd name="connsiteY6" fmla="*/ 918779 h 918779"/>
                <a:gd name="connsiteX7" fmla="*/ 0 w 5954288"/>
                <a:gd name="connsiteY7" fmla="*/ 918779 h 918779"/>
                <a:gd name="connsiteX8" fmla="*/ 0 w 5954288"/>
                <a:gd name="connsiteY8" fmla="*/ 0 h 918779"/>
                <a:gd name="connsiteX0" fmla="*/ 0 w 5952762"/>
                <a:gd name="connsiteY0" fmla="*/ 0 h 918779"/>
                <a:gd name="connsiteX1" fmla="*/ 5937234 w 5952762"/>
                <a:gd name="connsiteY1" fmla="*/ 0 h 918779"/>
                <a:gd name="connsiteX2" fmla="*/ 5934287 w 5952762"/>
                <a:gd name="connsiteY2" fmla="*/ 269184 h 918779"/>
                <a:gd name="connsiteX3" fmla="*/ 5886368 w 5952762"/>
                <a:gd name="connsiteY3" fmla="*/ 282438 h 918779"/>
                <a:gd name="connsiteX4" fmla="*/ 5882932 w 5952762"/>
                <a:gd name="connsiteY4" fmla="*/ 365668 h 918779"/>
                <a:gd name="connsiteX5" fmla="*/ 5952318 w 5952762"/>
                <a:gd name="connsiteY5" fmla="*/ 402104 h 918779"/>
                <a:gd name="connsiteX6" fmla="*/ 5937234 w 5952762"/>
                <a:gd name="connsiteY6" fmla="*/ 918779 h 918779"/>
                <a:gd name="connsiteX7" fmla="*/ 0 w 5952762"/>
                <a:gd name="connsiteY7" fmla="*/ 918779 h 918779"/>
                <a:gd name="connsiteX8" fmla="*/ 0 w 5952762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30157 w 5952389"/>
                <a:gd name="connsiteY5" fmla="*/ 357136 h 918779"/>
                <a:gd name="connsiteX6" fmla="*/ 5952318 w 5952389"/>
                <a:gd name="connsiteY6" fmla="*/ 402104 h 918779"/>
                <a:gd name="connsiteX7" fmla="*/ 5937234 w 5952389"/>
                <a:gd name="connsiteY7" fmla="*/ 918779 h 918779"/>
                <a:gd name="connsiteX8" fmla="*/ 0 w 5952389"/>
                <a:gd name="connsiteY8" fmla="*/ 918779 h 918779"/>
                <a:gd name="connsiteX9" fmla="*/ 0 w 5952389"/>
                <a:gd name="connsiteY9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86368 w 5952389"/>
                <a:gd name="connsiteY3" fmla="*/ 282438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389"/>
                <a:gd name="connsiteY0" fmla="*/ 0 h 918779"/>
                <a:gd name="connsiteX1" fmla="*/ 5937234 w 5952389"/>
                <a:gd name="connsiteY1" fmla="*/ 0 h 918779"/>
                <a:gd name="connsiteX2" fmla="*/ 5934287 w 5952389"/>
                <a:gd name="connsiteY2" fmla="*/ 269184 h 918779"/>
                <a:gd name="connsiteX3" fmla="*/ 5878641 w 5952389"/>
                <a:gd name="connsiteY3" fmla="*/ 290165 h 918779"/>
                <a:gd name="connsiteX4" fmla="*/ 5882932 w 5952389"/>
                <a:gd name="connsiteY4" fmla="*/ 365668 h 918779"/>
                <a:gd name="connsiteX5" fmla="*/ 5952318 w 5952389"/>
                <a:gd name="connsiteY5" fmla="*/ 402104 h 918779"/>
                <a:gd name="connsiteX6" fmla="*/ 5937234 w 5952389"/>
                <a:gd name="connsiteY6" fmla="*/ 918779 h 918779"/>
                <a:gd name="connsiteX7" fmla="*/ 0 w 5952389"/>
                <a:gd name="connsiteY7" fmla="*/ 918779 h 918779"/>
                <a:gd name="connsiteX8" fmla="*/ 0 w 5952389"/>
                <a:gd name="connsiteY8" fmla="*/ 0 h 918779"/>
                <a:gd name="connsiteX0" fmla="*/ 0 w 5952400"/>
                <a:gd name="connsiteY0" fmla="*/ 0 h 918779"/>
                <a:gd name="connsiteX1" fmla="*/ 5937234 w 5952400"/>
                <a:gd name="connsiteY1" fmla="*/ 0 h 918779"/>
                <a:gd name="connsiteX2" fmla="*/ 5934287 w 5952400"/>
                <a:gd name="connsiteY2" fmla="*/ 269184 h 918779"/>
                <a:gd name="connsiteX3" fmla="*/ 5878641 w 5952400"/>
                <a:gd name="connsiteY3" fmla="*/ 290165 h 918779"/>
                <a:gd name="connsiteX4" fmla="*/ 5882932 w 5952400"/>
                <a:gd name="connsiteY4" fmla="*/ 365668 h 918779"/>
                <a:gd name="connsiteX5" fmla="*/ 5952318 w 5952400"/>
                <a:gd name="connsiteY5" fmla="*/ 402104 h 918779"/>
                <a:gd name="connsiteX6" fmla="*/ 5937234 w 5952400"/>
                <a:gd name="connsiteY6" fmla="*/ 918779 h 918779"/>
                <a:gd name="connsiteX7" fmla="*/ 0 w 5952400"/>
                <a:gd name="connsiteY7" fmla="*/ 918779 h 918779"/>
                <a:gd name="connsiteX8" fmla="*/ 0 w 5952400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5952318"/>
                <a:gd name="connsiteY0" fmla="*/ 0 h 918779"/>
                <a:gd name="connsiteX1" fmla="*/ 5937234 w 5952318"/>
                <a:gd name="connsiteY1" fmla="*/ 0 h 918779"/>
                <a:gd name="connsiteX2" fmla="*/ 5934287 w 5952318"/>
                <a:gd name="connsiteY2" fmla="*/ 269184 h 918779"/>
                <a:gd name="connsiteX3" fmla="*/ 5878641 w 5952318"/>
                <a:gd name="connsiteY3" fmla="*/ 290165 h 918779"/>
                <a:gd name="connsiteX4" fmla="*/ 5882932 w 5952318"/>
                <a:gd name="connsiteY4" fmla="*/ 365668 h 918779"/>
                <a:gd name="connsiteX5" fmla="*/ 5952318 w 5952318"/>
                <a:gd name="connsiteY5" fmla="*/ 402104 h 918779"/>
                <a:gd name="connsiteX6" fmla="*/ 5937234 w 5952318"/>
                <a:gd name="connsiteY6" fmla="*/ 918779 h 918779"/>
                <a:gd name="connsiteX7" fmla="*/ 0 w 5952318"/>
                <a:gd name="connsiteY7" fmla="*/ 918779 h 918779"/>
                <a:gd name="connsiteX8" fmla="*/ 0 w 5952318"/>
                <a:gd name="connsiteY8" fmla="*/ 0 h 918779"/>
                <a:gd name="connsiteX0" fmla="*/ 0 w 6359902"/>
                <a:gd name="connsiteY0" fmla="*/ 0 h 918779"/>
                <a:gd name="connsiteX1" fmla="*/ 5937234 w 6359902"/>
                <a:gd name="connsiteY1" fmla="*/ 0 h 918779"/>
                <a:gd name="connsiteX2" fmla="*/ 5878641 w 6359902"/>
                <a:gd name="connsiteY2" fmla="*/ 290165 h 918779"/>
                <a:gd name="connsiteX3" fmla="*/ 5882932 w 6359902"/>
                <a:gd name="connsiteY3" fmla="*/ 365668 h 918779"/>
                <a:gd name="connsiteX4" fmla="*/ 5952318 w 6359902"/>
                <a:gd name="connsiteY4" fmla="*/ 402104 h 918779"/>
                <a:gd name="connsiteX5" fmla="*/ 5937234 w 6359902"/>
                <a:gd name="connsiteY5" fmla="*/ 918779 h 918779"/>
                <a:gd name="connsiteX6" fmla="*/ 0 w 6359902"/>
                <a:gd name="connsiteY6" fmla="*/ 918779 h 918779"/>
                <a:gd name="connsiteX7" fmla="*/ 0 w 6359902"/>
                <a:gd name="connsiteY7" fmla="*/ 0 h 918779"/>
                <a:gd name="connsiteX0" fmla="*/ 0 w 6358832"/>
                <a:gd name="connsiteY0" fmla="*/ 0 h 918779"/>
                <a:gd name="connsiteX1" fmla="*/ 5937234 w 6358832"/>
                <a:gd name="connsiteY1" fmla="*/ 0 h 918779"/>
                <a:gd name="connsiteX2" fmla="*/ 5882932 w 6358832"/>
                <a:gd name="connsiteY2" fmla="*/ 365668 h 918779"/>
                <a:gd name="connsiteX3" fmla="*/ 5952318 w 6358832"/>
                <a:gd name="connsiteY3" fmla="*/ 402104 h 918779"/>
                <a:gd name="connsiteX4" fmla="*/ 5937234 w 6358832"/>
                <a:gd name="connsiteY4" fmla="*/ 918779 h 918779"/>
                <a:gd name="connsiteX5" fmla="*/ 0 w 6358832"/>
                <a:gd name="connsiteY5" fmla="*/ 918779 h 918779"/>
                <a:gd name="connsiteX6" fmla="*/ 0 w 6358832"/>
                <a:gd name="connsiteY6" fmla="*/ 0 h 918779"/>
                <a:gd name="connsiteX0" fmla="*/ 0 w 6359360"/>
                <a:gd name="connsiteY0" fmla="*/ 0 h 918779"/>
                <a:gd name="connsiteX1" fmla="*/ 5937234 w 6359360"/>
                <a:gd name="connsiteY1" fmla="*/ 0 h 918779"/>
                <a:gd name="connsiteX2" fmla="*/ 5882932 w 6359360"/>
                <a:gd name="connsiteY2" fmla="*/ 365668 h 918779"/>
                <a:gd name="connsiteX3" fmla="*/ 5937234 w 6359360"/>
                <a:gd name="connsiteY3" fmla="*/ 918779 h 918779"/>
                <a:gd name="connsiteX4" fmla="*/ 0 w 6359360"/>
                <a:gd name="connsiteY4" fmla="*/ 918779 h 918779"/>
                <a:gd name="connsiteX5" fmla="*/ 0 w 6359360"/>
                <a:gd name="connsiteY5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79388"/>
                <a:gd name="connsiteY0" fmla="*/ 0 h 918779"/>
                <a:gd name="connsiteX1" fmla="*/ 5937234 w 6679388"/>
                <a:gd name="connsiteY1" fmla="*/ 0 h 918779"/>
                <a:gd name="connsiteX2" fmla="*/ 5937234 w 6679388"/>
                <a:gd name="connsiteY2" fmla="*/ 918779 h 918779"/>
                <a:gd name="connsiteX3" fmla="*/ 0 w 6679388"/>
                <a:gd name="connsiteY3" fmla="*/ 918779 h 918779"/>
                <a:gd name="connsiteX4" fmla="*/ 0 w 6679388"/>
                <a:gd name="connsiteY4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19506"/>
                <a:gd name="connsiteY0" fmla="*/ 0 h 918779"/>
                <a:gd name="connsiteX1" fmla="*/ 5937234 w 6619506"/>
                <a:gd name="connsiteY1" fmla="*/ 0 h 918779"/>
                <a:gd name="connsiteX2" fmla="*/ 6490377 w 6619506"/>
                <a:gd name="connsiteY2" fmla="*/ 740744 h 918779"/>
                <a:gd name="connsiteX3" fmla="*/ 5937234 w 6619506"/>
                <a:gd name="connsiteY3" fmla="*/ 918779 h 918779"/>
                <a:gd name="connsiteX4" fmla="*/ 0 w 6619506"/>
                <a:gd name="connsiteY4" fmla="*/ 918779 h 918779"/>
                <a:gd name="connsiteX5" fmla="*/ 0 w 6619506"/>
                <a:gd name="connsiteY5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658555"/>
                <a:gd name="connsiteY0" fmla="*/ 0 h 918779"/>
                <a:gd name="connsiteX1" fmla="*/ 5937234 w 6658555"/>
                <a:gd name="connsiteY1" fmla="*/ 0 h 918779"/>
                <a:gd name="connsiteX2" fmla="*/ 6490377 w 6658555"/>
                <a:gd name="connsiteY2" fmla="*/ 740744 h 918779"/>
                <a:gd name="connsiteX3" fmla="*/ 6616619 w 6658555"/>
                <a:gd name="connsiteY3" fmla="*/ 884045 h 918779"/>
                <a:gd name="connsiteX4" fmla="*/ 5937234 w 6658555"/>
                <a:gd name="connsiteY4" fmla="*/ 918779 h 918779"/>
                <a:gd name="connsiteX5" fmla="*/ 0 w 6658555"/>
                <a:gd name="connsiteY5" fmla="*/ 918779 h 918779"/>
                <a:gd name="connsiteX6" fmla="*/ 0 w 6658555"/>
                <a:gd name="connsiteY6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6490377"/>
                <a:gd name="connsiteY0" fmla="*/ 0 h 918779"/>
                <a:gd name="connsiteX1" fmla="*/ 5937234 w 6490377"/>
                <a:gd name="connsiteY1" fmla="*/ 0 h 918779"/>
                <a:gd name="connsiteX2" fmla="*/ 6490377 w 6490377"/>
                <a:gd name="connsiteY2" fmla="*/ 740744 h 918779"/>
                <a:gd name="connsiteX3" fmla="*/ 5937234 w 6490377"/>
                <a:gd name="connsiteY3" fmla="*/ 918779 h 918779"/>
                <a:gd name="connsiteX4" fmla="*/ 0 w 6490377"/>
                <a:gd name="connsiteY4" fmla="*/ 918779 h 918779"/>
                <a:gd name="connsiteX5" fmla="*/ 0 w 6490377"/>
                <a:gd name="connsiteY5" fmla="*/ 0 h 918779"/>
                <a:gd name="connsiteX0" fmla="*/ 0 w 5937234"/>
                <a:gd name="connsiteY0" fmla="*/ 0 h 918779"/>
                <a:gd name="connsiteX1" fmla="*/ 5937234 w 5937234"/>
                <a:gd name="connsiteY1" fmla="*/ 0 h 918779"/>
                <a:gd name="connsiteX2" fmla="*/ 5937234 w 5937234"/>
                <a:gd name="connsiteY2" fmla="*/ 918779 h 918779"/>
                <a:gd name="connsiteX3" fmla="*/ 0 w 5937234"/>
                <a:gd name="connsiteY3" fmla="*/ 918779 h 918779"/>
                <a:gd name="connsiteX4" fmla="*/ 0 w 5937234"/>
                <a:gd name="connsiteY4" fmla="*/ 0 h 918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937234" h="918779">
                  <a:moveTo>
                    <a:pt x="0" y="0"/>
                  </a:moveTo>
                  <a:lnTo>
                    <a:pt x="5937234" y="0"/>
                  </a:lnTo>
                  <a:lnTo>
                    <a:pt x="5937234" y="918779"/>
                  </a:lnTo>
                  <a:lnTo>
                    <a:pt x="0" y="91877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1996289" y="4962413"/>
              <a:ext cx="792000" cy="381277"/>
            </a:xfrm>
            <a:prstGeom prst="rect">
              <a:avLst/>
            </a:prstGeom>
            <a:solidFill>
              <a:schemeClr val="bg1">
                <a:lumMod val="50000"/>
                <a:alpha val="28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30" name="Rectangle 29"/>
          <p:cNvSpPr/>
          <p:nvPr/>
        </p:nvSpPr>
        <p:spPr>
          <a:xfrm>
            <a:off x="3124052" y="816398"/>
            <a:ext cx="38552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9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4207979" y="789507"/>
            <a:ext cx="3657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82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2955341" y="818026"/>
            <a:ext cx="35658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5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</a:t>
            </a:r>
            <a:endParaRPr lang="en-IN" sz="800" dirty="0"/>
          </a:p>
        </p:txBody>
      </p:sp>
      <p:sp>
        <p:nvSpPr>
          <p:cNvPr id="33" name="TextBox 32"/>
          <p:cNvSpPr txBox="1"/>
          <p:nvPr/>
        </p:nvSpPr>
        <p:spPr>
          <a:xfrm>
            <a:off x="1950520" y="1673583"/>
            <a:ext cx="535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C155</a:t>
            </a:r>
          </a:p>
          <a:p>
            <a:pPr algn="ctr"/>
            <a:endParaRPr lang="en-US" sz="800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4533018" y="1798765"/>
            <a:ext cx="46990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216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IN" sz="800" dirty="0"/>
          </a:p>
        </p:txBody>
      </p:sp>
      <p:sp>
        <p:nvSpPr>
          <p:cNvPr id="35" name="TextBox 34"/>
          <p:cNvSpPr txBox="1"/>
          <p:nvPr/>
        </p:nvSpPr>
        <p:spPr>
          <a:xfrm>
            <a:off x="2150222" y="1793479"/>
            <a:ext cx="5350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  C160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* 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764347" y="1798765"/>
            <a:ext cx="5350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150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564686" y="3767354"/>
            <a:ext cx="1323912" cy="453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putative hinge region</a:t>
            </a:r>
          </a:p>
          <a:p>
            <a:pPr algn="ctr"/>
            <a:r>
              <a:rPr lang="en-US" sz="750" dirty="0" smtClean="0">
                <a:latin typeface="Times New Roman" pitchFamily="18" charset="0"/>
                <a:cs typeface="Times New Roman" pitchFamily="18" charset="0"/>
              </a:rPr>
              <a:t>*****</a:t>
            </a:r>
          </a:p>
          <a:p>
            <a:pPr algn="ctr"/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620584" y="3639723"/>
            <a:ext cx="139454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E binding factor like motif</a:t>
            </a:r>
          </a:p>
          <a:p>
            <a:pPr algn="ctr"/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*******</a:t>
            </a:r>
          </a:p>
          <a:p>
            <a:pPr algn="ctr"/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61888" y="3756905"/>
            <a:ext cx="4256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T373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120729" y="4693569"/>
            <a:ext cx="4936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521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1461740" y="4695841"/>
            <a:ext cx="4616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529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 </a:t>
            </a:r>
            <a:endParaRPr lang="en-IN" sz="800" dirty="0"/>
          </a:p>
        </p:txBody>
      </p:sp>
      <p:sp>
        <p:nvSpPr>
          <p:cNvPr id="48" name="TextBox 47"/>
          <p:cNvSpPr txBox="1"/>
          <p:nvPr/>
        </p:nvSpPr>
        <p:spPr>
          <a:xfrm>
            <a:off x="1866132" y="4712746"/>
            <a:ext cx="126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   </a:t>
            </a:r>
            <a:r>
              <a:rPr lang="en-US" sz="800" dirty="0" smtClean="0"/>
              <a:t>** *               **</a:t>
            </a:r>
            <a:endParaRPr lang="en-US" sz="800" dirty="0"/>
          </a:p>
        </p:txBody>
      </p:sp>
      <p:sp>
        <p:nvSpPr>
          <p:cNvPr id="43" name="TextBox 42"/>
          <p:cNvSpPr txBox="1"/>
          <p:nvPr/>
        </p:nvSpPr>
        <p:spPr>
          <a:xfrm>
            <a:off x="739608" y="818969"/>
            <a:ext cx="151410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700" dirty="0" err="1" smtClean="0">
                <a:latin typeface="Times New Roman" pitchFamily="18" charset="0"/>
                <a:cs typeface="Times New Roman" pitchFamily="18" charset="0"/>
              </a:rPr>
              <a:t>IkB-phosphodegron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motif</a:t>
            </a:r>
          </a:p>
          <a:p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          DS***S</a:t>
            </a:r>
          </a:p>
          <a:p>
            <a:endParaRPr lang="en-US" sz="7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1085850" y="1057344"/>
            <a:ext cx="252000" cy="162000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45" name="Straight Connector 44"/>
          <p:cNvCxnSpPr/>
          <p:nvPr/>
        </p:nvCxnSpPr>
        <p:spPr>
          <a:xfrm>
            <a:off x="2237748" y="1858485"/>
            <a:ext cx="0" cy="1005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V="1">
            <a:off x="6009190" y="3960422"/>
            <a:ext cx="381600" cy="1379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538623" y="4915789"/>
            <a:ext cx="338400" cy="599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5889009" y="3765631"/>
            <a:ext cx="648269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solidFill>
                  <a:schemeClr val="accent6">
                    <a:lumMod val="75000"/>
                  </a:schemeClr>
                </a:solidFill>
              </a:rPr>
              <a:t>NIMIN1/2</a:t>
            </a:r>
          </a:p>
          <a:p>
            <a:endParaRPr lang="en-US" sz="800" dirty="0"/>
          </a:p>
        </p:txBody>
      </p:sp>
      <p:sp>
        <p:nvSpPr>
          <p:cNvPr id="52" name="Rectangle 51"/>
          <p:cNvSpPr/>
          <p:nvPr/>
        </p:nvSpPr>
        <p:spPr>
          <a:xfrm>
            <a:off x="111025" y="6788418"/>
            <a:ext cx="574458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IN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 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iple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lignment of 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I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boreum</a:t>
            </a:r>
            <a:r>
              <a:rPr lang="en-I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Arabidopsis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Rs 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 r="3846" b="87540"/>
          <a:stretch>
            <a:fillRect/>
          </a:stretch>
        </p:blipFill>
        <p:spPr bwMode="auto">
          <a:xfrm>
            <a:off x="99000" y="689610"/>
            <a:ext cx="6660000" cy="743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/>
          <a:srcRect t="26196" r="4062" b="60508"/>
          <a:stretch>
            <a:fillRect/>
          </a:stretch>
        </p:blipFill>
        <p:spPr bwMode="auto">
          <a:xfrm>
            <a:off x="99000" y="2931347"/>
            <a:ext cx="6660000" cy="7794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/>
          <a:srcRect t="39231" r="3738" b="46765"/>
          <a:stretch>
            <a:fillRect/>
          </a:stretch>
        </p:blipFill>
        <p:spPr bwMode="auto">
          <a:xfrm>
            <a:off x="99000" y="3998868"/>
            <a:ext cx="6660000" cy="8181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/>
          <a:srcRect t="52974" r="4062" b="33256"/>
          <a:stretch>
            <a:fillRect/>
          </a:stretch>
        </p:blipFill>
        <p:spPr bwMode="auto">
          <a:xfrm>
            <a:off x="111412" y="5115138"/>
            <a:ext cx="6660000" cy="8072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/>
          <a:srcRect t="13175" r="3846" b="73784"/>
          <a:stretch>
            <a:fillRect/>
          </a:stretch>
        </p:blipFill>
        <p:spPr bwMode="auto">
          <a:xfrm>
            <a:off x="99000" y="1853803"/>
            <a:ext cx="6660000" cy="7627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Rectangle 7"/>
          <p:cNvSpPr/>
          <p:nvPr/>
        </p:nvSpPr>
        <p:spPr>
          <a:xfrm>
            <a:off x="2765442" y="695158"/>
            <a:ext cx="3816000" cy="396000"/>
          </a:xfrm>
          <a:prstGeom prst="rect">
            <a:avLst/>
          </a:prstGeom>
          <a:solidFill>
            <a:srgbClr val="FFFF00">
              <a:alpha val="15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lt1">
                  <a:alpha val="20000"/>
                </a:schemeClr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765250" y="1162678"/>
            <a:ext cx="3816000" cy="282005"/>
          </a:xfrm>
          <a:prstGeom prst="rect">
            <a:avLst/>
          </a:prstGeom>
          <a:solidFill>
            <a:srgbClr val="FFFF00">
              <a:alpha val="15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lt1">
                  <a:alpha val="20000"/>
                </a:schemeClr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3071136" y="1080142"/>
            <a:ext cx="3492000" cy="72000"/>
          </a:xfrm>
          <a:prstGeom prst="rect">
            <a:avLst/>
          </a:prstGeom>
          <a:solidFill>
            <a:srgbClr val="FFFF00">
              <a:alpha val="15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lt1">
                  <a:alpha val="20000"/>
                </a:schemeClr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357846" y="1850801"/>
            <a:ext cx="3600000" cy="756000"/>
          </a:xfrm>
          <a:prstGeom prst="rect">
            <a:avLst/>
          </a:prstGeom>
          <a:solidFill>
            <a:srgbClr val="FFFF00">
              <a:alpha val="15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lt1">
                  <a:alpha val="20000"/>
                </a:schemeClr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5567548" y="1871493"/>
            <a:ext cx="1044000" cy="718283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" name="Rectangle 13"/>
          <p:cNvSpPr/>
          <p:nvPr/>
        </p:nvSpPr>
        <p:spPr>
          <a:xfrm>
            <a:off x="362423" y="2962841"/>
            <a:ext cx="1914371" cy="289723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" name="Rectangle 14"/>
          <p:cNvSpPr/>
          <p:nvPr/>
        </p:nvSpPr>
        <p:spPr>
          <a:xfrm>
            <a:off x="361400" y="3252563"/>
            <a:ext cx="1872000" cy="70575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6" name="Rectangle 15"/>
          <p:cNvSpPr/>
          <p:nvPr/>
        </p:nvSpPr>
        <p:spPr>
          <a:xfrm>
            <a:off x="361401" y="3323895"/>
            <a:ext cx="1914371" cy="378000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" name="Rectangle 16"/>
          <p:cNvSpPr/>
          <p:nvPr/>
        </p:nvSpPr>
        <p:spPr>
          <a:xfrm>
            <a:off x="2234278" y="2964556"/>
            <a:ext cx="3744000" cy="64051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" name="Rectangle 17"/>
          <p:cNvSpPr/>
          <p:nvPr/>
        </p:nvSpPr>
        <p:spPr>
          <a:xfrm>
            <a:off x="2320477" y="3028529"/>
            <a:ext cx="3744000" cy="540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9" name="Rectangle 18"/>
          <p:cNvSpPr/>
          <p:nvPr/>
        </p:nvSpPr>
        <p:spPr>
          <a:xfrm>
            <a:off x="2192212" y="3082317"/>
            <a:ext cx="3870000" cy="576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0" name="Rectangle 19"/>
          <p:cNvSpPr/>
          <p:nvPr/>
        </p:nvSpPr>
        <p:spPr>
          <a:xfrm>
            <a:off x="2315649" y="3137342"/>
            <a:ext cx="3744000" cy="106805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1" name="Rectangle 20"/>
          <p:cNvSpPr/>
          <p:nvPr/>
        </p:nvSpPr>
        <p:spPr>
          <a:xfrm>
            <a:off x="3263935" y="3307388"/>
            <a:ext cx="2844000" cy="64051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2" name="Rectangle 21"/>
          <p:cNvSpPr/>
          <p:nvPr/>
        </p:nvSpPr>
        <p:spPr>
          <a:xfrm>
            <a:off x="2179205" y="3372899"/>
            <a:ext cx="3780000" cy="648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3" name="Rectangle 22"/>
          <p:cNvSpPr/>
          <p:nvPr/>
        </p:nvSpPr>
        <p:spPr>
          <a:xfrm>
            <a:off x="2542533" y="3438406"/>
            <a:ext cx="3654000" cy="2520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4" name="Rectangle 23"/>
          <p:cNvSpPr/>
          <p:nvPr/>
        </p:nvSpPr>
        <p:spPr>
          <a:xfrm>
            <a:off x="2315626" y="3243463"/>
            <a:ext cx="3672000" cy="648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5" name="Rectangle 19"/>
          <p:cNvSpPr/>
          <p:nvPr/>
        </p:nvSpPr>
        <p:spPr>
          <a:xfrm>
            <a:off x="451260" y="4064471"/>
            <a:ext cx="6120000" cy="450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6" name="Rectangle 19"/>
          <p:cNvSpPr/>
          <p:nvPr/>
        </p:nvSpPr>
        <p:spPr>
          <a:xfrm>
            <a:off x="363683" y="5164894"/>
            <a:ext cx="2988000" cy="576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7" name="Rectangle 19"/>
          <p:cNvSpPr/>
          <p:nvPr/>
        </p:nvSpPr>
        <p:spPr>
          <a:xfrm>
            <a:off x="363667" y="5223572"/>
            <a:ext cx="3690000" cy="54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8" name="Rectangle 19"/>
          <p:cNvSpPr/>
          <p:nvPr/>
        </p:nvSpPr>
        <p:spPr>
          <a:xfrm>
            <a:off x="363682" y="5273908"/>
            <a:ext cx="3024000" cy="576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9" name="Rectangle 19"/>
          <p:cNvSpPr/>
          <p:nvPr/>
        </p:nvSpPr>
        <p:spPr>
          <a:xfrm>
            <a:off x="363681" y="5332597"/>
            <a:ext cx="2898000" cy="576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0" name="Rectangle 19"/>
          <p:cNvSpPr/>
          <p:nvPr/>
        </p:nvSpPr>
        <p:spPr>
          <a:xfrm>
            <a:off x="363681" y="5388209"/>
            <a:ext cx="2646000" cy="54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1" name="Rectangle 19"/>
          <p:cNvSpPr/>
          <p:nvPr/>
        </p:nvSpPr>
        <p:spPr>
          <a:xfrm>
            <a:off x="363681" y="5445359"/>
            <a:ext cx="3222000" cy="54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2" name="Rectangle 19"/>
          <p:cNvSpPr/>
          <p:nvPr/>
        </p:nvSpPr>
        <p:spPr>
          <a:xfrm>
            <a:off x="363665" y="5497213"/>
            <a:ext cx="2718000" cy="576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3" name="Rectangle 19"/>
          <p:cNvSpPr/>
          <p:nvPr/>
        </p:nvSpPr>
        <p:spPr>
          <a:xfrm>
            <a:off x="363649" y="5554876"/>
            <a:ext cx="3150000" cy="54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4" name="Rectangle 33"/>
          <p:cNvSpPr/>
          <p:nvPr/>
        </p:nvSpPr>
        <p:spPr>
          <a:xfrm>
            <a:off x="2096723" y="5157995"/>
            <a:ext cx="684000" cy="468000"/>
          </a:xfrm>
          <a:prstGeom prst="rect">
            <a:avLst/>
          </a:prstGeom>
          <a:solidFill>
            <a:schemeClr val="bg1">
              <a:lumMod val="50000"/>
              <a:alpha val="2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8" name="Rectangle 37"/>
          <p:cNvSpPr/>
          <p:nvPr/>
        </p:nvSpPr>
        <p:spPr>
          <a:xfrm>
            <a:off x="3135026" y="434338"/>
            <a:ext cx="38552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9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4338765" y="420049"/>
            <a:ext cx="3657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82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2977935" y="434338"/>
            <a:ext cx="34496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5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IN" sz="800" dirty="0"/>
          </a:p>
        </p:txBody>
      </p:sp>
      <p:sp>
        <p:nvSpPr>
          <p:cNvPr id="43" name="TextBox 42"/>
          <p:cNvSpPr txBox="1"/>
          <p:nvPr/>
        </p:nvSpPr>
        <p:spPr>
          <a:xfrm>
            <a:off x="1930012" y="1503693"/>
            <a:ext cx="535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155</a:t>
            </a:r>
          </a:p>
          <a:p>
            <a:pPr algn="ctr"/>
            <a:endParaRPr lang="en-US" sz="800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140938" y="1628875"/>
            <a:ext cx="5350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   C160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* 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722543" y="1628875"/>
            <a:ext cx="5350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150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7" name="Straight Connector 46"/>
          <p:cNvCxnSpPr/>
          <p:nvPr/>
        </p:nvCxnSpPr>
        <p:spPr>
          <a:xfrm>
            <a:off x="2221340" y="1673013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4689160" y="1628875"/>
            <a:ext cx="46990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216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IN" sz="800" dirty="0"/>
          </a:p>
        </p:txBody>
      </p:sp>
      <p:sp>
        <p:nvSpPr>
          <p:cNvPr id="49" name="TextBox 48"/>
          <p:cNvSpPr txBox="1"/>
          <p:nvPr/>
        </p:nvSpPr>
        <p:spPr>
          <a:xfrm>
            <a:off x="2568968" y="3809626"/>
            <a:ext cx="1323912" cy="453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putative hinge region</a:t>
            </a:r>
          </a:p>
          <a:p>
            <a:pPr algn="ctr"/>
            <a:r>
              <a:rPr lang="en-US" sz="750" dirty="0" smtClean="0">
                <a:latin typeface="Times New Roman" pitchFamily="18" charset="0"/>
                <a:cs typeface="Times New Roman" pitchFamily="18" charset="0"/>
              </a:rPr>
              <a:t>*****</a:t>
            </a:r>
          </a:p>
          <a:p>
            <a:pPr algn="ctr"/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717384" y="3693871"/>
            <a:ext cx="13945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E binding factor like motif</a:t>
            </a:r>
          </a:p>
          <a:p>
            <a:pPr algn="ctr"/>
            <a:r>
              <a:rPr lang="en-US" sz="7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***</a:t>
            </a:r>
          </a:p>
          <a:p>
            <a:pPr algn="ctr"/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97440" y="3816077"/>
            <a:ext cx="4256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T373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003927" y="4906149"/>
            <a:ext cx="4936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521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1374944" y="4908421"/>
            <a:ext cx="4616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529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 </a:t>
            </a:r>
            <a:endParaRPr lang="en-IN" sz="800" dirty="0"/>
          </a:p>
        </p:txBody>
      </p:sp>
      <p:sp>
        <p:nvSpPr>
          <p:cNvPr id="54" name="TextBox 53"/>
          <p:cNvSpPr txBox="1"/>
          <p:nvPr/>
        </p:nvSpPr>
        <p:spPr>
          <a:xfrm>
            <a:off x="1811962" y="4925326"/>
            <a:ext cx="126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   </a:t>
            </a:r>
            <a:r>
              <a:rPr lang="en-US" sz="800" dirty="0" smtClean="0"/>
              <a:t>** *                **</a:t>
            </a:r>
            <a:endParaRPr lang="en-US" sz="800" dirty="0"/>
          </a:p>
        </p:txBody>
      </p:sp>
      <p:cxnSp>
        <p:nvCxnSpPr>
          <p:cNvPr id="55" name="Straight Connector 54"/>
          <p:cNvCxnSpPr/>
          <p:nvPr/>
        </p:nvCxnSpPr>
        <p:spPr>
          <a:xfrm flipV="1">
            <a:off x="6187330" y="4019802"/>
            <a:ext cx="379734" cy="1379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6061211" y="3825011"/>
            <a:ext cx="648269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solidFill>
                  <a:schemeClr val="accent6">
                    <a:lumMod val="75000"/>
                  </a:schemeClr>
                </a:solidFill>
              </a:rPr>
              <a:t>NIMIN1/2</a:t>
            </a:r>
          </a:p>
          <a:p>
            <a:endParaRPr lang="en-US" sz="800" dirty="0"/>
          </a:p>
        </p:txBody>
      </p:sp>
      <p:sp>
        <p:nvSpPr>
          <p:cNvPr id="57" name="TextBox 56"/>
          <p:cNvSpPr txBox="1"/>
          <p:nvPr/>
        </p:nvSpPr>
        <p:spPr>
          <a:xfrm>
            <a:off x="-3158" y="4928274"/>
            <a:ext cx="1125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solidFill>
                  <a:schemeClr val="accent6">
                    <a:lumMod val="75000"/>
                  </a:schemeClr>
                </a:solidFill>
              </a:rPr>
              <a:t>Binding site</a:t>
            </a:r>
            <a:endParaRPr lang="en-US" sz="800" dirty="0">
              <a:solidFill>
                <a:schemeClr val="accent6">
                  <a:lumMod val="75000"/>
                </a:schemeClr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378297" y="5117681"/>
            <a:ext cx="342000" cy="599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9" name="Rectangle 58"/>
          <p:cNvSpPr/>
          <p:nvPr/>
        </p:nvSpPr>
        <p:spPr>
          <a:xfrm>
            <a:off x="99000" y="6464377"/>
            <a:ext cx="58192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ure </a:t>
            </a:r>
            <a:r>
              <a:rPr lang="en-IN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4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ple sequence alignment of </a:t>
            </a:r>
            <a:r>
              <a:rPr lang="en-I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I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imondaii</a:t>
            </a:r>
            <a:r>
              <a:rPr lang="en-I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NPRs 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IN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 r="3206" b="85300"/>
          <a:stretch>
            <a:fillRect/>
          </a:stretch>
        </p:blipFill>
        <p:spPr bwMode="auto">
          <a:xfrm>
            <a:off x="36000" y="1353360"/>
            <a:ext cx="6786000" cy="10962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/>
          <a:srcRect t="14700" r="3206" b="70110"/>
          <a:stretch>
            <a:fillRect/>
          </a:stretch>
        </p:blipFill>
        <p:spPr bwMode="auto">
          <a:xfrm>
            <a:off x="36000" y="2724016"/>
            <a:ext cx="6786000" cy="11327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/>
          <a:srcRect t="30074" r="3206" b="54919"/>
          <a:stretch>
            <a:fillRect/>
          </a:stretch>
        </p:blipFill>
        <p:spPr bwMode="auto">
          <a:xfrm>
            <a:off x="36000" y="4153127"/>
            <a:ext cx="6786000" cy="11191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/>
          <a:srcRect t="44898" r="3206" b="39729"/>
          <a:stretch>
            <a:fillRect/>
          </a:stretch>
        </p:blipFill>
        <p:spPr bwMode="auto">
          <a:xfrm>
            <a:off x="36000" y="5592255"/>
            <a:ext cx="6786000" cy="1146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/>
          <a:srcRect t="60271" r="3206" b="23187"/>
          <a:stretch>
            <a:fillRect/>
          </a:stretch>
        </p:blipFill>
        <p:spPr bwMode="auto">
          <a:xfrm>
            <a:off x="36000" y="7092655"/>
            <a:ext cx="6786000" cy="12335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Rectangle 8"/>
          <p:cNvSpPr/>
          <p:nvPr/>
        </p:nvSpPr>
        <p:spPr>
          <a:xfrm>
            <a:off x="2765442" y="1347492"/>
            <a:ext cx="3888000" cy="576000"/>
          </a:xfrm>
          <a:prstGeom prst="rect">
            <a:avLst/>
          </a:prstGeom>
          <a:solidFill>
            <a:srgbClr val="FFFF00">
              <a:alpha val="15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lt1">
                  <a:alpha val="20000"/>
                </a:schemeClr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3082942" y="1918992"/>
            <a:ext cx="3564000" cy="126000"/>
          </a:xfrm>
          <a:prstGeom prst="rect">
            <a:avLst/>
          </a:prstGeom>
          <a:solidFill>
            <a:srgbClr val="FFFF00">
              <a:alpha val="15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lt1">
                  <a:alpha val="20000"/>
                </a:schemeClr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2771792" y="2039642"/>
            <a:ext cx="3888000" cy="396000"/>
          </a:xfrm>
          <a:prstGeom prst="rect">
            <a:avLst/>
          </a:prstGeom>
          <a:solidFill>
            <a:srgbClr val="FFFF00">
              <a:alpha val="15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lt1">
                  <a:alpha val="20000"/>
                </a:schemeClr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33235" y="2739000"/>
            <a:ext cx="3654000" cy="1116000"/>
          </a:xfrm>
          <a:prstGeom prst="rect">
            <a:avLst/>
          </a:prstGeom>
          <a:solidFill>
            <a:srgbClr val="FFFF00">
              <a:alpha val="15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lt1">
                  <a:alpha val="20000"/>
                </a:schemeClr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5614664" y="2765820"/>
            <a:ext cx="1022956" cy="1080000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" name="Rectangle 13"/>
          <p:cNvSpPr/>
          <p:nvPr/>
        </p:nvSpPr>
        <p:spPr>
          <a:xfrm>
            <a:off x="325929" y="4172127"/>
            <a:ext cx="2000811" cy="360000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" name="Rectangle 14"/>
          <p:cNvSpPr/>
          <p:nvPr/>
        </p:nvSpPr>
        <p:spPr>
          <a:xfrm>
            <a:off x="338000" y="4659509"/>
            <a:ext cx="2000811" cy="612000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6" name="Rectangle 15"/>
          <p:cNvSpPr/>
          <p:nvPr/>
        </p:nvSpPr>
        <p:spPr>
          <a:xfrm>
            <a:off x="337992" y="4532769"/>
            <a:ext cx="1944000" cy="126000"/>
          </a:xfrm>
          <a:prstGeom prst="rect">
            <a:avLst/>
          </a:prstGeom>
          <a:solidFill>
            <a:schemeClr val="accent6">
              <a:lumMod val="60000"/>
              <a:lumOff val="4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" name="Rectangle 16"/>
          <p:cNvSpPr/>
          <p:nvPr/>
        </p:nvSpPr>
        <p:spPr>
          <a:xfrm>
            <a:off x="2290763" y="4184602"/>
            <a:ext cx="3762000" cy="68705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18" name="Rectangle 17"/>
          <p:cNvSpPr/>
          <p:nvPr/>
        </p:nvSpPr>
        <p:spPr>
          <a:xfrm>
            <a:off x="2366963" y="4252491"/>
            <a:ext cx="3772800" cy="648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19" name="Rectangle 18"/>
          <p:cNvSpPr/>
          <p:nvPr/>
        </p:nvSpPr>
        <p:spPr>
          <a:xfrm>
            <a:off x="2243117" y="4317949"/>
            <a:ext cx="3906000" cy="1008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0" name="Rectangle 19"/>
          <p:cNvSpPr/>
          <p:nvPr/>
        </p:nvSpPr>
        <p:spPr>
          <a:xfrm>
            <a:off x="2376465" y="4417433"/>
            <a:ext cx="3722400" cy="1044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1" name="Rectangle 20"/>
          <p:cNvSpPr/>
          <p:nvPr/>
        </p:nvSpPr>
        <p:spPr>
          <a:xfrm>
            <a:off x="3309997" y="4633290"/>
            <a:ext cx="2880000" cy="1188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2" name="Rectangle 21"/>
          <p:cNvSpPr/>
          <p:nvPr/>
        </p:nvSpPr>
        <p:spPr>
          <a:xfrm>
            <a:off x="2247848" y="4750304"/>
            <a:ext cx="3816000" cy="1152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3" name="Rectangle 22"/>
          <p:cNvSpPr/>
          <p:nvPr/>
        </p:nvSpPr>
        <p:spPr>
          <a:xfrm>
            <a:off x="2595531" y="4867184"/>
            <a:ext cx="3682800" cy="3888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4" name="Rectangle 23"/>
          <p:cNvSpPr/>
          <p:nvPr/>
        </p:nvSpPr>
        <p:spPr>
          <a:xfrm>
            <a:off x="2381212" y="4522203"/>
            <a:ext cx="3672000" cy="115200"/>
          </a:xfrm>
          <a:prstGeom prst="rect">
            <a:avLst/>
          </a:prstGeom>
          <a:solidFill>
            <a:srgbClr val="FF0000">
              <a:alpha val="32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5" name="Rectangle 19"/>
          <p:cNvSpPr/>
          <p:nvPr/>
        </p:nvSpPr>
        <p:spPr>
          <a:xfrm>
            <a:off x="481011" y="5664588"/>
            <a:ext cx="6156000" cy="669409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6" name="Rectangle 19"/>
          <p:cNvSpPr/>
          <p:nvPr/>
        </p:nvSpPr>
        <p:spPr>
          <a:xfrm>
            <a:off x="333160" y="7133998"/>
            <a:ext cx="3024000" cy="72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7" name="Rectangle 19"/>
          <p:cNvSpPr/>
          <p:nvPr/>
        </p:nvSpPr>
        <p:spPr>
          <a:xfrm>
            <a:off x="335432" y="7204510"/>
            <a:ext cx="3528000" cy="72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8" name="Rectangle 19"/>
          <p:cNvSpPr/>
          <p:nvPr/>
        </p:nvSpPr>
        <p:spPr>
          <a:xfrm>
            <a:off x="335432" y="7272750"/>
            <a:ext cx="3060000" cy="108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0" name="Rectangle 19"/>
          <p:cNvSpPr/>
          <p:nvPr/>
        </p:nvSpPr>
        <p:spPr>
          <a:xfrm>
            <a:off x="335432" y="7381934"/>
            <a:ext cx="2934000" cy="648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1" name="Rectangle 19"/>
          <p:cNvSpPr/>
          <p:nvPr/>
        </p:nvSpPr>
        <p:spPr>
          <a:xfrm>
            <a:off x="337704" y="7451560"/>
            <a:ext cx="2664000" cy="504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2" name="Rectangle 19"/>
          <p:cNvSpPr/>
          <p:nvPr/>
        </p:nvSpPr>
        <p:spPr>
          <a:xfrm>
            <a:off x="333152" y="7502486"/>
            <a:ext cx="3240000" cy="108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3" name="Rectangle 19"/>
          <p:cNvSpPr/>
          <p:nvPr/>
        </p:nvSpPr>
        <p:spPr>
          <a:xfrm>
            <a:off x="333152" y="7611670"/>
            <a:ext cx="2757600" cy="108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4" name="Rectangle 19"/>
          <p:cNvSpPr/>
          <p:nvPr/>
        </p:nvSpPr>
        <p:spPr>
          <a:xfrm>
            <a:off x="335424" y="7716302"/>
            <a:ext cx="3204000" cy="126000"/>
          </a:xfrm>
          <a:custGeom>
            <a:avLst/>
            <a:gdLst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389655 h 918779"/>
              <a:gd name="connsiteX3" fmla="*/ 5937234 w 5937234"/>
              <a:gd name="connsiteY3" fmla="*/ 918779 h 918779"/>
              <a:gd name="connsiteX4" fmla="*/ 0 w 5937234"/>
              <a:gd name="connsiteY4" fmla="*/ 918779 h 918779"/>
              <a:gd name="connsiteX5" fmla="*/ 0 w 5937234"/>
              <a:gd name="connsiteY5" fmla="*/ 0 h 918779"/>
              <a:gd name="connsiteX0" fmla="*/ 0 w 6378699"/>
              <a:gd name="connsiteY0" fmla="*/ 0 h 918779"/>
              <a:gd name="connsiteX1" fmla="*/ 5937234 w 6378699"/>
              <a:gd name="connsiteY1" fmla="*/ 0 h 918779"/>
              <a:gd name="connsiteX2" fmla="*/ 5934287 w 6378699"/>
              <a:gd name="connsiteY2" fmla="*/ 389655 h 918779"/>
              <a:gd name="connsiteX3" fmla="*/ 5941907 w 6378699"/>
              <a:gd name="connsiteY3" fmla="*/ 385845 h 918779"/>
              <a:gd name="connsiteX4" fmla="*/ 5937234 w 6378699"/>
              <a:gd name="connsiteY4" fmla="*/ 918779 h 918779"/>
              <a:gd name="connsiteX5" fmla="*/ 0 w 6378699"/>
              <a:gd name="connsiteY5" fmla="*/ 918779 h 918779"/>
              <a:gd name="connsiteX6" fmla="*/ 0 w 6378699"/>
              <a:gd name="connsiteY6" fmla="*/ 0 h 918779"/>
              <a:gd name="connsiteX0" fmla="*/ 0 w 6377708"/>
              <a:gd name="connsiteY0" fmla="*/ 0 h 918779"/>
              <a:gd name="connsiteX1" fmla="*/ 5937234 w 6377708"/>
              <a:gd name="connsiteY1" fmla="*/ 0 h 918779"/>
              <a:gd name="connsiteX2" fmla="*/ 5934287 w 6377708"/>
              <a:gd name="connsiteY2" fmla="*/ 389655 h 918779"/>
              <a:gd name="connsiteX3" fmla="*/ 5938097 w 6377708"/>
              <a:gd name="connsiteY3" fmla="*/ 267735 h 918779"/>
              <a:gd name="connsiteX4" fmla="*/ 5937234 w 6377708"/>
              <a:gd name="connsiteY4" fmla="*/ 918779 h 918779"/>
              <a:gd name="connsiteX5" fmla="*/ 0 w 6377708"/>
              <a:gd name="connsiteY5" fmla="*/ 918779 h 918779"/>
              <a:gd name="connsiteX6" fmla="*/ 0 w 6377708"/>
              <a:gd name="connsiteY6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493056"/>
              <a:gd name="connsiteY0" fmla="*/ 0 h 918779"/>
              <a:gd name="connsiteX1" fmla="*/ 5937234 w 6493056"/>
              <a:gd name="connsiteY1" fmla="*/ 0 h 918779"/>
              <a:gd name="connsiteX2" fmla="*/ 5934287 w 6493056"/>
              <a:gd name="connsiteY2" fmla="*/ 389655 h 918779"/>
              <a:gd name="connsiteX3" fmla="*/ 5938097 w 6493056"/>
              <a:gd name="connsiteY3" fmla="*/ 267735 h 918779"/>
              <a:gd name="connsiteX4" fmla="*/ 6239087 w 6493056"/>
              <a:gd name="connsiteY4" fmla="*/ 515385 h 918779"/>
              <a:gd name="connsiteX5" fmla="*/ 5937234 w 6493056"/>
              <a:gd name="connsiteY5" fmla="*/ 918779 h 918779"/>
              <a:gd name="connsiteX6" fmla="*/ 0 w 6493056"/>
              <a:gd name="connsiteY6" fmla="*/ 918779 h 918779"/>
              <a:gd name="connsiteX7" fmla="*/ 0 w 6493056"/>
              <a:gd name="connsiteY7" fmla="*/ 0 h 918779"/>
              <a:gd name="connsiteX0" fmla="*/ 0 w 6374319"/>
              <a:gd name="connsiteY0" fmla="*/ 0 h 918779"/>
              <a:gd name="connsiteX1" fmla="*/ 5937234 w 6374319"/>
              <a:gd name="connsiteY1" fmla="*/ 0 h 918779"/>
              <a:gd name="connsiteX2" fmla="*/ 5934287 w 6374319"/>
              <a:gd name="connsiteY2" fmla="*/ 389655 h 918779"/>
              <a:gd name="connsiteX3" fmla="*/ 5938097 w 6374319"/>
              <a:gd name="connsiteY3" fmla="*/ 267735 h 918779"/>
              <a:gd name="connsiteX4" fmla="*/ 5835227 w 6374319"/>
              <a:gd name="connsiteY4" fmla="*/ 305835 h 918779"/>
              <a:gd name="connsiteX5" fmla="*/ 5937234 w 6374319"/>
              <a:gd name="connsiteY5" fmla="*/ 918779 h 918779"/>
              <a:gd name="connsiteX6" fmla="*/ 0 w 6374319"/>
              <a:gd name="connsiteY6" fmla="*/ 918779 h 918779"/>
              <a:gd name="connsiteX7" fmla="*/ 0 w 6374319"/>
              <a:gd name="connsiteY7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431882"/>
              <a:gd name="connsiteY0" fmla="*/ 0 h 918779"/>
              <a:gd name="connsiteX1" fmla="*/ 5937234 w 6431882"/>
              <a:gd name="connsiteY1" fmla="*/ 0 h 918779"/>
              <a:gd name="connsiteX2" fmla="*/ 5934287 w 6431882"/>
              <a:gd name="connsiteY2" fmla="*/ 389655 h 918779"/>
              <a:gd name="connsiteX3" fmla="*/ 5938097 w 6431882"/>
              <a:gd name="connsiteY3" fmla="*/ 267735 h 918779"/>
              <a:gd name="connsiteX4" fmla="*/ 5835227 w 6431882"/>
              <a:gd name="connsiteY4" fmla="*/ 305835 h 918779"/>
              <a:gd name="connsiteX5" fmla="*/ 6079068 w 6431882"/>
              <a:gd name="connsiteY5" fmla="*/ 484905 h 918779"/>
              <a:gd name="connsiteX6" fmla="*/ 5937234 w 6431882"/>
              <a:gd name="connsiteY6" fmla="*/ 918779 h 918779"/>
              <a:gd name="connsiteX7" fmla="*/ 0 w 6431882"/>
              <a:gd name="connsiteY7" fmla="*/ 918779 h 918779"/>
              <a:gd name="connsiteX8" fmla="*/ 0 w 6431882"/>
              <a:gd name="connsiteY8" fmla="*/ 0 h 918779"/>
              <a:gd name="connsiteX0" fmla="*/ 0 w 6079068"/>
              <a:gd name="connsiteY0" fmla="*/ 0 h 918779"/>
              <a:gd name="connsiteX1" fmla="*/ 5937234 w 6079068"/>
              <a:gd name="connsiteY1" fmla="*/ 0 h 918779"/>
              <a:gd name="connsiteX2" fmla="*/ 5934287 w 6079068"/>
              <a:gd name="connsiteY2" fmla="*/ 389655 h 918779"/>
              <a:gd name="connsiteX3" fmla="*/ 5938097 w 6079068"/>
              <a:gd name="connsiteY3" fmla="*/ 267735 h 918779"/>
              <a:gd name="connsiteX4" fmla="*/ 5835227 w 6079068"/>
              <a:gd name="connsiteY4" fmla="*/ 305835 h 918779"/>
              <a:gd name="connsiteX5" fmla="*/ 6079068 w 6079068"/>
              <a:gd name="connsiteY5" fmla="*/ 484905 h 918779"/>
              <a:gd name="connsiteX6" fmla="*/ 5937234 w 6079068"/>
              <a:gd name="connsiteY6" fmla="*/ 918779 h 918779"/>
              <a:gd name="connsiteX7" fmla="*/ 0 w 6079068"/>
              <a:gd name="connsiteY7" fmla="*/ 918779 h 918779"/>
              <a:gd name="connsiteX8" fmla="*/ 0 w 6079068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0108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38965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401"/>
              <a:gd name="connsiteY0" fmla="*/ 0 h 918779"/>
              <a:gd name="connsiteX1" fmla="*/ 5937234 w 5948401"/>
              <a:gd name="connsiteY1" fmla="*/ 0 h 918779"/>
              <a:gd name="connsiteX2" fmla="*/ 5934287 w 5948401"/>
              <a:gd name="connsiteY2" fmla="*/ 172485 h 918779"/>
              <a:gd name="connsiteX3" fmla="*/ 5938097 w 5948401"/>
              <a:gd name="connsiteY3" fmla="*/ 267735 h 918779"/>
              <a:gd name="connsiteX4" fmla="*/ 5835227 w 5948401"/>
              <a:gd name="connsiteY4" fmla="*/ 305835 h 918779"/>
              <a:gd name="connsiteX5" fmla="*/ 5934288 w 5948401"/>
              <a:gd name="connsiteY5" fmla="*/ 420135 h 918779"/>
              <a:gd name="connsiteX6" fmla="*/ 5937234 w 5948401"/>
              <a:gd name="connsiteY6" fmla="*/ 918779 h 918779"/>
              <a:gd name="connsiteX7" fmla="*/ 0 w 5948401"/>
              <a:gd name="connsiteY7" fmla="*/ 918779 h 918779"/>
              <a:gd name="connsiteX8" fmla="*/ 0 w 5948401"/>
              <a:gd name="connsiteY8" fmla="*/ 0 h 918779"/>
              <a:gd name="connsiteX0" fmla="*/ 0 w 5948197"/>
              <a:gd name="connsiteY0" fmla="*/ 0 h 918779"/>
              <a:gd name="connsiteX1" fmla="*/ 5937234 w 5948197"/>
              <a:gd name="connsiteY1" fmla="*/ 0 h 918779"/>
              <a:gd name="connsiteX2" fmla="*/ 5934287 w 5948197"/>
              <a:gd name="connsiteY2" fmla="*/ 172485 h 918779"/>
              <a:gd name="connsiteX3" fmla="*/ 5938097 w 5948197"/>
              <a:gd name="connsiteY3" fmla="*/ 267735 h 918779"/>
              <a:gd name="connsiteX4" fmla="*/ 5831417 w 5948197"/>
              <a:gd name="connsiteY4" fmla="*/ 355365 h 918779"/>
              <a:gd name="connsiteX5" fmla="*/ 5934288 w 5948197"/>
              <a:gd name="connsiteY5" fmla="*/ 420135 h 918779"/>
              <a:gd name="connsiteX6" fmla="*/ 5937234 w 5948197"/>
              <a:gd name="connsiteY6" fmla="*/ 918779 h 918779"/>
              <a:gd name="connsiteX7" fmla="*/ 0 w 5948197"/>
              <a:gd name="connsiteY7" fmla="*/ 918779 h 918779"/>
              <a:gd name="connsiteX8" fmla="*/ 0 w 5948197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17248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07618 w 5937234"/>
              <a:gd name="connsiteY6" fmla="*/ 374415 h 918779"/>
              <a:gd name="connsiteX7" fmla="*/ 5911428 w 5937234"/>
              <a:gd name="connsiteY7" fmla="*/ 366795 h 918779"/>
              <a:gd name="connsiteX8" fmla="*/ 5934288 w 5937234"/>
              <a:gd name="connsiteY8" fmla="*/ 420135 h 918779"/>
              <a:gd name="connsiteX9" fmla="*/ 5937234 w 5937234"/>
              <a:gd name="connsiteY9" fmla="*/ 918779 h 918779"/>
              <a:gd name="connsiteX10" fmla="*/ 0 w 5937234"/>
              <a:gd name="connsiteY10" fmla="*/ 918779 h 918779"/>
              <a:gd name="connsiteX11" fmla="*/ 0 w 5937234"/>
              <a:gd name="connsiteY11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43"/>
              <a:gd name="connsiteY0" fmla="*/ 0 h 918779"/>
              <a:gd name="connsiteX1" fmla="*/ 5937234 w 5937243"/>
              <a:gd name="connsiteY1" fmla="*/ 0 h 918779"/>
              <a:gd name="connsiteX2" fmla="*/ 5934287 w 5937243"/>
              <a:gd name="connsiteY2" fmla="*/ 256305 h 918779"/>
              <a:gd name="connsiteX3" fmla="*/ 5842847 w 5937243"/>
              <a:gd name="connsiteY3" fmla="*/ 275355 h 918779"/>
              <a:gd name="connsiteX4" fmla="*/ 5831417 w 5937243"/>
              <a:gd name="connsiteY4" fmla="*/ 355365 h 918779"/>
              <a:gd name="connsiteX5" fmla="*/ 5915238 w 5937243"/>
              <a:gd name="connsiteY5" fmla="*/ 374415 h 918779"/>
              <a:gd name="connsiteX6" fmla="*/ 5907618 w 5937243"/>
              <a:gd name="connsiteY6" fmla="*/ 374415 h 918779"/>
              <a:gd name="connsiteX7" fmla="*/ 5934288 w 5937243"/>
              <a:gd name="connsiteY7" fmla="*/ 420135 h 918779"/>
              <a:gd name="connsiteX8" fmla="*/ 5937234 w 5937243"/>
              <a:gd name="connsiteY8" fmla="*/ 918779 h 918779"/>
              <a:gd name="connsiteX9" fmla="*/ 0 w 5937243"/>
              <a:gd name="connsiteY9" fmla="*/ 918779 h 918779"/>
              <a:gd name="connsiteX10" fmla="*/ 0 w 5937243"/>
              <a:gd name="connsiteY10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9048 w 5937234"/>
              <a:gd name="connsiteY5" fmla="*/ 37441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4287 w 5937234"/>
              <a:gd name="connsiteY2" fmla="*/ 256305 h 918779"/>
              <a:gd name="connsiteX3" fmla="*/ 5842847 w 5937234"/>
              <a:gd name="connsiteY3" fmla="*/ 275355 h 918779"/>
              <a:gd name="connsiteX4" fmla="*/ 5831417 w 5937234"/>
              <a:gd name="connsiteY4" fmla="*/ 355365 h 918779"/>
              <a:gd name="connsiteX5" fmla="*/ 5915238 w 5937234"/>
              <a:gd name="connsiteY5" fmla="*/ 362985 h 918779"/>
              <a:gd name="connsiteX6" fmla="*/ 5934288 w 5937234"/>
              <a:gd name="connsiteY6" fmla="*/ 420135 h 918779"/>
              <a:gd name="connsiteX7" fmla="*/ 5937234 w 5937234"/>
              <a:gd name="connsiteY7" fmla="*/ 918779 h 918779"/>
              <a:gd name="connsiteX8" fmla="*/ 0 w 5937234"/>
              <a:gd name="connsiteY8" fmla="*/ 918779 h 918779"/>
              <a:gd name="connsiteX9" fmla="*/ 0 w 5937234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37939"/>
              <a:gd name="connsiteY0" fmla="*/ 0 h 918779"/>
              <a:gd name="connsiteX1" fmla="*/ 5937234 w 5937939"/>
              <a:gd name="connsiteY1" fmla="*/ 0 h 918779"/>
              <a:gd name="connsiteX2" fmla="*/ 5934287 w 5937939"/>
              <a:gd name="connsiteY2" fmla="*/ 256305 h 918779"/>
              <a:gd name="connsiteX3" fmla="*/ 5842847 w 5937939"/>
              <a:gd name="connsiteY3" fmla="*/ 275355 h 918779"/>
              <a:gd name="connsiteX4" fmla="*/ 5831417 w 5937939"/>
              <a:gd name="connsiteY4" fmla="*/ 355365 h 918779"/>
              <a:gd name="connsiteX5" fmla="*/ 5897207 w 5937939"/>
              <a:gd name="connsiteY5" fmla="*/ 366342 h 918779"/>
              <a:gd name="connsiteX6" fmla="*/ 5934288 w 5937939"/>
              <a:gd name="connsiteY6" fmla="*/ 420135 h 918779"/>
              <a:gd name="connsiteX7" fmla="*/ 5937234 w 5937939"/>
              <a:gd name="connsiteY7" fmla="*/ 918779 h 918779"/>
              <a:gd name="connsiteX8" fmla="*/ 0 w 5937939"/>
              <a:gd name="connsiteY8" fmla="*/ 918779 h 918779"/>
              <a:gd name="connsiteX9" fmla="*/ 0 w 5937939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847 w 5942716"/>
              <a:gd name="connsiteY3" fmla="*/ 275355 h 918779"/>
              <a:gd name="connsiteX4" fmla="*/ 5837428 w 5942716"/>
              <a:gd name="connsiteY4" fmla="*/ 305620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7428 w 5942716"/>
              <a:gd name="connsiteY5" fmla="*/ 305620 h 918779"/>
              <a:gd name="connsiteX6" fmla="*/ 5831417 w 5942716"/>
              <a:gd name="connsiteY6" fmla="*/ 355365 h 918779"/>
              <a:gd name="connsiteX7" fmla="*/ 5934288 w 5942716"/>
              <a:gd name="connsiteY7" fmla="*/ 420135 h 918779"/>
              <a:gd name="connsiteX8" fmla="*/ 5937234 w 5942716"/>
              <a:gd name="connsiteY8" fmla="*/ 918779 h 918779"/>
              <a:gd name="connsiteX9" fmla="*/ 0 w 5942716"/>
              <a:gd name="connsiteY9" fmla="*/ 918779 h 918779"/>
              <a:gd name="connsiteX10" fmla="*/ 0 w 5942716"/>
              <a:gd name="connsiteY10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42847 w 5942716"/>
              <a:gd name="connsiteY4" fmla="*/ 275355 h 918779"/>
              <a:gd name="connsiteX5" fmla="*/ 5831417 w 5942716"/>
              <a:gd name="connsiteY5" fmla="*/ 355365 h 918779"/>
              <a:gd name="connsiteX6" fmla="*/ 5934288 w 5942716"/>
              <a:gd name="connsiteY6" fmla="*/ 420135 h 918779"/>
              <a:gd name="connsiteX7" fmla="*/ 5937234 w 5942716"/>
              <a:gd name="connsiteY7" fmla="*/ 918779 h 918779"/>
              <a:gd name="connsiteX8" fmla="*/ 0 w 5942716"/>
              <a:gd name="connsiteY8" fmla="*/ 918779 h 918779"/>
              <a:gd name="connsiteX9" fmla="*/ 0 w 5942716"/>
              <a:gd name="connsiteY9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73489 w 5942716"/>
              <a:gd name="connsiteY3" fmla="*/ 251529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42580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34287 w 5942716"/>
              <a:gd name="connsiteY2" fmla="*/ 256305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32277 w 5942716"/>
              <a:gd name="connsiteY3" fmla="*/ 272135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42716"/>
              <a:gd name="connsiteY0" fmla="*/ 0 h 918779"/>
              <a:gd name="connsiteX1" fmla="*/ 5937234 w 5942716"/>
              <a:gd name="connsiteY1" fmla="*/ 0 h 918779"/>
              <a:gd name="connsiteX2" fmla="*/ 5929135 w 5942716"/>
              <a:gd name="connsiteY2" fmla="*/ 269184 h 918779"/>
              <a:gd name="connsiteX3" fmla="*/ 5886368 w 5942716"/>
              <a:gd name="connsiteY3" fmla="*/ 282438 h 918779"/>
              <a:gd name="connsiteX4" fmla="*/ 5831417 w 5942716"/>
              <a:gd name="connsiteY4" fmla="*/ 355365 h 918779"/>
              <a:gd name="connsiteX5" fmla="*/ 5934288 w 5942716"/>
              <a:gd name="connsiteY5" fmla="*/ 420135 h 918779"/>
              <a:gd name="connsiteX6" fmla="*/ 5937234 w 5942716"/>
              <a:gd name="connsiteY6" fmla="*/ 918779 h 918779"/>
              <a:gd name="connsiteX7" fmla="*/ 0 w 5942716"/>
              <a:gd name="connsiteY7" fmla="*/ 918779 h 918779"/>
              <a:gd name="connsiteX8" fmla="*/ 0 w 5942716"/>
              <a:gd name="connsiteY8" fmla="*/ 0 h 918779"/>
              <a:gd name="connsiteX0" fmla="*/ 0 w 5938951"/>
              <a:gd name="connsiteY0" fmla="*/ 0 h 918779"/>
              <a:gd name="connsiteX1" fmla="*/ 5937234 w 5938951"/>
              <a:gd name="connsiteY1" fmla="*/ 0 h 918779"/>
              <a:gd name="connsiteX2" fmla="*/ 5929135 w 5938951"/>
              <a:gd name="connsiteY2" fmla="*/ 269184 h 918779"/>
              <a:gd name="connsiteX3" fmla="*/ 5886368 w 5938951"/>
              <a:gd name="connsiteY3" fmla="*/ 282438 h 918779"/>
              <a:gd name="connsiteX4" fmla="*/ 5882932 w 5938951"/>
              <a:gd name="connsiteY4" fmla="*/ 365668 h 918779"/>
              <a:gd name="connsiteX5" fmla="*/ 5934288 w 5938951"/>
              <a:gd name="connsiteY5" fmla="*/ 420135 h 918779"/>
              <a:gd name="connsiteX6" fmla="*/ 5937234 w 5938951"/>
              <a:gd name="connsiteY6" fmla="*/ 918779 h 918779"/>
              <a:gd name="connsiteX7" fmla="*/ 0 w 5938951"/>
              <a:gd name="connsiteY7" fmla="*/ 918779 h 918779"/>
              <a:gd name="connsiteX8" fmla="*/ 0 w 5938951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924"/>
              <a:gd name="connsiteY0" fmla="*/ 0 h 918779"/>
              <a:gd name="connsiteX1" fmla="*/ 5937234 w 5952924"/>
              <a:gd name="connsiteY1" fmla="*/ 0 h 918779"/>
              <a:gd name="connsiteX2" fmla="*/ 5929135 w 5952924"/>
              <a:gd name="connsiteY2" fmla="*/ 269184 h 918779"/>
              <a:gd name="connsiteX3" fmla="*/ 5886368 w 5952924"/>
              <a:gd name="connsiteY3" fmla="*/ 282438 h 918779"/>
              <a:gd name="connsiteX4" fmla="*/ 5882932 w 5952924"/>
              <a:gd name="connsiteY4" fmla="*/ 365668 h 918779"/>
              <a:gd name="connsiteX5" fmla="*/ 5943035 w 5952924"/>
              <a:gd name="connsiteY5" fmla="*/ 362287 h 918779"/>
              <a:gd name="connsiteX6" fmla="*/ 5952318 w 5952924"/>
              <a:gd name="connsiteY6" fmla="*/ 402104 h 918779"/>
              <a:gd name="connsiteX7" fmla="*/ 5937234 w 5952924"/>
              <a:gd name="connsiteY7" fmla="*/ 918779 h 918779"/>
              <a:gd name="connsiteX8" fmla="*/ 0 w 5952924"/>
              <a:gd name="connsiteY8" fmla="*/ 918779 h 918779"/>
              <a:gd name="connsiteX9" fmla="*/ 0 w 5952924"/>
              <a:gd name="connsiteY9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29135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4288"/>
              <a:gd name="connsiteY0" fmla="*/ 0 h 918779"/>
              <a:gd name="connsiteX1" fmla="*/ 5937234 w 5954288"/>
              <a:gd name="connsiteY1" fmla="*/ 0 h 918779"/>
              <a:gd name="connsiteX2" fmla="*/ 5934287 w 5954288"/>
              <a:gd name="connsiteY2" fmla="*/ 269184 h 918779"/>
              <a:gd name="connsiteX3" fmla="*/ 5886368 w 5954288"/>
              <a:gd name="connsiteY3" fmla="*/ 282438 h 918779"/>
              <a:gd name="connsiteX4" fmla="*/ 5882932 w 5954288"/>
              <a:gd name="connsiteY4" fmla="*/ 365668 h 918779"/>
              <a:gd name="connsiteX5" fmla="*/ 5952318 w 5954288"/>
              <a:gd name="connsiteY5" fmla="*/ 402104 h 918779"/>
              <a:gd name="connsiteX6" fmla="*/ 5937234 w 5954288"/>
              <a:gd name="connsiteY6" fmla="*/ 918779 h 918779"/>
              <a:gd name="connsiteX7" fmla="*/ 0 w 5954288"/>
              <a:gd name="connsiteY7" fmla="*/ 918779 h 918779"/>
              <a:gd name="connsiteX8" fmla="*/ 0 w 5954288"/>
              <a:gd name="connsiteY8" fmla="*/ 0 h 918779"/>
              <a:gd name="connsiteX0" fmla="*/ 0 w 5952762"/>
              <a:gd name="connsiteY0" fmla="*/ 0 h 918779"/>
              <a:gd name="connsiteX1" fmla="*/ 5937234 w 5952762"/>
              <a:gd name="connsiteY1" fmla="*/ 0 h 918779"/>
              <a:gd name="connsiteX2" fmla="*/ 5934287 w 5952762"/>
              <a:gd name="connsiteY2" fmla="*/ 269184 h 918779"/>
              <a:gd name="connsiteX3" fmla="*/ 5886368 w 5952762"/>
              <a:gd name="connsiteY3" fmla="*/ 282438 h 918779"/>
              <a:gd name="connsiteX4" fmla="*/ 5882932 w 5952762"/>
              <a:gd name="connsiteY4" fmla="*/ 365668 h 918779"/>
              <a:gd name="connsiteX5" fmla="*/ 5952318 w 5952762"/>
              <a:gd name="connsiteY5" fmla="*/ 402104 h 918779"/>
              <a:gd name="connsiteX6" fmla="*/ 5937234 w 5952762"/>
              <a:gd name="connsiteY6" fmla="*/ 918779 h 918779"/>
              <a:gd name="connsiteX7" fmla="*/ 0 w 5952762"/>
              <a:gd name="connsiteY7" fmla="*/ 918779 h 918779"/>
              <a:gd name="connsiteX8" fmla="*/ 0 w 5952762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30157 w 5952389"/>
              <a:gd name="connsiteY5" fmla="*/ 357136 h 918779"/>
              <a:gd name="connsiteX6" fmla="*/ 5952318 w 5952389"/>
              <a:gd name="connsiteY6" fmla="*/ 402104 h 918779"/>
              <a:gd name="connsiteX7" fmla="*/ 5937234 w 5952389"/>
              <a:gd name="connsiteY7" fmla="*/ 918779 h 918779"/>
              <a:gd name="connsiteX8" fmla="*/ 0 w 5952389"/>
              <a:gd name="connsiteY8" fmla="*/ 918779 h 918779"/>
              <a:gd name="connsiteX9" fmla="*/ 0 w 5952389"/>
              <a:gd name="connsiteY9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86368 w 5952389"/>
              <a:gd name="connsiteY3" fmla="*/ 282438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389"/>
              <a:gd name="connsiteY0" fmla="*/ 0 h 918779"/>
              <a:gd name="connsiteX1" fmla="*/ 5937234 w 5952389"/>
              <a:gd name="connsiteY1" fmla="*/ 0 h 918779"/>
              <a:gd name="connsiteX2" fmla="*/ 5934287 w 5952389"/>
              <a:gd name="connsiteY2" fmla="*/ 269184 h 918779"/>
              <a:gd name="connsiteX3" fmla="*/ 5878641 w 5952389"/>
              <a:gd name="connsiteY3" fmla="*/ 290165 h 918779"/>
              <a:gd name="connsiteX4" fmla="*/ 5882932 w 5952389"/>
              <a:gd name="connsiteY4" fmla="*/ 365668 h 918779"/>
              <a:gd name="connsiteX5" fmla="*/ 5952318 w 5952389"/>
              <a:gd name="connsiteY5" fmla="*/ 402104 h 918779"/>
              <a:gd name="connsiteX6" fmla="*/ 5937234 w 5952389"/>
              <a:gd name="connsiteY6" fmla="*/ 918779 h 918779"/>
              <a:gd name="connsiteX7" fmla="*/ 0 w 5952389"/>
              <a:gd name="connsiteY7" fmla="*/ 918779 h 918779"/>
              <a:gd name="connsiteX8" fmla="*/ 0 w 5952389"/>
              <a:gd name="connsiteY8" fmla="*/ 0 h 918779"/>
              <a:gd name="connsiteX0" fmla="*/ 0 w 5952400"/>
              <a:gd name="connsiteY0" fmla="*/ 0 h 918779"/>
              <a:gd name="connsiteX1" fmla="*/ 5937234 w 5952400"/>
              <a:gd name="connsiteY1" fmla="*/ 0 h 918779"/>
              <a:gd name="connsiteX2" fmla="*/ 5934287 w 5952400"/>
              <a:gd name="connsiteY2" fmla="*/ 269184 h 918779"/>
              <a:gd name="connsiteX3" fmla="*/ 5878641 w 5952400"/>
              <a:gd name="connsiteY3" fmla="*/ 290165 h 918779"/>
              <a:gd name="connsiteX4" fmla="*/ 5882932 w 5952400"/>
              <a:gd name="connsiteY4" fmla="*/ 365668 h 918779"/>
              <a:gd name="connsiteX5" fmla="*/ 5952318 w 5952400"/>
              <a:gd name="connsiteY5" fmla="*/ 402104 h 918779"/>
              <a:gd name="connsiteX6" fmla="*/ 5937234 w 5952400"/>
              <a:gd name="connsiteY6" fmla="*/ 918779 h 918779"/>
              <a:gd name="connsiteX7" fmla="*/ 0 w 5952400"/>
              <a:gd name="connsiteY7" fmla="*/ 918779 h 918779"/>
              <a:gd name="connsiteX8" fmla="*/ 0 w 5952400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5952318"/>
              <a:gd name="connsiteY0" fmla="*/ 0 h 918779"/>
              <a:gd name="connsiteX1" fmla="*/ 5937234 w 5952318"/>
              <a:gd name="connsiteY1" fmla="*/ 0 h 918779"/>
              <a:gd name="connsiteX2" fmla="*/ 5934287 w 5952318"/>
              <a:gd name="connsiteY2" fmla="*/ 269184 h 918779"/>
              <a:gd name="connsiteX3" fmla="*/ 5878641 w 5952318"/>
              <a:gd name="connsiteY3" fmla="*/ 290165 h 918779"/>
              <a:gd name="connsiteX4" fmla="*/ 5882932 w 5952318"/>
              <a:gd name="connsiteY4" fmla="*/ 365668 h 918779"/>
              <a:gd name="connsiteX5" fmla="*/ 5952318 w 5952318"/>
              <a:gd name="connsiteY5" fmla="*/ 402104 h 918779"/>
              <a:gd name="connsiteX6" fmla="*/ 5937234 w 5952318"/>
              <a:gd name="connsiteY6" fmla="*/ 918779 h 918779"/>
              <a:gd name="connsiteX7" fmla="*/ 0 w 5952318"/>
              <a:gd name="connsiteY7" fmla="*/ 918779 h 918779"/>
              <a:gd name="connsiteX8" fmla="*/ 0 w 5952318"/>
              <a:gd name="connsiteY8" fmla="*/ 0 h 918779"/>
              <a:gd name="connsiteX0" fmla="*/ 0 w 6359902"/>
              <a:gd name="connsiteY0" fmla="*/ 0 h 918779"/>
              <a:gd name="connsiteX1" fmla="*/ 5937234 w 6359902"/>
              <a:gd name="connsiteY1" fmla="*/ 0 h 918779"/>
              <a:gd name="connsiteX2" fmla="*/ 5878641 w 6359902"/>
              <a:gd name="connsiteY2" fmla="*/ 290165 h 918779"/>
              <a:gd name="connsiteX3" fmla="*/ 5882932 w 6359902"/>
              <a:gd name="connsiteY3" fmla="*/ 365668 h 918779"/>
              <a:gd name="connsiteX4" fmla="*/ 5952318 w 6359902"/>
              <a:gd name="connsiteY4" fmla="*/ 402104 h 918779"/>
              <a:gd name="connsiteX5" fmla="*/ 5937234 w 6359902"/>
              <a:gd name="connsiteY5" fmla="*/ 918779 h 918779"/>
              <a:gd name="connsiteX6" fmla="*/ 0 w 6359902"/>
              <a:gd name="connsiteY6" fmla="*/ 918779 h 918779"/>
              <a:gd name="connsiteX7" fmla="*/ 0 w 6359902"/>
              <a:gd name="connsiteY7" fmla="*/ 0 h 918779"/>
              <a:gd name="connsiteX0" fmla="*/ 0 w 6358832"/>
              <a:gd name="connsiteY0" fmla="*/ 0 h 918779"/>
              <a:gd name="connsiteX1" fmla="*/ 5937234 w 6358832"/>
              <a:gd name="connsiteY1" fmla="*/ 0 h 918779"/>
              <a:gd name="connsiteX2" fmla="*/ 5882932 w 6358832"/>
              <a:gd name="connsiteY2" fmla="*/ 365668 h 918779"/>
              <a:gd name="connsiteX3" fmla="*/ 5952318 w 6358832"/>
              <a:gd name="connsiteY3" fmla="*/ 402104 h 918779"/>
              <a:gd name="connsiteX4" fmla="*/ 5937234 w 6358832"/>
              <a:gd name="connsiteY4" fmla="*/ 918779 h 918779"/>
              <a:gd name="connsiteX5" fmla="*/ 0 w 6358832"/>
              <a:gd name="connsiteY5" fmla="*/ 918779 h 918779"/>
              <a:gd name="connsiteX6" fmla="*/ 0 w 6358832"/>
              <a:gd name="connsiteY6" fmla="*/ 0 h 918779"/>
              <a:gd name="connsiteX0" fmla="*/ 0 w 6359360"/>
              <a:gd name="connsiteY0" fmla="*/ 0 h 918779"/>
              <a:gd name="connsiteX1" fmla="*/ 5937234 w 6359360"/>
              <a:gd name="connsiteY1" fmla="*/ 0 h 918779"/>
              <a:gd name="connsiteX2" fmla="*/ 5882932 w 6359360"/>
              <a:gd name="connsiteY2" fmla="*/ 365668 h 918779"/>
              <a:gd name="connsiteX3" fmla="*/ 5937234 w 6359360"/>
              <a:gd name="connsiteY3" fmla="*/ 918779 h 918779"/>
              <a:gd name="connsiteX4" fmla="*/ 0 w 6359360"/>
              <a:gd name="connsiteY4" fmla="*/ 918779 h 918779"/>
              <a:gd name="connsiteX5" fmla="*/ 0 w 6359360"/>
              <a:gd name="connsiteY5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79388"/>
              <a:gd name="connsiteY0" fmla="*/ 0 h 918779"/>
              <a:gd name="connsiteX1" fmla="*/ 5937234 w 6679388"/>
              <a:gd name="connsiteY1" fmla="*/ 0 h 918779"/>
              <a:gd name="connsiteX2" fmla="*/ 5937234 w 6679388"/>
              <a:gd name="connsiteY2" fmla="*/ 918779 h 918779"/>
              <a:gd name="connsiteX3" fmla="*/ 0 w 6679388"/>
              <a:gd name="connsiteY3" fmla="*/ 918779 h 918779"/>
              <a:gd name="connsiteX4" fmla="*/ 0 w 6679388"/>
              <a:gd name="connsiteY4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19506"/>
              <a:gd name="connsiteY0" fmla="*/ 0 h 918779"/>
              <a:gd name="connsiteX1" fmla="*/ 5937234 w 6619506"/>
              <a:gd name="connsiteY1" fmla="*/ 0 h 918779"/>
              <a:gd name="connsiteX2" fmla="*/ 6490377 w 6619506"/>
              <a:gd name="connsiteY2" fmla="*/ 740744 h 918779"/>
              <a:gd name="connsiteX3" fmla="*/ 5937234 w 6619506"/>
              <a:gd name="connsiteY3" fmla="*/ 918779 h 918779"/>
              <a:gd name="connsiteX4" fmla="*/ 0 w 6619506"/>
              <a:gd name="connsiteY4" fmla="*/ 918779 h 918779"/>
              <a:gd name="connsiteX5" fmla="*/ 0 w 6619506"/>
              <a:gd name="connsiteY5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658555"/>
              <a:gd name="connsiteY0" fmla="*/ 0 h 918779"/>
              <a:gd name="connsiteX1" fmla="*/ 5937234 w 6658555"/>
              <a:gd name="connsiteY1" fmla="*/ 0 h 918779"/>
              <a:gd name="connsiteX2" fmla="*/ 6490377 w 6658555"/>
              <a:gd name="connsiteY2" fmla="*/ 740744 h 918779"/>
              <a:gd name="connsiteX3" fmla="*/ 6616619 w 6658555"/>
              <a:gd name="connsiteY3" fmla="*/ 884045 h 918779"/>
              <a:gd name="connsiteX4" fmla="*/ 5937234 w 6658555"/>
              <a:gd name="connsiteY4" fmla="*/ 918779 h 918779"/>
              <a:gd name="connsiteX5" fmla="*/ 0 w 6658555"/>
              <a:gd name="connsiteY5" fmla="*/ 918779 h 918779"/>
              <a:gd name="connsiteX6" fmla="*/ 0 w 6658555"/>
              <a:gd name="connsiteY6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6490377"/>
              <a:gd name="connsiteY0" fmla="*/ 0 h 918779"/>
              <a:gd name="connsiteX1" fmla="*/ 5937234 w 6490377"/>
              <a:gd name="connsiteY1" fmla="*/ 0 h 918779"/>
              <a:gd name="connsiteX2" fmla="*/ 6490377 w 6490377"/>
              <a:gd name="connsiteY2" fmla="*/ 740744 h 918779"/>
              <a:gd name="connsiteX3" fmla="*/ 5937234 w 6490377"/>
              <a:gd name="connsiteY3" fmla="*/ 918779 h 918779"/>
              <a:gd name="connsiteX4" fmla="*/ 0 w 6490377"/>
              <a:gd name="connsiteY4" fmla="*/ 918779 h 918779"/>
              <a:gd name="connsiteX5" fmla="*/ 0 w 6490377"/>
              <a:gd name="connsiteY5" fmla="*/ 0 h 918779"/>
              <a:gd name="connsiteX0" fmla="*/ 0 w 5937234"/>
              <a:gd name="connsiteY0" fmla="*/ 0 h 918779"/>
              <a:gd name="connsiteX1" fmla="*/ 5937234 w 5937234"/>
              <a:gd name="connsiteY1" fmla="*/ 0 h 918779"/>
              <a:gd name="connsiteX2" fmla="*/ 5937234 w 5937234"/>
              <a:gd name="connsiteY2" fmla="*/ 918779 h 918779"/>
              <a:gd name="connsiteX3" fmla="*/ 0 w 5937234"/>
              <a:gd name="connsiteY3" fmla="*/ 918779 h 918779"/>
              <a:gd name="connsiteX4" fmla="*/ 0 w 5937234"/>
              <a:gd name="connsiteY4" fmla="*/ 0 h 9187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937234" h="918779">
                <a:moveTo>
                  <a:pt x="0" y="0"/>
                </a:moveTo>
                <a:lnTo>
                  <a:pt x="5937234" y="0"/>
                </a:lnTo>
                <a:lnTo>
                  <a:pt x="5937234" y="918779"/>
                </a:lnTo>
                <a:lnTo>
                  <a:pt x="0" y="91877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lumMod val="75000"/>
              <a:alpha val="2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5" name="Rectangle 34"/>
          <p:cNvSpPr/>
          <p:nvPr/>
        </p:nvSpPr>
        <p:spPr>
          <a:xfrm>
            <a:off x="2096723" y="7129911"/>
            <a:ext cx="676800" cy="718689"/>
          </a:xfrm>
          <a:prstGeom prst="rect">
            <a:avLst/>
          </a:prstGeom>
          <a:solidFill>
            <a:schemeClr val="bg1">
              <a:lumMod val="50000"/>
              <a:alpha val="2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6" name="TextBox 35"/>
          <p:cNvSpPr txBox="1"/>
          <p:nvPr/>
        </p:nvSpPr>
        <p:spPr>
          <a:xfrm>
            <a:off x="1918826" y="2352847"/>
            <a:ext cx="535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155</a:t>
            </a:r>
          </a:p>
          <a:p>
            <a:pPr algn="ctr"/>
            <a:endParaRPr lang="en-US" sz="800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153504" y="2478029"/>
            <a:ext cx="5350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   C160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 * 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723233" y="2478029"/>
            <a:ext cx="5350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150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9" name="Straight Connector 38"/>
          <p:cNvCxnSpPr/>
          <p:nvPr/>
        </p:nvCxnSpPr>
        <p:spPr>
          <a:xfrm>
            <a:off x="2210154" y="2533387"/>
            <a:ext cx="0" cy="1005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39"/>
          <p:cNvSpPr/>
          <p:nvPr/>
        </p:nvSpPr>
        <p:spPr>
          <a:xfrm>
            <a:off x="4724788" y="2501781"/>
            <a:ext cx="46990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216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IN" sz="800" dirty="0"/>
          </a:p>
        </p:txBody>
      </p:sp>
      <p:sp>
        <p:nvSpPr>
          <p:cNvPr id="41" name="TextBox 40"/>
          <p:cNvSpPr txBox="1"/>
          <p:nvPr/>
        </p:nvSpPr>
        <p:spPr>
          <a:xfrm>
            <a:off x="427446" y="5401397"/>
            <a:ext cx="4256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T373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635010" y="5282124"/>
            <a:ext cx="13239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putative hinge region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LENRV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****</a:t>
            </a:r>
          </a:p>
          <a:p>
            <a:pPr algn="ctr"/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825648" y="5285129"/>
            <a:ext cx="13945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E binding factor like motif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*******</a:t>
            </a:r>
          </a:p>
          <a:p>
            <a:pPr algn="ctr"/>
            <a:endParaRPr lang="en-U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989167" y="6875381"/>
            <a:ext cx="4936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521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1355816" y="6877653"/>
            <a:ext cx="4616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C529</a:t>
            </a:r>
          </a:p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* </a:t>
            </a:r>
            <a:endParaRPr lang="en-IN" sz="800" dirty="0"/>
          </a:p>
        </p:txBody>
      </p:sp>
      <p:sp>
        <p:nvSpPr>
          <p:cNvPr id="46" name="TextBox 45"/>
          <p:cNvSpPr txBox="1"/>
          <p:nvPr/>
        </p:nvSpPr>
        <p:spPr>
          <a:xfrm>
            <a:off x="1792576" y="6888620"/>
            <a:ext cx="126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   </a:t>
            </a:r>
            <a:r>
              <a:rPr lang="en-US" sz="800" dirty="0" smtClean="0"/>
              <a:t>**  *                **</a:t>
            </a:r>
            <a:endParaRPr lang="en-US" sz="800" dirty="0"/>
          </a:p>
        </p:txBody>
      </p:sp>
      <p:sp>
        <p:nvSpPr>
          <p:cNvPr id="50" name="Rectangle 49"/>
          <p:cNvSpPr/>
          <p:nvPr/>
        </p:nvSpPr>
        <p:spPr>
          <a:xfrm>
            <a:off x="3148190" y="1087090"/>
            <a:ext cx="38552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9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4360225" y="1078411"/>
            <a:ext cx="3657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82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1"/>
          <p:cNvSpPr/>
          <p:nvPr/>
        </p:nvSpPr>
        <p:spPr>
          <a:xfrm>
            <a:off x="2985489" y="1092700"/>
            <a:ext cx="34496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5</a:t>
            </a:r>
          </a:p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IN" sz="800" dirty="0"/>
          </a:p>
        </p:txBody>
      </p:sp>
      <p:sp>
        <p:nvSpPr>
          <p:cNvPr id="53" name="TextBox 52"/>
          <p:cNvSpPr txBox="1"/>
          <p:nvPr/>
        </p:nvSpPr>
        <p:spPr>
          <a:xfrm>
            <a:off x="601424" y="1078734"/>
            <a:ext cx="151410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700" dirty="0" err="1" smtClean="0">
                <a:latin typeface="Times New Roman" pitchFamily="18" charset="0"/>
                <a:cs typeface="Times New Roman" pitchFamily="18" charset="0"/>
              </a:rPr>
              <a:t>IkB-phosphodegron</a:t>
            </a:r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motif</a:t>
            </a:r>
          </a:p>
          <a:p>
            <a:r>
              <a:rPr lang="en-US" sz="700" dirty="0" smtClean="0">
                <a:latin typeface="Times New Roman" pitchFamily="18" charset="0"/>
                <a:cs typeface="Times New Roman" pitchFamily="18" charset="0"/>
              </a:rPr>
              <a:t>           DS***S</a:t>
            </a:r>
          </a:p>
          <a:p>
            <a:endParaRPr lang="en-US" sz="7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929745" y="1324950"/>
            <a:ext cx="274320" cy="252000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9" name="TextBox 48"/>
          <p:cNvSpPr txBox="1"/>
          <p:nvPr/>
        </p:nvSpPr>
        <p:spPr>
          <a:xfrm>
            <a:off x="-38786" y="6893752"/>
            <a:ext cx="1125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solidFill>
                  <a:schemeClr val="accent6">
                    <a:lumMod val="75000"/>
                  </a:schemeClr>
                </a:solidFill>
              </a:rPr>
              <a:t>Binding site</a:t>
            </a:r>
            <a:endParaRPr lang="en-US" sz="800" dirty="0">
              <a:solidFill>
                <a:schemeClr val="accent6">
                  <a:lumMod val="75000"/>
                </a:schemeClr>
              </a:solidFill>
            </a:endParaRPr>
          </a:p>
        </p:txBody>
      </p:sp>
      <p:cxnSp>
        <p:nvCxnSpPr>
          <p:cNvPr id="55" name="Straight Connector 54"/>
          <p:cNvCxnSpPr/>
          <p:nvPr/>
        </p:nvCxnSpPr>
        <p:spPr>
          <a:xfrm flipV="1">
            <a:off x="6252648" y="5623062"/>
            <a:ext cx="367200" cy="1379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342669" y="7083159"/>
            <a:ext cx="324000" cy="599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6102777" y="5428271"/>
            <a:ext cx="648269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solidFill>
                  <a:schemeClr val="accent6">
                    <a:lumMod val="75000"/>
                  </a:schemeClr>
                </a:solidFill>
              </a:rPr>
              <a:t>NIMIN1/2</a:t>
            </a:r>
          </a:p>
          <a:p>
            <a:endParaRPr lang="en-US" sz="800" dirty="0"/>
          </a:p>
        </p:txBody>
      </p:sp>
      <p:sp>
        <p:nvSpPr>
          <p:cNvPr id="58" name="Rectangle 57"/>
          <p:cNvSpPr/>
          <p:nvPr/>
        </p:nvSpPr>
        <p:spPr>
          <a:xfrm>
            <a:off x="42880" y="8463257"/>
            <a:ext cx="67550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4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ure </a:t>
            </a:r>
            <a:r>
              <a:rPr lang="en-I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5</a:t>
            </a:r>
            <a:r>
              <a:rPr lang="en-IN" sz="14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ple sequence alignment of </a:t>
            </a:r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I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badense</a:t>
            </a:r>
            <a:r>
              <a:rPr lang="en-I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Arabidopsis NPRs proteins</a:t>
            </a:r>
            <a:r>
              <a:rPr lang="en-IN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IN" sz="14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73501" y="2271018"/>
            <a:ext cx="5968207" cy="3199263"/>
            <a:chOff x="851883" y="2353610"/>
            <a:chExt cx="5968207" cy="3199263"/>
          </a:xfrm>
        </p:grpSpPr>
        <p:grpSp>
          <p:nvGrpSpPr>
            <p:cNvPr id="26" name="Group 25"/>
            <p:cNvGrpSpPr/>
            <p:nvPr/>
          </p:nvGrpSpPr>
          <p:grpSpPr>
            <a:xfrm>
              <a:off x="4891077" y="3662761"/>
              <a:ext cx="1929013" cy="565572"/>
              <a:chOff x="5341346" y="5869949"/>
              <a:chExt cx="1929013" cy="565572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5341346" y="5958974"/>
                <a:ext cx="137160" cy="13716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5341346" y="6205581"/>
                <a:ext cx="137160" cy="13716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529113" y="5869949"/>
                <a:ext cx="17412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ater–treated </a:t>
                </a: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5534658" y="6158522"/>
                <a:ext cx="5052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 hr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851883" y="2353610"/>
              <a:ext cx="3790076" cy="1463040"/>
              <a:chOff x="572184" y="772236"/>
              <a:chExt cx="3790076" cy="1463040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572184" y="772236"/>
                <a:ext cx="1097280" cy="1463040"/>
                <a:chOff x="572184" y="772236"/>
                <a:chExt cx="1097280" cy="1463040"/>
              </a:xfrm>
            </p:grpSpPr>
            <p:graphicFrame>
              <p:nvGraphicFramePr>
                <p:cNvPr id="11" name="Chart 1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00725279"/>
                    </p:ext>
                  </p:extLst>
                </p:nvPr>
              </p:nvGraphicFramePr>
              <p:xfrm>
                <a:off x="572184" y="772236"/>
                <a:ext cx="1097280" cy="14630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12" name="TextBox 11"/>
                <p:cNvSpPr txBox="1"/>
                <p:nvPr/>
              </p:nvSpPr>
              <p:spPr>
                <a:xfrm>
                  <a:off x="1188410" y="834091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I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</a:p>
              </p:txBody>
            </p:sp>
          </p:grpSp>
          <p:grpSp>
            <p:nvGrpSpPr>
              <p:cNvPr id="28" name="Group 27"/>
              <p:cNvGrpSpPr/>
              <p:nvPr/>
            </p:nvGrpSpPr>
            <p:grpSpPr>
              <a:xfrm>
                <a:off x="1918582" y="772236"/>
                <a:ext cx="1097280" cy="1463040"/>
                <a:chOff x="1957325" y="772236"/>
                <a:chExt cx="1097280" cy="1463040"/>
              </a:xfrm>
            </p:grpSpPr>
            <p:graphicFrame>
              <p:nvGraphicFramePr>
                <p:cNvPr id="13" name="Chart 1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1589748"/>
                    </p:ext>
                  </p:extLst>
                </p:nvPr>
              </p:nvGraphicFramePr>
              <p:xfrm>
                <a:off x="1957325" y="772236"/>
                <a:ext cx="1097280" cy="14630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4" name="TextBox 13"/>
                <p:cNvSpPr txBox="1"/>
                <p:nvPr/>
              </p:nvSpPr>
              <p:spPr>
                <a:xfrm>
                  <a:off x="2553947" y="1597934"/>
                  <a:ext cx="312907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IN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en-IN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7" name="Group 26"/>
              <p:cNvGrpSpPr/>
              <p:nvPr/>
            </p:nvGrpSpPr>
            <p:grpSpPr>
              <a:xfrm>
                <a:off x="3264980" y="772236"/>
                <a:ext cx="1097280" cy="1463040"/>
                <a:chOff x="3296727" y="834091"/>
                <a:chExt cx="1097280" cy="1463040"/>
              </a:xfrm>
            </p:grpSpPr>
            <p:graphicFrame>
              <p:nvGraphicFramePr>
                <p:cNvPr id="15" name="Chart 1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23330240"/>
                    </p:ext>
                  </p:extLst>
                </p:nvPr>
              </p:nvGraphicFramePr>
              <p:xfrm>
                <a:off x="3296727" y="834091"/>
                <a:ext cx="1097280" cy="14630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6" name="TextBox 15"/>
                <p:cNvSpPr txBox="1"/>
                <p:nvPr/>
              </p:nvSpPr>
              <p:spPr>
                <a:xfrm>
                  <a:off x="3918574" y="143727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I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</a:p>
              </p:txBody>
            </p:sp>
          </p:grpSp>
        </p:grpSp>
        <p:grpSp>
          <p:nvGrpSpPr>
            <p:cNvPr id="31" name="Group 30"/>
            <p:cNvGrpSpPr/>
            <p:nvPr/>
          </p:nvGrpSpPr>
          <p:grpSpPr>
            <a:xfrm>
              <a:off x="851883" y="4089833"/>
              <a:ext cx="3790076" cy="1463040"/>
              <a:chOff x="572184" y="2508459"/>
              <a:chExt cx="3790076" cy="1463040"/>
            </a:xfrm>
          </p:grpSpPr>
          <p:grpSp>
            <p:nvGrpSpPr>
              <p:cNvPr id="23" name="Group 22"/>
              <p:cNvGrpSpPr/>
              <p:nvPr/>
            </p:nvGrpSpPr>
            <p:grpSpPr>
              <a:xfrm>
                <a:off x="572184" y="2508459"/>
                <a:ext cx="1097280" cy="1463040"/>
                <a:chOff x="3296727" y="4150647"/>
                <a:chExt cx="1097280" cy="1463040"/>
              </a:xfrm>
            </p:grpSpPr>
            <p:graphicFrame>
              <p:nvGraphicFramePr>
                <p:cNvPr id="17" name="Chart 1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38166641"/>
                    </p:ext>
                  </p:extLst>
                </p:nvPr>
              </p:nvGraphicFramePr>
              <p:xfrm>
                <a:off x="3296727" y="4150647"/>
                <a:ext cx="1097280" cy="14630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18" name="TextBox 17"/>
                <p:cNvSpPr txBox="1"/>
                <p:nvPr/>
              </p:nvSpPr>
              <p:spPr>
                <a:xfrm>
                  <a:off x="3912949" y="4793625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I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</a:p>
              </p:txBody>
            </p:sp>
          </p:grpSp>
          <p:grpSp>
            <p:nvGrpSpPr>
              <p:cNvPr id="24" name="Group 23"/>
              <p:cNvGrpSpPr/>
              <p:nvPr/>
            </p:nvGrpSpPr>
            <p:grpSpPr>
              <a:xfrm>
                <a:off x="1918582" y="2508459"/>
                <a:ext cx="1097280" cy="1463040"/>
                <a:chOff x="3296727" y="5671424"/>
                <a:chExt cx="1097280" cy="1463040"/>
              </a:xfrm>
            </p:grpSpPr>
            <p:graphicFrame>
              <p:nvGraphicFramePr>
                <p:cNvPr id="19" name="Chart 1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649072121"/>
                    </p:ext>
                  </p:extLst>
                </p:nvPr>
              </p:nvGraphicFramePr>
              <p:xfrm>
                <a:off x="3296727" y="5671424"/>
                <a:ext cx="1097280" cy="14630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20" name="TextBox 19"/>
                <p:cNvSpPr txBox="1"/>
                <p:nvPr/>
              </p:nvSpPr>
              <p:spPr>
                <a:xfrm>
                  <a:off x="3897449" y="6476169"/>
                  <a:ext cx="312907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pPr algn="ctr"/>
                  <a:r>
                    <a:rPr lang="en-IN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en-IN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5" name="Group 24"/>
              <p:cNvGrpSpPr/>
              <p:nvPr/>
            </p:nvGrpSpPr>
            <p:grpSpPr>
              <a:xfrm>
                <a:off x="3264980" y="2508459"/>
                <a:ext cx="1097280" cy="1463040"/>
                <a:chOff x="3296727" y="7211816"/>
                <a:chExt cx="1097280" cy="1463040"/>
              </a:xfrm>
            </p:grpSpPr>
            <p:graphicFrame>
              <p:nvGraphicFramePr>
                <p:cNvPr id="21" name="Chart 2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053750020"/>
                    </p:ext>
                  </p:extLst>
                </p:nvPr>
              </p:nvGraphicFramePr>
              <p:xfrm>
                <a:off x="3296727" y="7211816"/>
                <a:ext cx="1097280" cy="14630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sp>
              <p:nvSpPr>
                <p:cNvPr id="22" name="TextBox 21"/>
                <p:cNvSpPr txBox="1"/>
                <p:nvPr/>
              </p:nvSpPr>
              <p:spPr>
                <a:xfrm>
                  <a:off x="3886751" y="8033570"/>
                  <a:ext cx="312907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pPr algn="ctr"/>
                  <a:r>
                    <a:rPr lang="en-IN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en-IN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sp>
        <p:nvSpPr>
          <p:cNvPr id="2" name="Rectangle 1"/>
          <p:cNvSpPr/>
          <p:nvPr/>
        </p:nvSpPr>
        <p:spPr>
          <a:xfrm>
            <a:off x="72553" y="6374627"/>
            <a:ext cx="6785447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IN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licylic acid effect on the </a:t>
            </a:r>
            <a:r>
              <a:rPr lang="en-IN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abidopsis </a:t>
            </a:r>
            <a:r>
              <a:rPr lang="en-IN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PR1-</a:t>
            </a:r>
            <a:r>
              <a:rPr lang="en-I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ke genes expression pattern.</a:t>
            </a:r>
            <a:endParaRPr lang="en-IN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ve expression of Arabidopsis </a:t>
            </a:r>
            <a:r>
              <a:rPr lang="en-I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PRs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estimated by </a:t>
            </a:r>
            <a:r>
              <a:rPr lang="en-IN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PCR after 12 hrs SA induction. 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ernal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trol gene </a:t>
            </a:r>
            <a:r>
              <a:rPr lang="en-IN" sz="1200" i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UBQ10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 used to normalize the expression in 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abidopsis.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are the mean ± SE of three independent experiments 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iological replicates with two technical replicates).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icant differences were indicated by * = </a:t>
            </a:r>
            <a:r>
              <a:rPr lang="en-I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0.05.; 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 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n-I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I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0.005.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35932" y="4589792"/>
            <a:ext cx="1398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35932" y="2787495"/>
            <a:ext cx="1398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6048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35</TotalTime>
  <Words>321</Words>
  <Application>Microsoft Office PowerPoint</Application>
  <PresentationFormat>A4 Paper (210x297 mm)</PresentationFormat>
  <Paragraphs>10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kesh</dc:creator>
  <cp:lastModifiedBy>Rakesh</cp:lastModifiedBy>
  <cp:revision>124</cp:revision>
  <dcterms:created xsi:type="dcterms:W3CDTF">2019-11-06T03:30:36Z</dcterms:created>
  <dcterms:modified xsi:type="dcterms:W3CDTF">2020-07-29T18:21:37Z</dcterms:modified>
</cp:coreProperties>
</file>